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80" r:id="rId3"/>
    <p:sldId id="257" r:id="rId4"/>
    <p:sldId id="258" r:id="rId5"/>
    <p:sldId id="261" r:id="rId6"/>
    <p:sldId id="260" r:id="rId7"/>
    <p:sldId id="262" r:id="rId8"/>
    <p:sldId id="259" r:id="rId9"/>
    <p:sldId id="276" r:id="rId10"/>
    <p:sldId id="283" r:id="rId11"/>
    <p:sldId id="278" r:id="rId12"/>
    <p:sldId id="277" r:id="rId13"/>
    <p:sldId id="275" r:id="rId14"/>
    <p:sldId id="318" r:id="rId15"/>
    <p:sldId id="264" r:id="rId16"/>
    <p:sldId id="263" r:id="rId17"/>
    <p:sldId id="321" r:id="rId18"/>
    <p:sldId id="325" r:id="rId19"/>
    <p:sldId id="326" r:id="rId20"/>
    <p:sldId id="327" r:id="rId21"/>
    <p:sldId id="282" r:id="rId22"/>
    <p:sldId id="319" r:id="rId23"/>
    <p:sldId id="313" r:id="rId24"/>
    <p:sldId id="323" r:id="rId2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6" d="100"/>
          <a:sy n="66" d="100"/>
        </p:scale>
        <p:origin x="600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theme" Target="theme/theme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4A7577-ABE7-B0AF-EA53-00B2A83C719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C1FD467-522C-BF03-7619-2764BD3CC29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B4ECE93-4009-203E-AA90-C6DB2D19AD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219C3-BA2A-45D7-BEFF-828DCF3E2959}" type="datetimeFigureOut">
              <a:rPr lang="en-US" smtClean="0"/>
              <a:t>8/15/2024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F7FAAB1-0868-ED41-A3B7-524F716844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727ABEA-92DE-B9A6-7387-78594E4761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768A99-D2AC-4208-A7AF-A1FB17C077F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280163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19F2ED-FE40-04F0-3F01-ED6526C27B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9414B25-10EB-9C30-6F98-04BF0A8A7B8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41F7221-3566-8B50-A2DC-4DB2BCD46B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219C3-BA2A-45D7-BEFF-828DCF3E2959}" type="datetimeFigureOut">
              <a:rPr lang="en-US" smtClean="0"/>
              <a:t>8/15/2024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DB0AC3E-570A-5E55-3C6B-F974D8FD74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3CDFEA9-A1E0-EBA0-59A2-26259774D8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768A99-D2AC-4208-A7AF-A1FB17C077F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748852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FEE732B-B8D7-C2F6-2A05-5D34A3F20B8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B494C8B-4631-7CA1-2FC5-124A3DCD7A2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8864ADF-1267-6E33-3779-79515875E1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219C3-BA2A-45D7-BEFF-828DCF3E2959}" type="datetimeFigureOut">
              <a:rPr lang="en-US" smtClean="0"/>
              <a:t>8/15/2024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AE24FF7-161A-2CAC-EC9C-A624EF1AF2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FCFA84F-555B-4AB7-71F3-DE7314CEA1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768A99-D2AC-4208-A7AF-A1FB17C077F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090642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4FF6927-9DE3-885F-6AD8-4CCFDDCAB16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7A0B1C7-5B1A-F70B-60EA-1E0AA6B5226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DB86751-9FC8-F8BE-4A1A-0BBD78C0E7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219C3-BA2A-45D7-BEFF-828DCF3E2959}" type="datetimeFigureOut">
              <a:rPr lang="en-US" smtClean="0"/>
              <a:t>8/15/2024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DF056DC-1862-85B6-EA28-F8D485E0AC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A1C1273-C1BF-E821-4CDD-1088E0B0F1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768A99-D2AC-4208-A7AF-A1FB17C077F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84035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1CE133-F023-7DE3-0D75-82F953B4E3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AF38958-7809-A25C-CFD9-3BADDDF4BA5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A6A0F22-A6D8-2838-D5ED-4E6E24A95D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219C3-BA2A-45D7-BEFF-828DCF3E2959}" type="datetimeFigureOut">
              <a:rPr lang="en-US" smtClean="0"/>
              <a:t>8/15/2024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1B88DF2-FB1E-8797-5EA4-214F311B87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F651A05-08AB-241D-58FE-0FDF9BB28A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768A99-D2AC-4208-A7AF-A1FB17C077F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386469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F197EE-50E0-2F35-8E4F-96A3186D1C7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5BBA1F6-918E-6490-3FE0-D4136C934F8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34B36A4-001D-B4A5-4D2F-44D1733B6DD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3C07C89-81E9-8497-6295-A047F85409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219C3-BA2A-45D7-BEFF-828DCF3E2959}" type="datetimeFigureOut">
              <a:rPr lang="en-US" smtClean="0"/>
              <a:t>8/15/2024</a:t>
            </a:fld>
            <a:endParaRPr lang="en-US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1DC7927-FF84-9EAF-948C-0DE69F71E0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69BAA86-2A59-724D-B4DB-D052C4933B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768A99-D2AC-4208-A7AF-A1FB17C077F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175036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699E56-DE02-EA38-9821-48B52D4BA7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E50FBFD-AE7C-7DD9-2711-E59AB588B99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96C511E-87A2-C194-A28C-F0232ECF8D7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902D443-E6A0-B580-90EE-25C0CF05519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44E510F-50A0-6AB1-6C28-24C9925268F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552CC41-B831-7EE3-AC2A-38C2EC3F43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219C3-BA2A-45D7-BEFF-828DCF3E2959}" type="datetimeFigureOut">
              <a:rPr lang="en-US" smtClean="0"/>
              <a:t>8/15/2024</a:t>
            </a:fld>
            <a:endParaRPr lang="en-US" dirty="0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C21C8B0-5D18-DD85-767D-3815CF6ED8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2955FAE-8D6E-7939-1271-7F5E1F9E57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768A99-D2AC-4208-A7AF-A1FB17C077F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222529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D00976-3911-3F9D-7B61-FA57AD74FED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098E294-E29B-6F9E-9B42-6AAD820A16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219C3-BA2A-45D7-BEFF-828DCF3E2959}" type="datetimeFigureOut">
              <a:rPr lang="en-US" smtClean="0"/>
              <a:t>8/15/2024</a:t>
            </a:fld>
            <a:endParaRPr lang="en-US" dirty="0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9FEA7E7-7266-D3D5-8DBE-0001296ABA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5B26913-4624-E756-ABE5-D5B7A24836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768A99-D2AC-4208-A7AF-A1FB17C077F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70807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7932B93-26D3-22F7-3A1A-BD4ED19D94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219C3-BA2A-45D7-BEFF-828DCF3E2959}" type="datetimeFigureOut">
              <a:rPr lang="en-US" smtClean="0"/>
              <a:t>8/15/2024</a:t>
            </a:fld>
            <a:endParaRPr lang="en-US" dirty="0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406CA01-8D22-736D-6722-8BC3C21F6E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B12CFED-593D-1845-FFBF-9248BCE551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768A99-D2AC-4208-A7AF-A1FB17C077F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115677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87B2D6-66BA-1CB8-EDE3-14291349DA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AF5F271-B5B6-F0C2-74B8-1330E072285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A16A8DC-9FAD-F67E-860B-9F6DE17E7CC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96D9A3D-BB08-96D8-5F10-1F588FE23E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219C3-BA2A-45D7-BEFF-828DCF3E2959}" type="datetimeFigureOut">
              <a:rPr lang="en-US" smtClean="0"/>
              <a:t>8/15/2024</a:t>
            </a:fld>
            <a:endParaRPr lang="en-US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8AC8FCB-B6F4-9391-CB9E-A999F4FEE1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06A52CF-B660-6DA0-D65A-9F7C1AD559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768A99-D2AC-4208-A7AF-A1FB17C077F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495408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A71A4C-81D3-2418-E8FE-66F9BF3434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6F59798-DBD9-673A-D2D2-509B6242F6B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0905BD0-41F9-7303-B5A7-9BC2B635C33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67C2629-E73B-6BAA-E092-F0DBAD5C44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219C3-BA2A-45D7-BEFF-828DCF3E2959}" type="datetimeFigureOut">
              <a:rPr lang="en-US" smtClean="0"/>
              <a:t>8/15/2024</a:t>
            </a:fld>
            <a:endParaRPr lang="en-US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4805C39-4FA5-730C-178F-033694F3D8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53E0777-CAD4-A4F5-F418-34311D2411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768A99-D2AC-4208-A7AF-A1FB17C077F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85782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886E72C-86A2-D471-CE19-DA556823DF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A212CC7-1735-D650-8D60-DACE6AB73D0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96CE7D0-6A40-20C2-E755-15E6A49D292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E219C3-BA2A-45D7-BEFF-828DCF3E2959}" type="datetimeFigureOut">
              <a:rPr lang="en-US" smtClean="0"/>
              <a:t>8/15/2024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748FF0C-8276-5946-2D90-7EC4E763F0F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44CC965-3513-0224-BEB1-F66B3347BAB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768A99-D2AC-4208-A7AF-A1FB17C077F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493235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sv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EA78E4-FF18-3B7E-4FE2-316180CB5E7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320842" y="487095"/>
            <a:ext cx="11550316" cy="2387600"/>
          </a:xfrm>
        </p:spPr>
        <p:txBody>
          <a:bodyPr>
            <a:noAutofit/>
          </a:bodyPr>
          <a:lstStyle/>
          <a:p>
            <a:r>
              <a:rPr lang="en-US" sz="48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Exosomal Delivery Enhances Anticancer Properties of Acid Hydrolyzed </a:t>
            </a:r>
            <a:r>
              <a:rPr lang="en-US" sz="4800" i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Apiaceae</a:t>
            </a:r>
            <a:r>
              <a:rPr lang="en-US" sz="48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Spice Extracts. 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6C6B192-44D1-D692-6894-CF49235609A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0" y="3429000"/>
            <a:ext cx="12192000" cy="2371992"/>
          </a:xfrm>
        </p:spPr>
        <p:txBody>
          <a:bodyPr>
            <a:normAutofit fontScale="92500" lnSpcReduction="10000"/>
          </a:bodyPr>
          <a:lstStyle/>
          <a:p>
            <a:r>
              <a:rPr lang="en-US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Jared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. Scott, Ramesh C. Gupta, Farrukh Aqil, Jeyaprakash Jeyabalan, and David J. Schultz</a:t>
            </a:r>
          </a:p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 Peer Review</a:t>
            </a:r>
          </a:p>
          <a:p>
            <a:endParaRPr lang="en-US" sz="3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3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s and Tables</a:t>
            </a:r>
          </a:p>
        </p:txBody>
      </p:sp>
    </p:spTree>
    <p:extLst>
      <p:ext uri="{BB962C8B-B14F-4D97-AF65-F5344CB8AC3E}">
        <p14:creationId xmlns:p14="http://schemas.microsoft.com/office/powerpoint/2010/main" val="407229338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0A50088B-A860-F64C-917B-264C1FB054A2}"/>
              </a:ext>
            </a:extLst>
          </p:cNvPr>
          <p:cNvSpPr txBox="1"/>
          <p:nvPr/>
        </p:nvSpPr>
        <p:spPr>
          <a:xfrm>
            <a:off x="1741359" y="1932128"/>
            <a:ext cx="5077525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dirty="0">
                <a:latin typeface="Palatino Linotype" panose="02040502050505030304" pitchFamily="18" charset="0"/>
              </a:rPr>
              <a:t>Table S6. One-way ANOVA table for AH-extract Loading % Calculations</a:t>
            </a:r>
            <a:endParaRPr lang="en-US" sz="1100" dirty="0">
              <a:latin typeface="Palatino Linotype" panose="02040502050505030304" pitchFamily="18" charset="0"/>
            </a:endParaRPr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B99945E5-B134-163F-8C13-44E415E8AE3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65553760"/>
              </p:ext>
            </p:extLst>
          </p:nvPr>
        </p:nvGraphicFramePr>
        <p:xfrm>
          <a:off x="1774614" y="2211321"/>
          <a:ext cx="4842934" cy="1866584"/>
        </p:xfrm>
        <a:graphic>
          <a:graphicData uri="http://schemas.openxmlformats.org/drawingml/2006/table">
            <a:tbl>
              <a:tblPr firstRow="1" firstCol="1" bandRow="1"/>
              <a:tblGrid>
                <a:gridCol w="1380316">
                  <a:extLst>
                    <a:ext uri="{9D8B030D-6E8A-4147-A177-3AD203B41FA5}">
                      <a16:colId xmlns:a16="http://schemas.microsoft.com/office/drawing/2014/main" val="4019093576"/>
                    </a:ext>
                  </a:extLst>
                </a:gridCol>
                <a:gridCol w="613585">
                  <a:extLst>
                    <a:ext uri="{9D8B030D-6E8A-4147-A177-3AD203B41FA5}">
                      <a16:colId xmlns:a16="http://schemas.microsoft.com/office/drawing/2014/main" val="3549038995"/>
                    </a:ext>
                  </a:extLst>
                </a:gridCol>
                <a:gridCol w="656167">
                  <a:extLst>
                    <a:ext uri="{9D8B030D-6E8A-4147-A177-3AD203B41FA5}">
                      <a16:colId xmlns:a16="http://schemas.microsoft.com/office/drawing/2014/main" val="1225594128"/>
                    </a:ext>
                  </a:extLst>
                </a:gridCol>
                <a:gridCol w="516466">
                  <a:extLst>
                    <a:ext uri="{9D8B030D-6E8A-4147-A177-3AD203B41FA5}">
                      <a16:colId xmlns:a16="http://schemas.microsoft.com/office/drawing/2014/main" val="4177472088"/>
                    </a:ext>
                  </a:extLst>
                </a:gridCol>
                <a:gridCol w="965200">
                  <a:extLst>
                    <a:ext uri="{9D8B030D-6E8A-4147-A177-3AD203B41FA5}">
                      <a16:colId xmlns:a16="http://schemas.microsoft.com/office/drawing/2014/main" val="212096707"/>
                    </a:ext>
                  </a:extLst>
                </a:gridCol>
                <a:gridCol w="711200">
                  <a:extLst>
                    <a:ext uri="{9D8B030D-6E8A-4147-A177-3AD203B41FA5}">
                      <a16:colId xmlns:a16="http://schemas.microsoft.com/office/drawing/2014/main" val="696750978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i="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NOVA table</a:t>
                      </a:r>
                      <a:endParaRPr lang="en-US" sz="1100" i="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S</a:t>
                      </a:r>
                      <a:endParaRPr lang="en-US" sz="110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F</a:t>
                      </a:r>
                      <a:endParaRPr lang="en-US" sz="110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S</a:t>
                      </a:r>
                      <a:endParaRPr lang="en-US" sz="110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 (</a:t>
                      </a:r>
                      <a:r>
                        <a:rPr lang="en-US" sz="1100" b="1" dirty="0" err="1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Fn</a:t>
                      </a: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lang="en-US" sz="1100" b="1" dirty="0" err="1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Fd</a:t>
                      </a: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en-US" sz="1100" b="1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10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 value</a:t>
                      </a:r>
                      <a:endParaRPr lang="en-US" sz="1100" b="1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10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5273476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reatment </a:t>
                      </a:r>
                    </a:p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between columns)</a:t>
                      </a:r>
                      <a:endParaRPr lang="en-US" sz="1100" b="1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2499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7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357.0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F (7, 12) = 7.710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P=0.001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6277692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esidual </a:t>
                      </a:r>
                    </a:p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within columns)</a:t>
                      </a:r>
                      <a:endParaRPr lang="en-US" sz="1100" b="1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555.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1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46.30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0366983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otal</a:t>
                      </a:r>
                      <a:endParaRPr lang="en-US" sz="1100" b="1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305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19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97623169"/>
                  </a:ext>
                </a:extLst>
              </a:tr>
            </a:tbl>
          </a:graphicData>
        </a:graphic>
      </p:graphicFrame>
      <p:graphicFrame>
        <p:nvGraphicFramePr>
          <p:cNvPr id="8" name="Table 7">
            <a:extLst>
              <a:ext uri="{FF2B5EF4-FFF2-40B4-BE49-F238E27FC236}">
                <a16:creationId xmlns:a16="http://schemas.microsoft.com/office/drawing/2014/main" id="{A055EF7B-9678-DF60-169B-538E45BA8DA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59543741"/>
              </p:ext>
            </p:extLst>
          </p:nvPr>
        </p:nvGraphicFramePr>
        <p:xfrm>
          <a:off x="7098276" y="2211321"/>
          <a:ext cx="3186053" cy="1667828"/>
        </p:xfrm>
        <a:graphic>
          <a:graphicData uri="http://schemas.openxmlformats.org/drawingml/2006/table">
            <a:tbl>
              <a:tblPr firstRow="1" firstCol="1" bandRow="1"/>
              <a:tblGrid>
                <a:gridCol w="1665261">
                  <a:extLst>
                    <a:ext uri="{9D8B030D-6E8A-4147-A177-3AD203B41FA5}">
                      <a16:colId xmlns:a16="http://schemas.microsoft.com/office/drawing/2014/main" val="4019093576"/>
                    </a:ext>
                  </a:extLst>
                </a:gridCol>
                <a:gridCol w="1520792">
                  <a:extLst>
                    <a:ext uri="{9D8B030D-6E8A-4147-A177-3AD203B41FA5}">
                      <a16:colId xmlns:a16="http://schemas.microsoft.com/office/drawing/2014/main" val="3549038995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ukey's multiple comparisons test</a:t>
                      </a:r>
                      <a:endParaRPr lang="en-US" sz="11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djusted P Value</a:t>
                      </a: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5273476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Ajwain vs. Fennel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0.032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6277692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Cumin vs. Fennel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0.0138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0366983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Coriander vs. Celery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0.010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9762316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Caraway vs. Celery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0.019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6503175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Celery vs. Fennel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0.0018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6592949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Dill vs. Fennel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0.017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69355853"/>
                  </a:ext>
                </a:extLst>
              </a:tr>
            </a:tbl>
          </a:graphicData>
        </a:graphic>
      </p:graphicFrame>
      <p:sp>
        <p:nvSpPr>
          <p:cNvPr id="9" name="TextBox 8">
            <a:extLst>
              <a:ext uri="{FF2B5EF4-FFF2-40B4-BE49-F238E27FC236}">
                <a16:creationId xmlns:a16="http://schemas.microsoft.com/office/drawing/2014/main" id="{77F3BB5D-052A-467E-27A6-B88072F2705E}"/>
              </a:ext>
            </a:extLst>
          </p:cNvPr>
          <p:cNvSpPr txBox="1"/>
          <p:nvPr/>
        </p:nvSpPr>
        <p:spPr>
          <a:xfrm>
            <a:off x="7007014" y="1896177"/>
            <a:ext cx="3696192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dirty="0">
                <a:latin typeface="Palatino Linotype" panose="02040502050505030304" pitchFamily="18" charset="0"/>
              </a:rPr>
              <a:t>Table S6A. Tukey’s Multiple Comparisons</a:t>
            </a:r>
            <a:endParaRPr lang="en-US" sz="11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5077220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5A5536FF-437C-0292-88D5-35366283220A}"/>
              </a:ext>
            </a:extLst>
          </p:cNvPr>
          <p:cNvSpPr txBox="1"/>
          <p:nvPr/>
        </p:nvSpPr>
        <p:spPr>
          <a:xfrm>
            <a:off x="1120094" y="2087696"/>
            <a:ext cx="5858221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dirty="0">
                <a:latin typeface="Palatino Linotype" panose="02040502050505030304" pitchFamily="18" charset="0"/>
              </a:rPr>
              <a:t>Table S7. Two-way ANOVA table for AH Exosome Formulations HPLC Measurements</a:t>
            </a:r>
            <a:endParaRPr lang="en-US" sz="1100" dirty="0">
              <a:latin typeface="Palatino Linotype" panose="02040502050505030304" pitchFamily="18" charset="0"/>
            </a:endParaRPr>
          </a:p>
        </p:txBody>
      </p:sp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5FD9CEBD-597F-15B8-8EC7-239370A0E74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5127739"/>
              </p:ext>
            </p:extLst>
          </p:nvPr>
        </p:nvGraphicFramePr>
        <p:xfrm>
          <a:off x="1120095" y="2402840"/>
          <a:ext cx="4842934" cy="1026160"/>
        </p:xfrm>
        <a:graphic>
          <a:graphicData uri="http://schemas.openxmlformats.org/drawingml/2006/table">
            <a:tbl>
              <a:tblPr firstRow="1" firstCol="1" bandRow="1"/>
              <a:tblGrid>
                <a:gridCol w="1380316">
                  <a:extLst>
                    <a:ext uri="{9D8B030D-6E8A-4147-A177-3AD203B41FA5}">
                      <a16:colId xmlns:a16="http://schemas.microsoft.com/office/drawing/2014/main" val="4019093576"/>
                    </a:ext>
                  </a:extLst>
                </a:gridCol>
                <a:gridCol w="691701">
                  <a:extLst>
                    <a:ext uri="{9D8B030D-6E8A-4147-A177-3AD203B41FA5}">
                      <a16:colId xmlns:a16="http://schemas.microsoft.com/office/drawing/2014/main" val="3549038995"/>
                    </a:ext>
                  </a:extLst>
                </a:gridCol>
                <a:gridCol w="203200">
                  <a:extLst>
                    <a:ext uri="{9D8B030D-6E8A-4147-A177-3AD203B41FA5}">
                      <a16:colId xmlns:a16="http://schemas.microsoft.com/office/drawing/2014/main" val="1225594128"/>
                    </a:ext>
                  </a:extLst>
                </a:gridCol>
                <a:gridCol w="891317">
                  <a:extLst>
                    <a:ext uri="{9D8B030D-6E8A-4147-A177-3AD203B41FA5}">
                      <a16:colId xmlns:a16="http://schemas.microsoft.com/office/drawing/2014/main" val="4177472088"/>
                    </a:ext>
                  </a:extLst>
                </a:gridCol>
                <a:gridCol w="965200">
                  <a:extLst>
                    <a:ext uri="{9D8B030D-6E8A-4147-A177-3AD203B41FA5}">
                      <a16:colId xmlns:a16="http://schemas.microsoft.com/office/drawing/2014/main" val="212096707"/>
                    </a:ext>
                  </a:extLst>
                </a:gridCol>
                <a:gridCol w="711200">
                  <a:extLst>
                    <a:ext uri="{9D8B030D-6E8A-4147-A177-3AD203B41FA5}">
                      <a16:colId xmlns:a16="http://schemas.microsoft.com/office/drawing/2014/main" val="696750978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i="0" kern="1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NOVA table</a:t>
                      </a:r>
                      <a:endParaRPr lang="en-US" sz="1100" i="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kern="1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S</a:t>
                      </a:r>
                      <a:endParaRPr lang="en-US" sz="110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kern="1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F</a:t>
                      </a:r>
                      <a:endParaRPr lang="en-US" sz="110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kern="1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S</a:t>
                      </a:r>
                      <a:endParaRPr lang="en-US" sz="110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 (</a:t>
                      </a:r>
                      <a:r>
                        <a:rPr lang="en-US" sz="1100" b="1" dirty="0" err="1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Fn</a:t>
                      </a: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lang="en-US" sz="1100" b="1" dirty="0" err="1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Fd</a:t>
                      </a: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en-US" sz="1100" b="1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10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 value</a:t>
                      </a:r>
                      <a:endParaRPr lang="en-US" sz="1100" b="1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10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5273476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Interaction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17268532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7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2466933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F (7, 24) = 10.29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P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6277692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Apiaceae Spic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89098549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7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12728364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F (7, 24) = 53.1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P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0366983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Acid Hydrolysis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25861635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25861635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F (1, 24) = 107.9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P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1973013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Residual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575153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2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239647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97623169"/>
                  </a:ext>
                </a:extLst>
              </a:tr>
            </a:tbl>
          </a:graphicData>
        </a:graphic>
      </p:graphicFrame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F1791F9C-2A66-EBDA-3011-5E7BB2DC172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67903976"/>
              </p:ext>
            </p:extLst>
          </p:nvPr>
        </p:nvGraphicFramePr>
        <p:xfrm>
          <a:off x="7069577" y="2402840"/>
          <a:ext cx="3186053" cy="1356678"/>
        </p:xfrm>
        <a:graphic>
          <a:graphicData uri="http://schemas.openxmlformats.org/drawingml/2006/table">
            <a:tbl>
              <a:tblPr firstRow="1" firstCol="1" bandRow="1"/>
              <a:tblGrid>
                <a:gridCol w="1665261">
                  <a:extLst>
                    <a:ext uri="{9D8B030D-6E8A-4147-A177-3AD203B41FA5}">
                      <a16:colId xmlns:a16="http://schemas.microsoft.com/office/drawing/2014/main" val="4019093576"/>
                    </a:ext>
                  </a:extLst>
                </a:gridCol>
                <a:gridCol w="1520792">
                  <a:extLst>
                    <a:ext uri="{9D8B030D-6E8A-4147-A177-3AD203B41FA5}">
                      <a16:colId xmlns:a16="http://schemas.microsoft.com/office/drawing/2014/main" val="3549038995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i="0" u="none" strike="noStrike" dirty="0" err="1">
                          <a:effectLst/>
                          <a:latin typeface="Palatino Linotype" panose="02040502050505030304" pitchFamily="18" charset="0"/>
                        </a:rPr>
                        <a:t>Šídák's</a:t>
                      </a: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multiple comparisons test</a:t>
                      </a:r>
                      <a:endParaRPr lang="en-US" sz="11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djusted P Value</a:t>
                      </a: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5273476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6277692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Ajwain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0366983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Cumin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9762316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Celery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6592949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Dill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0.0397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69355853"/>
                  </a:ext>
                </a:extLst>
              </a:tr>
            </a:tbl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70B56F90-8D32-7E19-D8AA-85A5885886C1}"/>
              </a:ext>
            </a:extLst>
          </p:cNvPr>
          <p:cNvSpPr txBox="1"/>
          <p:nvPr/>
        </p:nvSpPr>
        <p:spPr>
          <a:xfrm>
            <a:off x="6978315" y="2087696"/>
            <a:ext cx="3696192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dirty="0">
                <a:latin typeface="Palatino Linotype" panose="02040502050505030304" pitchFamily="18" charset="0"/>
              </a:rPr>
              <a:t>Table S7A. </a:t>
            </a:r>
            <a:r>
              <a:rPr lang="en-US" sz="1100" b="1" i="0" u="none" strike="noStrike" dirty="0" err="1">
                <a:effectLst/>
                <a:latin typeface="Palatino Linotype" panose="02040502050505030304" pitchFamily="18" charset="0"/>
              </a:rPr>
              <a:t>Šídák's</a:t>
            </a:r>
            <a:r>
              <a:rPr lang="en-US" sz="1100" b="1" dirty="0">
                <a:latin typeface="Palatino Linotype" panose="02040502050505030304" pitchFamily="18" charset="0"/>
              </a:rPr>
              <a:t> Multiple Comparisons</a:t>
            </a:r>
            <a:endParaRPr lang="en-US" sz="11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11353323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C2090DF1-B00F-FE0D-1703-EB2B14E454C7}"/>
              </a:ext>
            </a:extLst>
          </p:cNvPr>
          <p:cNvSpPr txBox="1"/>
          <p:nvPr/>
        </p:nvSpPr>
        <p:spPr>
          <a:xfrm>
            <a:off x="1185332" y="2402098"/>
            <a:ext cx="5644950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dirty="0">
                <a:latin typeface="Palatino Linotype" panose="02040502050505030304" pitchFamily="18" charset="0"/>
              </a:rPr>
              <a:t>Table S8. Two-way ANOVA table for Acid Hydrolysis Extract HPLC Measurements</a:t>
            </a:r>
            <a:endParaRPr lang="en-US" sz="1100" dirty="0">
              <a:latin typeface="Palatino Linotype" panose="02040502050505030304" pitchFamily="18" charset="0"/>
            </a:endParaRPr>
          </a:p>
        </p:txBody>
      </p: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DF1E159A-E946-B88C-B26A-9B7DFC03CB2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67835601"/>
              </p:ext>
            </p:extLst>
          </p:nvPr>
        </p:nvGraphicFramePr>
        <p:xfrm>
          <a:off x="1253066" y="2663708"/>
          <a:ext cx="4842934" cy="1026160"/>
        </p:xfrm>
        <a:graphic>
          <a:graphicData uri="http://schemas.openxmlformats.org/drawingml/2006/table">
            <a:tbl>
              <a:tblPr firstRow="1" firstCol="1" bandRow="1"/>
              <a:tblGrid>
                <a:gridCol w="1380316">
                  <a:extLst>
                    <a:ext uri="{9D8B030D-6E8A-4147-A177-3AD203B41FA5}">
                      <a16:colId xmlns:a16="http://schemas.microsoft.com/office/drawing/2014/main" val="4019093576"/>
                    </a:ext>
                  </a:extLst>
                </a:gridCol>
                <a:gridCol w="717101">
                  <a:extLst>
                    <a:ext uri="{9D8B030D-6E8A-4147-A177-3AD203B41FA5}">
                      <a16:colId xmlns:a16="http://schemas.microsoft.com/office/drawing/2014/main" val="3549038995"/>
                    </a:ext>
                  </a:extLst>
                </a:gridCol>
                <a:gridCol w="431800">
                  <a:extLst>
                    <a:ext uri="{9D8B030D-6E8A-4147-A177-3AD203B41FA5}">
                      <a16:colId xmlns:a16="http://schemas.microsoft.com/office/drawing/2014/main" val="1225594128"/>
                    </a:ext>
                  </a:extLst>
                </a:gridCol>
                <a:gridCol w="711200">
                  <a:extLst>
                    <a:ext uri="{9D8B030D-6E8A-4147-A177-3AD203B41FA5}">
                      <a16:colId xmlns:a16="http://schemas.microsoft.com/office/drawing/2014/main" val="4177472088"/>
                    </a:ext>
                  </a:extLst>
                </a:gridCol>
                <a:gridCol w="990600">
                  <a:extLst>
                    <a:ext uri="{9D8B030D-6E8A-4147-A177-3AD203B41FA5}">
                      <a16:colId xmlns:a16="http://schemas.microsoft.com/office/drawing/2014/main" val="212096707"/>
                    </a:ext>
                  </a:extLst>
                </a:gridCol>
                <a:gridCol w="611917">
                  <a:extLst>
                    <a:ext uri="{9D8B030D-6E8A-4147-A177-3AD203B41FA5}">
                      <a16:colId xmlns:a16="http://schemas.microsoft.com/office/drawing/2014/main" val="696750978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i="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NOVA table</a:t>
                      </a:r>
                      <a:endParaRPr lang="en-US" sz="1100" i="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S</a:t>
                      </a:r>
                      <a:endParaRPr lang="en-US" sz="110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F</a:t>
                      </a:r>
                      <a:endParaRPr lang="en-US" sz="110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S</a:t>
                      </a:r>
                      <a:endParaRPr lang="en-US" sz="110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 (</a:t>
                      </a:r>
                      <a:r>
                        <a:rPr lang="en-US" sz="1100" b="1" dirty="0" err="1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Fn</a:t>
                      </a: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lang="en-US" sz="1100" b="1" dirty="0" err="1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Fd</a:t>
                      </a: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en-US" sz="1100" b="1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10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 value</a:t>
                      </a:r>
                      <a:endParaRPr lang="en-US" sz="1100" b="1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10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5273476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Interaction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155294825</a:t>
                      </a:r>
                    </a:p>
                  </a:txBody>
                  <a:tcPr marL="5432" marR="5432" marT="543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7</a:t>
                      </a:r>
                    </a:p>
                  </a:txBody>
                  <a:tcPr marL="5432" marR="5432" marT="543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22184975</a:t>
                      </a:r>
                    </a:p>
                  </a:txBody>
                  <a:tcPr marL="5432" marR="5432" marT="543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F (7, 32) = 2.407</a:t>
                      </a:r>
                    </a:p>
                  </a:txBody>
                  <a:tcPr marL="5432" marR="5432" marT="543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P=0.0425</a:t>
                      </a:r>
                    </a:p>
                  </a:txBody>
                  <a:tcPr marL="5432" marR="5432" marT="543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6277692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Apiaceae Spic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7183263315</a:t>
                      </a:r>
                    </a:p>
                  </a:txBody>
                  <a:tcPr marL="5432" marR="5432" marT="54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7</a:t>
                      </a:r>
                    </a:p>
                  </a:txBody>
                  <a:tcPr marL="5432" marR="5432" marT="54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1026180474</a:t>
                      </a:r>
                    </a:p>
                  </a:txBody>
                  <a:tcPr marL="5432" marR="5432" marT="54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F (7, 32) = 111.3</a:t>
                      </a:r>
                    </a:p>
                  </a:txBody>
                  <a:tcPr marL="5432" marR="5432" marT="54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P&lt;0.0001</a:t>
                      </a:r>
                    </a:p>
                  </a:txBody>
                  <a:tcPr marL="5432" marR="5432" marT="54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0366983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Acid Hydrolysis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36461643</a:t>
                      </a:r>
                    </a:p>
                  </a:txBody>
                  <a:tcPr marL="5432" marR="5432" marT="54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1</a:t>
                      </a:r>
                    </a:p>
                  </a:txBody>
                  <a:tcPr marL="5432" marR="5432" marT="54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36461643</a:t>
                      </a:r>
                    </a:p>
                  </a:txBody>
                  <a:tcPr marL="5432" marR="5432" marT="54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F (1, 32) = 3.956</a:t>
                      </a:r>
                    </a:p>
                  </a:txBody>
                  <a:tcPr marL="5432" marR="5432" marT="54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P=0.0553</a:t>
                      </a:r>
                    </a:p>
                  </a:txBody>
                  <a:tcPr marL="5432" marR="5432" marT="54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1973013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Residual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294958783</a:t>
                      </a:r>
                    </a:p>
                  </a:txBody>
                  <a:tcPr marL="5432" marR="5432" marT="54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32</a:t>
                      </a:r>
                    </a:p>
                  </a:txBody>
                  <a:tcPr marL="5432" marR="5432" marT="54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9217462</a:t>
                      </a:r>
                    </a:p>
                  </a:txBody>
                  <a:tcPr marL="5432" marR="5432" marT="54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5432" marR="5432" marT="54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5432" marR="5432" marT="54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97623169"/>
                  </a:ext>
                </a:extLst>
              </a:tr>
            </a:tbl>
          </a:graphicData>
        </a:graphic>
      </p:graphicFrame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A52C1FEE-9D40-6B9D-BD9D-DE4F2DB2506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11672628"/>
              </p:ext>
            </p:extLst>
          </p:nvPr>
        </p:nvGraphicFramePr>
        <p:xfrm>
          <a:off x="7202548" y="2663708"/>
          <a:ext cx="3186053" cy="767398"/>
        </p:xfrm>
        <a:graphic>
          <a:graphicData uri="http://schemas.openxmlformats.org/drawingml/2006/table">
            <a:tbl>
              <a:tblPr firstRow="1" firstCol="1" bandRow="1"/>
              <a:tblGrid>
                <a:gridCol w="1665261">
                  <a:extLst>
                    <a:ext uri="{9D8B030D-6E8A-4147-A177-3AD203B41FA5}">
                      <a16:colId xmlns:a16="http://schemas.microsoft.com/office/drawing/2014/main" val="4019093576"/>
                    </a:ext>
                  </a:extLst>
                </a:gridCol>
                <a:gridCol w="1520792">
                  <a:extLst>
                    <a:ext uri="{9D8B030D-6E8A-4147-A177-3AD203B41FA5}">
                      <a16:colId xmlns:a16="http://schemas.microsoft.com/office/drawing/2014/main" val="3549038995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i="0" u="none" strike="noStrike" dirty="0" err="1">
                          <a:effectLst/>
                          <a:latin typeface="Palatino Linotype" panose="02040502050505030304" pitchFamily="18" charset="0"/>
                        </a:rPr>
                        <a:t>Šídák's</a:t>
                      </a: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multiple comparisons test</a:t>
                      </a:r>
                      <a:endParaRPr lang="en-US" sz="11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djusted P Value</a:t>
                      </a: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5273476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Celery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0.0020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62776920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BB4D84C5-3E1E-4C71-4481-210AEDD51730}"/>
              </a:ext>
            </a:extLst>
          </p:cNvPr>
          <p:cNvSpPr txBox="1"/>
          <p:nvPr/>
        </p:nvSpPr>
        <p:spPr>
          <a:xfrm>
            <a:off x="7111286" y="2348564"/>
            <a:ext cx="3696192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dirty="0">
                <a:latin typeface="Palatino Linotype" panose="02040502050505030304" pitchFamily="18" charset="0"/>
              </a:rPr>
              <a:t>Table S8A. </a:t>
            </a:r>
            <a:r>
              <a:rPr lang="en-US" sz="1100" b="1" i="0" u="none" strike="noStrike" dirty="0" err="1">
                <a:effectLst/>
                <a:latin typeface="Palatino Linotype" panose="02040502050505030304" pitchFamily="18" charset="0"/>
              </a:rPr>
              <a:t>Šídák's</a:t>
            </a:r>
            <a:r>
              <a:rPr lang="en-US" sz="1100" b="1" dirty="0">
                <a:latin typeface="Palatino Linotype" panose="02040502050505030304" pitchFamily="18" charset="0"/>
              </a:rPr>
              <a:t> Multiple Comparisons</a:t>
            </a:r>
            <a:endParaRPr lang="en-US" sz="11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93457430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5A9800B1-3B53-D8B4-8C30-D58E31212F4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8463" y="690053"/>
            <a:ext cx="11626080" cy="4682134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7F628150-ADD2-2A00-6820-B1C4FF0F885F}"/>
              </a:ext>
            </a:extLst>
          </p:cNvPr>
          <p:cNvSpPr txBox="1"/>
          <p:nvPr/>
        </p:nvSpPr>
        <p:spPr>
          <a:xfrm>
            <a:off x="398463" y="5372187"/>
            <a:ext cx="11352944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Figure S4. </a:t>
            </a:r>
            <a:r>
              <a:rPr lang="en-US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Overlaid HPLC-DAD chromatographs for each </a:t>
            </a:r>
            <a:r>
              <a:rPr lang="en-US" i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Apiaceae</a:t>
            </a:r>
            <a:r>
              <a:rPr lang="en-US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spice at 10mg/mL dry extract. Chromatographs indicate phytochemical conversions indicated by changing peak intensities.</a:t>
            </a:r>
          </a:p>
        </p:txBody>
      </p:sp>
    </p:spTree>
    <p:extLst>
      <p:ext uri="{BB962C8B-B14F-4D97-AF65-F5344CB8AC3E}">
        <p14:creationId xmlns:p14="http://schemas.microsoft.com/office/powerpoint/2010/main" val="3109262065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F33DFC64-1DDA-7CFB-1966-602AB8FF14A9}"/>
              </a:ext>
            </a:extLst>
          </p:cNvPr>
          <p:cNvSpPr txBox="1"/>
          <p:nvPr/>
        </p:nvSpPr>
        <p:spPr>
          <a:xfrm>
            <a:off x="325076" y="5303636"/>
            <a:ext cx="11531948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Figure S5. </a:t>
            </a:r>
            <a:r>
              <a:rPr lang="en-US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Overlaid HPLC-DAD chromatographs for each spice exosomal formulation, 5x concentrated to highlight the smaller peaks. Chromatographs indicate AH differential loading indicated by changing peak intensities.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9E0B8224-509B-55AC-A994-D95D78FC162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5076" y="536245"/>
            <a:ext cx="11632176" cy="468823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53899607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>
            <a:extLst>
              <a:ext uri="{FF2B5EF4-FFF2-40B4-BE49-F238E27FC236}">
                <a16:creationId xmlns:a16="http://schemas.microsoft.com/office/drawing/2014/main" id="{38C72595-F2BD-CDAE-4359-CAD0491C9A7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5955566" y="2826746"/>
            <a:ext cx="3958729" cy="241475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67FE3819-92AE-CF7E-7F8E-6EE125B865E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96845" y="425961"/>
            <a:ext cx="3958725" cy="241475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E080C1BB-064E-3F18-4E1E-47A629AF9896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5955569" y="425915"/>
            <a:ext cx="3958725" cy="239434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8C2A9804-7713-BC7C-5A3A-5708F9DBAA3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996840" y="2836795"/>
            <a:ext cx="3958728" cy="239466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91B6F365-6B89-2D12-3D6A-4B9CFF68C91F}"/>
              </a:ext>
            </a:extLst>
          </p:cNvPr>
          <p:cNvSpPr txBox="1"/>
          <p:nvPr/>
        </p:nvSpPr>
        <p:spPr>
          <a:xfrm>
            <a:off x="1957267" y="5352936"/>
            <a:ext cx="7957027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Figure S6. </a:t>
            </a:r>
            <a:r>
              <a:rPr lang="en-US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I</a:t>
            </a:r>
            <a:r>
              <a:rPr lang="en-US" sz="1800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ndividual AH-</a:t>
            </a:r>
            <a:r>
              <a:rPr lang="en-US" sz="1800" i="1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piaceae</a:t>
            </a:r>
            <a:r>
              <a:rPr lang="en-US" sz="1800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exosome formulation characterization results, these data were pooled for Figure 1</a:t>
            </a:r>
            <a:r>
              <a:rPr lang="en-US" dirty="0"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2 in the main text</a:t>
            </a:r>
            <a:r>
              <a:rPr lang="en-US" sz="1800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.</a:t>
            </a:r>
            <a:endParaRPr lang="en-US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028362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A42D848D-FF6F-F67C-C94B-85B2974545B1}"/>
              </a:ext>
            </a:extLst>
          </p:cNvPr>
          <p:cNvSpPr txBox="1"/>
          <p:nvPr/>
        </p:nvSpPr>
        <p:spPr>
          <a:xfrm>
            <a:off x="1345091" y="250951"/>
            <a:ext cx="5223388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dirty="0">
                <a:latin typeface="Palatino Linotype" panose="02040502050505030304" pitchFamily="18" charset="0"/>
              </a:rPr>
              <a:t>Table S9. One-way ANOVA table for Exosome size Measurements</a:t>
            </a:r>
            <a:endParaRPr lang="en-US" sz="1100" dirty="0">
              <a:latin typeface="Palatino Linotype" panose="02040502050505030304" pitchFamily="18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62FC8F7-B28A-A3D7-890D-6690503746A6}"/>
              </a:ext>
            </a:extLst>
          </p:cNvPr>
          <p:cNvSpPr txBox="1"/>
          <p:nvPr/>
        </p:nvSpPr>
        <p:spPr>
          <a:xfrm>
            <a:off x="1272611" y="3092781"/>
            <a:ext cx="5107774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dirty="0">
                <a:latin typeface="Palatino Linotype" panose="02040502050505030304" pitchFamily="18" charset="0"/>
              </a:rPr>
              <a:t>Table S10. One-way ANOVA table for Exosome PDI Measurements</a:t>
            </a:r>
            <a:endParaRPr lang="en-US" sz="1100" dirty="0">
              <a:latin typeface="Palatino Linotype" panose="02040502050505030304" pitchFamily="18" charset="0"/>
            </a:endParaRPr>
          </a:p>
        </p:txBody>
      </p: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D26A9CFB-86F5-5454-4A3C-733512F4F3F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92798148"/>
              </p:ext>
            </p:extLst>
          </p:nvPr>
        </p:nvGraphicFramePr>
        <p:xfrm>
          <a:off x="1408853" y="520391"/>
          <a:ext cx="4842934" cy="1187450"/>
        </p:xfrm>
        <a:graphic>
          <a:graphicData uri="http://schemas.openxmlformats.org/drawingml/2006/table">
            <a:tbl>
              <a:tblPr firstRow="1" firstCol="1" bandRow="1"/>
              <a:tblGrid>
                <a:gridCol w="1380316">
                  <a:extLst>
                    <a:ext uri="{9D8B030D-6E8A-4147-A177-3AD203B41FA5}">
                      <a16:colId xmlns:a16="http://schemas.microsoft.com/office/drawing/2014/main" val="4019093576"/>
                    </a:ext>
                  </a:extLst>
                </a:gridCol>
                <a:gridCol w="613585">
                  <a:extLst>
                    <a:ext uri="{9D8B030D-6E8A-4147-A177-3AD203B41FA5}">
                      <a16:colId xmlns:a16="http://schemas.microsoft.com/office/drawing/2014/main" val="3549038995"/>
                    </a:ext>
                  </a:extLst>
                </a:gridCol>
                <a:gridCol w="656167">
                  <a:extLst>
                    <a:ext uri="{9D8B030D-6E8A-4147-A177-3AD203B41FA5}">
                      <a16:colId xmlns:a16="http://schemas.microsoft.com/office/drawing/2014/main" val="1225594128"/>
                    </a:ext>
                  </a:extLst>
                </a:gridCol>
                <a:gridCol w="516466">
                  <a:extLst>
                    <a:ext uri="{9D8B030D-6E8A-4147-A177-3AD203B41FA5}">
                      <a16:colId xmlns:a16="http://schemas.microsoft.com/office/drawing/2014/main" val="4177472088"/>
                    </a:ext>
                  </a:extLst>
                </a:gridCol>
                <a:gridCol w="965200">
                  <a:extLst>
                    <a:ext uri="{9D8B030D-6E8A-4147-A177-3AD203B41FA5}">
                      <a16:colId xmlns:a16="http://schemas.microsoft.com/office/drawing/2014/main" val="212096707"/>
                    </a:ext>
                  </a:extLst>
                </a:gridCol>
                <a:gridCol w="711200">
                  <a:extLst>
                    <a:ext uri="{9D8B030D-6E8A-4147-A177-3AD203B41FA5}">
                      <a16:colId xmlns:a16="http://schemas.microsoft.com/office/drawing/2014/main" val="696750978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i="0" kern="1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NOVA table</a:t>
                      </a:r>
                      <a:endParaRPr lang="en-US" sz="1100" i="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kern="1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S</a:t>
                      </a:r>
                      <a:endParaRPr lang="en-US" sz="110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kern="1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F</a:t>
                      </a:r>
                      <a:endParaRPr lang="en-US" sz="110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kern="1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S</a:t>
                      </a:r>
                      <a:endParaRPr lang="en-US" sz="110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 (</a:t>
                      </a:r>
                      <a:r>
                        <a:rPr lang="en-US" sz="1100" b="1" dirty="0" err="1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Fn</a:t>
                      </a: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lang="en-US" sz="1100" b="1" dirty="0" err="1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Fd</a:t>
                      </a: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en-US" sz="1100" b="1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10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 value</a:t>
                      </a:r>
                      <a:endParaRPr lang="en-US" sz="1100" b="1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10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5273476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Treatment (between columns)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164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822.9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F (2, 14) = 28.9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P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6277692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Residual (within columns)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398.0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1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28.4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0366983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Total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204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1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97623169"/>
                  </a:ext>
                </a:extLst>
              </a:tr>
            </a:tbl>
          </a:graphicData>
        </a:graphic>
      </p:graphicFrame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22B9F85C-F3D9-6DAE-073B-CF4371F65DD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43052209"/>
              </p:ext>
            </p:extLst>
          </p:nvPr>
        </p:nvGraphicFramePr>
        <p:xfrm>
          <a:off x="6645999" y="454108"/>
          <a:ext cx="3186053" cy="1145858"/>
        </p:xfrm>
        <a:graphic>
          <a:graphicData uri="http://schemas.openxmlformats.org/drawingml/2006/table">
            <a:tbl>
              <a:tblPr firstRow="1" firstCol="1" bandRow="1"/>
              <a:tblGrid>
                <a:gridCol w="1665261">
                  <a:extLst>
                    <a:ext uri="{9D8B030D-6E8A-4147-A177-3AD203B41FA5}">
                      <a16:colId xmlns:a16="http://schemas.microsoft.com/office/drawing/2014/main" val="4019093576"/>
                    </a:ext>
                  </a:extLst>
                </a:gridCol>
                <a:gridCol w="1520792">
                  <a:extLst>
                    <a:ext uri="{9D8B030D-6E8A-4147-A177-3AD203B41FA5}">
                      <a16:colId xmlns:a16="http://schemas.microsoft.com/office/drawing/2014/main" val="3549038995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ukey's multiple comparisons test</a:t>
                      </a:r>
                      <a:endParaRPr lang="en-US" sz="11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djusted P Value</a:t>
                      </a: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5273476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 err="1">
                          <a:effectLst/>
                          <a:latin typeface="Palatino Linotype" panose="02040502050505030304" pitchFamily="18" charset="0"/>
                        </a:rPr>
                        <a:t>Pr</a:t>
                      </a:r>
                      <a:r>
                        <a:rPr lang="en-US" sz="11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-E-Exo vs. AH-E-Exo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0.1339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6277692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 err="1">
                          <a:effectLst/>
                          <a:latin typeface="Palatino Linotype" panose="02040502050505030304" pitchFamily="18" charset="0"/>
                        </a:rPr>
                        <a:t>Pr</a:t>
                      </a:r>
                      <a:r>
                        <a:rPr lang="en-US" sz="11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-E-Exo vs. Exosomes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0366983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AH-E-Exo vs. Exosomes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97623169"/>
                  </a:ext>
                </a:extLst>
              </a:tr>
            </a:tbl>
          </a:graphicData>
        </a:graphic>
      </p:graphicFrame>
      <p:sp>
        <p:nvSpPr>
          <p:cNvPr id="16" name="TextBox 15">
            <a:extLst>
              <a:ext uri="{FF2B5EF4-FFF2-40B4-BE49-F238E27FC236}">
                <a16:creationId xmlns:a16="http://schemas.microsoft.com/office/drawing/2014/main" id="{DF8FB3F4-E5D1-B7F3-2618-F8A3D5EE67DE}"/>
              </a:ext>
            </a:extLst>
          </p:cNvPr>
          <p:cNvSpPr txBox="1"/>
          <p:nvPr/>
        </p:nvSpPr>
        <p:spPr>
          <a:xfrm>
            <a:off x="6641253" y="205247"/>
            <a:ext cx="3696192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dirty="0">
                <a:latin typeface="Palatino Linotype" panose="02040502050505030304" pitchFamily="18" charset="0"/>
              </a:rPr>
              <a:t>Table S9A. Tukey’s Multiple Comparisons</a:t>
            </a:r>
            <a:endParaRPr lang="en-US" sz="1100" dirty="0">
              <a:latin typeface="Palatino Linotype" panose="02040502050505030304" pitchFamily="18" charset="0"/>
            </a:endParaRPr>
          </a:p>
        </p:txBody>
      </p:sp>
      <p:graphicFrame>
        <p:nvGraphicFramePr>
          <p:cNvPr id="17" name="Table 16">
            <a:extLst>
              <a:ext uri="{FF2B5EF4-FFF2-40B4-BE49-F238E27FC236}">
                <a16:creationId xmlns:a16="http://schemas.microsoft.com/office/drawing/2014/main" id="{5DE78A8B-5AC6-5B0B-0A62-8626D378E71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427460"/>
              </p:ext>
            </p:extLst>
          </p:nvPr>
        </p:nvGraphicFramePr>
        <p:xfrm>
          <a:off x="1345091" y="3340919"/>
          <a:ext cx="4842934" cy="1866584"/>
        </p:xfrm>
        <a:graphic>
          <a:graphicData uri="http://schemas.openxmlformats.org/drawingml/2006/table">
            <a:tbl>
              <a:tblPr firstRow="1" firstCol="1" bandRow="1"/>
              <a:tblGrid>
                <a:gridCol w="1380316">
                  <a:extLst>
                    <a:ext uri="{9D8B030D-6E8A-4147-A177-3AD203B41FA5}">
                      <a16:colId xmlns:a16="http://schemas.microsoft.com/office/drawing/2014/main" val="4019093576"/>
                    </a:ext>
                  </a:extLst>
                </a:gridCol>
                <a:gridCol w="613585">
                  <a:extLst>
                    <a:ext uri="{9D8B030D-6E8A-4147-A177-3AD203B41FA5}">
                      <a16:colId xmlns:a16="http://schemas.microsoft.com/office/drawing/2014/main" val="3549038995"/>
                    </a:ext>
                  </a:extLst>
                </a:gridCol>
                <a:gridCol w="656167">
                  <a:extLst>
                    <a:ext uri="{9D8B030D-6E8A-4147-A177-3AD203B41FA5}">
                      <a16:colId xmlns:a16="http://schemas.microsoft.com/office/drawing/2014/main" val="1225594128"/>
                    </a:ext>
                  </a:extLst>
                </a:gridCol>
                <a:gridCol w="516466">
                  <a:extLst>
                    <a:ext uri="{9D8B030D-6E8A-4147-A177-3AD203B41FA5}">
                      <a16:colId xmlns:a16="http://schemas.microsoft.com/office/drawing/2014/main" val="4177472088"/>
                    </a:ext>
                  </a:extLst>
                </a:gridCol>
                <a:gridCol w="965200">
                  <a:extLst>
                    <a:ext uri="{9D8B030D-6E8A-4147-A177-3AD203B41FA5}">
                      <a16:colId xmlns:a16="http://schemas.microsoft.com/office/drawing/2014/main" val="212096707"/>
                    </a:ext>
                  </a:extLst>
                </a:gridCol>
                <a:gridCol w="711200">
                  <a:extLst>
                    <a:ext uri="{9D8B030D-6E8A-4147-A177-3AD203B41FA5}">
                      <a16:colId xmlns:a16="http://schemas.microsoft.com/office/drawing/2014/main" val="696750978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i="0" kern="1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NOVA table</a:t>
                      </a:r>
                      <a:endParaRPr lang="en-US" sz="1100" i="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kern="1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S</a:t>
                      </a:r>
                      <a:endParaRPr lang="en-US" sz="110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kern="1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F</a:t>
                      </a:r>
                      <a:endParaRPr lang="en-US" sz="110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kern="1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S</a:t>
                      </a:r>
                      <a:endParaRPr lang="en-US" sz="110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 (</a:t>
                      </a:r>
                      <a:r>
                        <a:rPr lang="en-US" sz="1100" b="1" dirty="0" err="1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Fn</a:t>
                      </a: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lang="en-US" sz="1100" b="1" dirty="0" err="1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Fd</a:t>
                      </a: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en-US" sz="1100" b="1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10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 value</a:t>
                      </a:r>
                      <a:endParaRPr lang="en-US" sz="1100" b="1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10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5273476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reatment </a:t>
                      </a:r>
                    </a:p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between columns)</a:t>
                      </a:r>
                      <a:endParaRPr lang="en-US" sz="1100" b="1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0.000473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0.0002367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F (2, 16) = 0.2400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P=0.789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6277692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esidual </a:t>
                      </a:r>
                    </a:p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within columns)</a:t>
                      </a:r>
                      <a:endParaRPr lang="en-US" sz="1100" b="1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0.01578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1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0.000986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0366983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otal</a:t>
                      </a:r>
                      <a:endParaRPr lang="en-US" sz="1100" b="1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0.0162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18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97623169"/>
                  </a:ext>
                </a:extLst>
              </a:tr>
            </a:tbl>
          </a:graphicData>
        </a:graphic>
      </p:graphicFrame>
      <p:graphicFrame>
        <p:nvGraphicFramePr>
          <p:cNvPr id="18" name="Table 17">
            <a:extLst>
              <a:ext uri="{FF2B5EF4-FFF2-40B4-BE49-F238E27FC236}">
                <a16:creationId xmlns:a16="http://schemas.microsoft.com/office/drawing/2014/main" id="{0366EBF4-BEBC-2D5F-CDC8-5FC101F4FCF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73815276"/>
              </p:ext>
            </p:extLst>
          </p:nvPr>
        </p:nvGraphicFramePr>
        <p:xfrm>
          <a:off x="6582237" y="3274636"/>
          <a:ext cx="3186053" cy="1145858"/>
        </p:xfrm>
        <a:graphic>
          <a:graphicData uri="http://schemas.openxmlformats.org/drawingml/2006/table">
            <a:tbl>
              <a:tblPr firstRow="1" firstCol="1" bandRow="1"/>
              <a:tblGrid>
                <a:gridCol w="1665261">
                  <a:extLst>
                    <a:ext uri="{9D8B030D-6E8A-4147-A177-3AD203B41FA5}">
                      <a16:colId xmlns:a16="http://schemas.microsoft.com/office/drawing/2014/main" val="4019093576"/>
                    </a:ext>
                  </a:extLst>
                </a:gridCol>
                <a:gridCol w="1520792">
                  <a:extLst>
                    <a:ext uri="{9D8B030D-6E8A-4147-A177-3AD203B41FA5}">
                      <a16:colId xmlns:a16="http://schemas.microsoft.com/office/drawing/2014/main" val="3549038995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ukey's multiple comparisons test</a:t>
                      </a:r>
                      <a:endParaRPr lang="en-US" sz="11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djusted P Value</a:t>
                      </a: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5273476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 err="1">
                          <a:effectLst/>
                          <a:latin typeface="Palatino Linotype" panose="02040502050505030304" pitchFamily="18" charset="0"/>
                        </a:rPr>
                        <a:t>Pr</a:t>
                      </a:r>
                      <a:r>
                        <a:rPr lang="en-US" sz="11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-E-Exo vs. AH-E-Exo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0.886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6277692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 err="1">
                          <a:effectLst/>
                          <a:latin typeface="Palatino Linotype" panose="02040502050505030304" pitchFamily="18" charset="0"/>
                        </a:rPr>
                        <a:t>Pr</a:t>
                      </a:r>
                      <a:r>
                        <a:rPr lang="en-US" sz="11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-E-Exo vs. Exosomes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0.7968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0366983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AH-E-Exo vs. Exosomes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0.9518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97623169"/>
                  </a:ext>
                </a:extLst>
              </a:tr>
            </a:tbl>
          </a:graphicData>
        </a:graphic>
      </p:graphicFrame>
      <p:sp>
        <p:nvSpPr>
          <p:cNvPr id="19" name="TextBox 18">
            <a:extLst>
              <a:ext uri="{FF2B5EF4-FFF2-40B4-BE49-F238E27FC236}">
                <a16:creationId xmlns:a16="http://schemas.microsoft.com/office/drawing/2014/main" id="{6110FCFA-C77E-14DD-7EF1-03902679F18D}"/>
              </a:ext>
            </a:extLst>
          </p:cNvPr>
          <p:cNvSpPr txBox="1"/>
          <p:nvPr/>
        </p:nvSpPr>
        <p:spPr>
          <a:xfrm>
            <a:off x="6577491" y="3025775"/>
            <a:ext cx="3696192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dirty="0">
                <a:latin typeface="Palatino Linotype" panose="02040502050505030304" pitchFamily="18" charset="0"/>
              </a:rPr>
              <a:t>Table S10A. Tukey’s Multiple Comparisons</a:t>
            </a:r>
            <a:endParaRPr lang="en-US" sz="11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91423076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A42D848D-FF6F-F67C-C94B-85B2974545B1}"/>
              </a:ext>
            </a:extLst>
          </p:cNvPr>
          <p:cNvSpPr txBox="1"/>
          <p:nvPr/>
        </p:nvSpPr>
        <p:spPr>
          <a:xfrm>
            <a:off x="1354716" y="299077"/>
            <a:ext cx="5223388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dirty="0">
                <a:latin typeface="Palatino Linotype" panose="02040502050505030304" pitchFamily="18" charset="0"/>
              </a:rPr>
              <a:t>Table S11. One-way ANOVA table for Exosome Zeta Potential Measurements</a:t>
            </a:r>
            <a:endParaRPr lang="en-US" sz="1100" dirty="0">
              <a:latin typeface="Palatino Linotype" panose="02040502050505030304" pitchFamily="18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62FC8F7-B28A-A3D7-890D-6690503746A6}"/>
              </a:ext>
            </a:extLst>
          </p:cNvPr>
          <p:cNvSpPr txBox="1"/>
          <p:nvPr/>
        </p:nvSpPr>
        <p:spPr>
          <a:xfrm>
            <a:off x="1282236" y="3140907"/>
            <a:ext cx="5223388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dirty="0">
                <a:latin typeface="Palatino Linotype" panose="02040502050505030304" pitchFamily="18" charset="0"/>
              </a:rPr>
              <a:t>Table S12. One-way ANOVA table for Exosome Particle Count Measurements</a:t>
            </a:r>
            <a:endParaRPr lang="en-US" sz="1100" dirty="0">
              <a:latin typeface="Palatino Linotype" panose="02040502050505030304" pitchFamily="18" charset="0"/>
            </a:endParaRPr>
          </a:p>
        </p:txBody>
      </p: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D26A9CFB-86F5-5454-4A3C-733512F4F3F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45115300"/>
              </p:ext>
            </p:extLst>
          </p:nvPr>
        </p:nvGraphicFramePr>
        <p:xfrm>
          <a:off x="1418478" y="568517"/>
          <a:ext cx="4842934" cy="1866584"/>
        </p:xfrm>
        <a:graphic>
          <a:graphicData uri="http://schemas.openxmlformats.org/drawingml/2006/table">
            <a:tbl>
              <a:tblPr firstRow="1" firstCol="1" bandRow="1"/>
              <a:tblGrid>
                <a:gridCol w="1380316">
                  <a:extLst>
                    <a:ext uri="{9D8B030D-6E8A-4147-A177-3AD203B41FA5}">
                      <a16:colId xmlns:a16="http://schemas.microsoft.com/office/drawing/2014/main" val="4019093576"/>
                    </a:ext>
                  </a:extLst>
                </a:gridCol>
                <a:gridCol w="613585">
                  <a:extLst>
                    <a:ext uri="{9D8B030D-6E8A-4147-A177-3AD203B41FA5}">
                      <a16:colId xmlns:a16="http://schemas.microsoft.com/office/drawing/2014/main" val="3549038995"/>
                    </a:ext>
                  </a:extLst>
                </a:gridCol>
                <a:gridCol w="656167">
                  <a:extLst>
                    <a:ext uri="{9D8B030D-6E8A-4147-A177-3AD203B41FA5}">
                      <a16:colId xmlns:a16="http://schemas.microsoft.com/office/drawing/2014/main" val="1225594128"/>
                    </a:ext>
                  </a:extLst>
                </a:gridCol>
                <a:gridCol w="516466">
                  <a:extLst>
                    <a:ext uri="{9D8B030D-6E8A-4147-A177-3AD203B41FA5}">
                      <a16:colId xmlns:a16="http://schemas.microsoft.com/office/drawing/2014/main" val="4177472088"/>
                    </a:ext>
                  </a:extLst>
                </a:gridCol>
                <a:gridCol w="965200">
                  <a:extLst>
                    <a:ext uri="{9D8B030D-6E8A-4147-A177-3AD203B41FA5}">
                      <a16:colId xmlns:a16="http://schemas.microsoft.com/office/drawing/2014/main" val="212096707"/>
                    </a:ext>
                  </a:extLst>
                </a:gridCol>
                <a:gridCol w="711200">
                  <a:extLst>
                    <a:ext uri="{9D8B030D-6E8A-4147-A177-3AD203B41FA5}">
                      <a16:colId xmlns:a16="http://schemas.microsoft.com/office/drawing/2014/main" val="696750978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i="0" kern="1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NOVA table</a:t>
                      </a:r>
                      <a:endParaRPr lang="en-US" sz="1100" i="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kern="1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S</a:t>
                      </a:r>
                      <a:endParaRPr lang="en-US" sz="110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kern="1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F</a:t>
                      </a:r>
                      <a:endParaRPr lang="en-US" sz="110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kern="1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S</a:t>
                      </a:r>
                      <a:endParaRPr lang="en-US" sz="110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 (</a:t>
                      </a:r>
                      <a:r>
                        <a:rPr lang="en-US" sz="1100" b="1" dirty="0" err="1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Fn</a:t>
                      </a: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lang="en-US" sz="1100" b="1" dirty="0" err="1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Fd</a:t>
                      </a: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en-US" sz="1100" b="1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10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 value</a:t>
                      </a:r>
                      <a:endParaRPr lang="en-US" sz="1100" b="1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10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5273476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reatment </a:t>
                      </a:r>
                    </a:p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between columns)</a:t>
                      </a:r>
                      <a:endParaRPr lang="en-US" sz="1100" b="1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0.2087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0.104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F (2, 16) = 0.369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P=0.6970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6277692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esidual </a:t>
                      </a:r>
                    </a:p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within columns)</a:t>
                      </a:r>
                      <a:endParaRPr lang="en-US" sz="1100" b="1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4.52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1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0.282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0366983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otal</a:t>
                      </a:r>
                      <a:endParaRPr lang="en-US" sz="1100" b="1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4.730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18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97623169"/>
                  </a:ext>
                </a:extLst>
              </a:tr>
            </a:tbl>
          </a:graphicData>
        </a:graphic>
      </p:graphicFrame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22B9F85C-F3D9-6DAE-073B-CF4371F65DD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50691994"/>
              </p:ext>
            </p:extLst>
          </p:nvPr>
        </p:nvGraphicFramePr>
        <p:xfrm>
          <a:off x="6646612" y="581989"/>
          <a:ext cx="3186053" cy="1145858"/>
        </p:xfrm>
        <a:graphic>
          <a:graphicData uri="http://schemas.openxmlformats.org/drawingml/2006/table">
            <a:tbl>
              <a:tblPr firstRow="1" firstCol="1" bandRow="1"/>
              <a:tblGrid>
                <a:gridCol w="1665261">
                  <a:extLst>
                    <a:ext uri="{9D8B030D-6E8A-4147-A177-3AD203B41FA5}">
                      <a16:colId xmlns:a16="http://schemas.microsoft.com/office/drawing/2014/main" val="4019093576"/>
                    </a:ext>
                  </a:extLst>
                </a:gridCol>
                <a:gridCol w="1520792">
                  <a:extLst>
                    <a:ext uri="{9D8B030D-6E8A-4147-A177-3AD203B41FA5}">
                      <a16:colId xmlns:a16="http://schemas.microsoft.com/office/drawing/2014/main" val="3549038995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ukey's multiple comparisons test</a:t>
                      </a:r>
                      <a:endParaRPr lang="en-US" sz="11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djusted P Value</a:t>
                      </a: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5273476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 err="1">
                          <a:effectLst/>
                          <a:latin typeface="Palatino Linotype" panose="02040502050505030304" pitchFamily="18" charset="0"/>
                        </a:rPr>
                        <a:t>Pr</a:t>
                      </a:r>
                      <a:r>
                        <a:rPr lang="en-US" sz="11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-E-Exo vs. AH-E-Exo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0.843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6277692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 err="1">
                          <a:effectLst/>
                          <a:latin typeface="Palatino Linotype" panose="02040502050505030304" pitchFamily="18" charset="0"/>
                        </a:rPr>
                        <a:t>Pr</a:t>
                      </a:r>
                      <a:r>
                        <a:rPr lang="en-US" sz="11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-E-Exo vs. Exosomes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0.916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0366983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AH-E-Exo vs. Exosomes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0.7007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97623169"/>
                  </a:ext>
                </a:extLst>
              </a:tr>
            </a:tbl>
          </a:graphicData>
        </a:graphic>
      </p:graphicFrame>
      <p:sp>
        <p:nvSpPr>
          <p:cNvPr id="16" name="TextBox 15">
            <a:extLst>
              <a:ext uri="{FF2B5EF4-FFF2-40B4-BE49-F238E27FC236}">
                <a16:creationId xmlns:a16="http://schemas.microsoft.com/office/drawing/2014/main" id="{DF8FB3F4-E5D1-B7F3-2618-F8A3D5EE67DE}"/>
              </a:ext>
            </a:extLst>
          </p:cNvPr>
          <p:cNvSpPr txBox="1"/>
          <p:nvPr/>
        </p:nvSpPr>
        <p:spPr>
          <a:xfrm>
            <a:off x="6641866" y="333128"/>
            <a:ext cx="3696192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dirty="0">
                <a:latin typeface="Palatino Linotype" panose="02040502050505030304" pitchFamily="18" charset="0"/>
              </a:rPr>
              <a:t>Table S11A. Tukey’s Multiple Comparisons</a:t>
            </a:r>
            <a:endParaRPr lang="en-US" sz="1100" dirty="0">
              <a:latin typeface="Palatino Linotype" panose="02040502050505030304" pitchFamily="18" charset="0"/>
            </a:endParaRPr>
          </a:p>
        </p:txBody>
      </p:sp>
      <p:graphicFrame>
        <p:nvGraphicFramePr>
          <p:cNvPr id="17" name="Table 16">
            <a:extLst>
              <a:ext uri="{FF2B5EF4-FFF2-40B4-BE49-F238E27FC236}">
                <a16:creationId xmlns:a16="http://schemas.microsoft.com/office/drawing/2014/main" id="{5DE78A8B-5AC6-5B0B-0A62-8626D378E71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25171153"/>
              </p:ext>
            </p:extLst>
          </p:nvPr>
        </p:nvGraphicFramePr>
        <p:xfrm>
          <a:off x="1354716" y="3389045"/>
          <a:ext cx="4842934" cy="1919606"/>
        </p:xfrm>
        <a:graphic>
          <a:graphicData uri="http://schemas.openxmlformats.org/drawingml/2006/table">
            <a:tbl>
              <a:tblPr firstRow="1" firstCol="1" bandRow="1"/>
              <a:tblGrid>
                <a:gridCol w="1380316">
                  <a:extLst>
                    <a:ext uri="{9D8B030D-6E8A-4147-A177-3AD203B41FA5}">
                      <a16:colId xmlns:a16="http://schemas.microsoft.com/office/drawing/2014/main" val="4019093576"/>
                    </a:ext>
                  </a:extLst>
                </a:gridCol>
                <a:gridCol w="613585">
                  <a:extLst>
                    <a:ext uri="{9D8B030D-6E8A-4147-A177-3AD203B41FA5}">
                      <a16:colId xmlns:a16="http://schemas.microsoft.com/office/drawing/2014/main" val="3549038995"/>
                    </a:ext>
                  </a:extLst>
                </a:gridCol>
                <a:gridCol w="656167">
                  <a:extLst>
                    <a:ext uri="{9D8B030D-6E8A-4147-A177-3AD203B41FA5}">
                      <a16:colId xmlns:a16="http://schemas.microsoft.com/office/drawing/2014/main" val="1225594128"/>
                    </a:ext>
                  </a:extLst>
                </a:gridCol>
                <a:gridCol w="516466">
                  <a:extLst>
                    <a:ext uri="{9D8B030D-6E8A-4147-A177-3AD203B41FA5}">
                      <a16:colId xmlns:a16="http://schemas.microsoft.com/office/drawing/2014/main" val="4177472088"/>
                    </a:ext>
                  </a:extLst>
                </a:gridCol>
                <a:gridCol w="965200">
                  <a:extLst>
                    <a:ext uri="{9D8B030D-6E8A-4147-A177-3AD203B41FA5}">
                      <a16:colId xmlns:a16="http://schemas.microsoft.com/office/drawing/2014/main" val="212096707"/>
                    </a:ext>
                  </a:extLst>
                </a:gridCol>
                <a:gridCol w="711200">
                  <a:extLst>
                    <a:ext uri="{9D8B030D-6E8A-4147-A177-3AD203B41FA5}">
                      <a16:colId xmlns:a16="http://schemas.microsoft.com/office/drawing/2014/main" val="696750978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i="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NOVA table</a:t>
                      </a:r>
                      <a:endParaRPr lang="en-US" sz="1100" i="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S</a:t>
                      </a:r>
                      <a:endParaRPr lang="en-US" sz="110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F</a:t>
                      </a:r>
                      <a:endParaRPr lang="en-US" sz="110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S</a:t>
                      </a:r>
                      <a:endParaRPr lang="en-US" sz="110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 (</a:t>
                      </a:r>
                      <a:r>
                        <a:rPr lang="en-US" sz="1100" b="1" dirty="0" err="1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Fn</a:t>
                      </a: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lang="en-US" sz="1100" b="1" dirty="0" err="1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Fd</a:t>
                      </a: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en-US" sz="1100" b="1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10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 value</a:t>
                      </a:r>
                      <a:endParaRPr lang="en-US" sz="1100" b="1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10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5273476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reatment </a:t>
                      </a:r>
                    </a:p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between columns)</a:t>
                      </a:r>
                      <a:endParaRPr lang="en-US" sz="1100" b="1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2.313e+029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1.157e+029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F (2, 16) = 2.30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P=0.1318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6277692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esidual </a:t>
                      </a:r>
                    </a:p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within columns)</a:t>
                      </a:r>
                      <a:endParaRPr lang="en-US" sz="1100" b="1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8.023e+029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1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5.014e+028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0366983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otal</a:t>
                      </a:r>
                      <a:endParaRPr lang="en-US" sz="1100" b="1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1.034e+030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18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97623169"/>
                  </a:ext>
                </a:extLst>
              </a:tr>
            </a:tbl>
          </a:graphicData>
        </a:graphic>
      </p:graphicFrame>
      <p:graphicFrame>
        <p:nvGraphicFramePr>
          <p:cNvPr id="18" name="Table 17">
            <a:extLst>
              <a:ext uri="{FF2B5EF4-FFF2-40B4-BE49-F238E27FC236}">
                <a16:creationId xmlns:a16="http://schemas.microsoft.com/office/drawing/2014/main" id="{0366EBF4-BEBC-2D5F-CDC8-5FC101F4FCF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97454340"/>
              </p:ext>
            </p:extLst>
          </p:nvPr>
        </p:nvGraphicFramePr>
        <p:xfrm>
          <a:off x="6582850" y="3402517"/>
          <a:ext cx="3186053" cy="1145858"/>
        </p:xfrm>
        <a:graphic>
          <a:graphicData uri="http://schemas.openxmlformats.org/drawingml/2006/table">
            <a:tbl>
              <a:tblPr firstRow="1" firstCol="1" bandRow="1"/>
              <a:tblGrid>
                <a:gridCol w="1665261">
                  <a:extLst>
                    <a:ext uri="{9D8B030D-6E8A-4147-A177-3AD203B41FA5}">
                      <a16:colId xmlns:a16="http://schemas.microsoft.com/office/drawing/2014/main" val="4019093576"/>
                    </a:ext>
                  </a:extLst>
                </a:gridCol>
                <a:gridCol w="1520792">
                  <a:extLst>
                    <a:ext uri="{9D8B030D-6E8A-4147-A177-3AD203B41FA5}">
                      <a16:colId xmlns:a16="http://schemas.microsoft.com/office/drawing/2014/main" val="3549038995"/>
                    </a:ext>
                  </a:extLst>
                </a:gridCol>
              </a:tblGrid>
              <a:tr h="457542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ukey's multiple comparisons test</a:t>
                      </a:r>
                      <a:endParaRPr lang="en-US" sz="11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djusted P Value</a:t>
                      </a: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5273476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 err="1">
                          <a:effectLst/>
                          <a:latin typeface="Palatino Linotype" panose="02040502050505030304" pitchFamily="18" charset="0"/>
                        </a:rPr>
                        <a:t>Pr</a:t>
                      </a:r>
                      <a:r>
                        <a:rPr lang="en-US" sz="11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-E-Exo vs. AH-E-Exo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0.672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6277692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 err="1">
                          <a:effectLst/>
                          <a:latin typeface="Palatino Linotype" panose="02040502050505030304" pitchFamily="18" charset="0"/>
                        </a:rPr>
                        <a:t>Pr</a:t>
                      </a:r>
                      <a:r>
                        <a:rPr lang="en-US" sz="11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-E-Exo vs. Exosomes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0.3119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0366983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AH-E-Exo vs. Exosomes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0.1118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97623169"/>
                  </a:ext>
                </a:extLst>
              </a:tr>
            </a:tbl>
          </a:graphicData>
        </a:graphic>
      </p:graphicFrame>
      <p:sp>
        <p:nvSpPr>
          <p:cNvPr id="19" name="TextBox 18">
            <a:extLst>
              <a:ext uri="{FF2B5EF4-FFF2-40B4-BE49-F238E27FC236}">
                <a16:creationId xmlns:a16="http://schemas.microsoft.com/office/drawing/2014/main" id="{6110FCFA-C77E-14DD-7EF1-03902679F18D}"/>
              </a:ext>
            </a:extLst>
          </p:cNvPr>
          <p:cNvSpPr txBox="1"/>
          <p:nvPr/>
        </p:nvSpPr>
        <p:spPr>
          <a:xfrm>
            <a:off x="6578104" y="3153656"/>
            <a:ext cx="3696192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dirty="0">
                <a:latin typeface="Palatino Linotype" panose="02040502050505030304" pitchFamily="18" charset="0"/>
              </a:rPr>
              <a:t>Table S12A. Tukey’s Multiple Comparisons</a:t>
            </a:r>
            <a:endParaRPr lang="en-US" sz="11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29864303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B4AD7AD2-18BC-5FED-1B2B-45A85978023C}"/>
              </a:ext>
            </a:extLst>
          </p:cNvPr>
          <p:cNvSpPr txBox="1"/>
          <p:nvPr/>
        </p:nvSpPr>
        <p:spPr>
          <a:xfrm>
            <a:off x="1323207" y="515547"/>
            <a:ext cx="8576110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dirty="0">
                <a:latin typeface="Palatino Linotype" panose="02040502050505030304" pitchFamily="18" charset="0"/>
              </a:rPr>
              <a:t>Table S13. One-way ANOVA table for Apiaceae Initial Extracts IC50s in BT-474</a:t>
            </a:r>
            <a:endParaRPr lang="en-US" sz="1100" dirty="0">
              <a:latin typeface="Palatino Linotype" panose="02040502050505030304" pitchFamily="18" charset="0"/>
            </a:endParaRPr>
          </a:p>
        </p:txBody>
      </p:sp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0D66DFE7-D2FE-A32E-547D-2574B6F27A9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51518488"/>
              </p:ext>
            </p:extLst>
          </p:nvPr>
        </p:nvGraphicFramePr>
        <p:xfrm>
          <a:off x="1389602" y="777157"/>
          <a:ext cx="4842934" cy="1187450"/>
        </p:xfrm>
        <a:graphic>
          <a:graphicData uri="http://schemas.openxmlformats.org/drawingml/2006/table">
            <a:tbl>
              <a:tblPr firstRow="1" firstCol="1" bandRow="1"/>
              <a:tblGrid>
                <a:gridCol w="1380316">
                  <a:extLst>
                    <a:ext uri="{9D8B030D-6E8A-4147-A177-3AD203B41FA5}">
                      <a16:colId xmlns:a16="http://schemas.microsoft.com/office/drawing/2014/main" val="4019093576"/>
                    </a:ext>
                  </a:extLst>
                </a:gridCol>
                <a:gridCol w="613585">
                  <a:extLst>
                    <a:ext uri="{9D8B030D-6E8A-4147-A177-3AD203B41FA5}">
                      <a16:colId xmlns:a16="http://schemas.microsoft.com/office/drawing/2014/main" val="3549038995"/>
                    </a:ext>
                  </a:extLst>
                </a:gridCol>
                <a:gridCol w="656167">
                  <a:extLst>
                    <a:ext uri="{9D8B030D-6E8A-4147-A177-3AD203B41FA5}">
                      <a16:colId xmlns:a16="http://schemas.microsoft.com/office/drawing/2014/main" val="1225594128"/>
                    </a:ext>
                  </a:extLst>
                </a:gridCol>
                <a:gridCol w="516466">
                  <a:extLst>
                    <a:ext uri="{9D8B030D-6E8A-4147-A177-3AD203B41FA5}">
                      <a16:colId xmlns:a16="http://schemas.microsoft.com/office/drawing/2014/main" val="4177472088"/>
                    </a:ext>
                  </a:extLst>
                </a:gridCol>
                <a:gridCol w="965200">
                  <a:extLst>
                    <a:ext uri="{9D8B030D-6E8A-4147-A177-3AD203B41FA5}">
                      <a16:colId xmlns:a16="http://schemas.microsoft.com/office/drawing/2014/main" val="212096707"/>
                    </a:ext>
                  </a:extLst>
                </a:gridCol>
                <a:gridCol w="711200">
                  <a:extLst>
                    <a:ext uri="{9D8B030D-6E8A-4147-A177-3AD203B41FA5}">
                      <a16:colId xmlns:a16="http://schemas.microsoft.com/office/drawing/2014/main" val="696750978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i="0" kern="1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NOVA table</a:t>
                      </a:r>
                      <a:endParaRPr lang="en-US" sz="1100" i="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kern="1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S</a:t>
                      </a:r>
                      <a:endParaRPr lang="en-US" sz="110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kern="1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F</a:t>
                      </a:r>
                      <a:endParaRPr lang="en-US" sz="110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kern="1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S</a:t>
                      </a:r>
                      <a:endParaRPr lang="en-US" sz="110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 (</a:t>
                      </a:r>
                      <a:r>
                        <a:rPr lang="en-US" sz="1100" b="1" dirty="0" err="1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Fn</a:t>
                      </a: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lang="en-US" sz="1100" b="1" dirty="0" err="1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Fd</a:t>
                      </a: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en-US" sz="1100" b="1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10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 value</a:t>
                      </a:r>
                      <a:endParaRPr lang="en-US" sz="1100" b="1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10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5273476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Treatment (between columns)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177297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7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25328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F (7, 16) = 88.98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P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6277692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Residual (within columns)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455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1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284.7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0366983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Total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18185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2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97623169"/>
                  </a:ext>
                </a:extLst>
              </a:tr>
            </a:tbl>
          </a:graphicData>
        </a:graphic>
      </p:graphicFrame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6CEB8414-DC94-545A-4365-6F1B32EC52C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92679692"/>
              </p:ext>
            </p:extLst>
          </p:nvPr>
        </p:nvGraphicFramePr>
        <p:xfrm>
          <a:off x="6713264" y="777157"/>
          <a:ext cx="3186053" cy="5495608"/>
        </p:xfrm>
        <a:graphic>
          <a:graphicData uri="http://schemas.openxmlformats.org/drawingml/2006/table">
            <a:tbl>
              <a:tblPr firstRow="1" firstCol="1" bandRow="1"/>
              <a:tblGrid>
                <a:gridCol w="1665261">
                  <a:extLst>
                    <a:ext uri="{9D8B030D-6E8A-4147-A177-3AD203B41FA5}">
                      <a16:colId xmlns:a16="http://schemas.microsoft.com/office/drawing/2014/main" val="4019093576"/>
                    </a:ext>
                  </a:extLst>
                </a:gridCol>
                <a:gridCol w="1520792">
                  <a:extLst>
                    <a:ext uri="{9D8B030D-6E8A-4147-A177-3AD203B41FA5}">
                      <a16:colId xmlns:a16="http://schemas.microsoft.com/office/drawing/2014/main" val="3549038995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ukey's multiple comparisons test</a:t>
                      </a:r>
                      <a:endParaRPr lang="en-US" sz="11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djusted P Value</a:t>
                      </a: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5273476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Ajwain vs. Anis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0.8539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6277692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Ajwain vs. Cumin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0.4920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0366983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Ajwain vs. Coriander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0.005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9762316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Ajwain vs. Caraway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6503175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Ajwain vs. Celery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6592949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Ajwain vs. Dill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0.000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6935585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Ajwain vs. Fennel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6413291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Anise vs. Cumin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0.997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4971951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Anise vs. Coriander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0.000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4298516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Anise vs. Caraway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2784083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Anise vs. Celery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0.001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1273830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Anise vs. Dill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1029721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Anise vs. Fennel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8020026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Cumin vs. Coriander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013732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Cumin vs. Caraway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7181888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Cumin vs. Celery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0.004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220971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Cumin vs. Dill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041015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Cumin vs. Fennel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7520096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Coriander vs. Caraway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0.01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5310508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Coriander vs. Celery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693157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Coriander vs. Dill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0.7907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7278838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Coriander vs. Fennel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7212375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Caraway vs. Celery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950189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Caraway vs. Dill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0.167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6820366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Caraway vs. Fennel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0.0040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465969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Celery vs. Dill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0854222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Celery vs. Fennel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6167684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Dill vs. Fennel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88338323"/>
                  </a:ext>
                </a:extLst>
              </a:tr>
            </a:tbl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BE137A9C-1CF4-E519-D2EA-6E3D22695470}"/>
              </a:ext>
            </a:extLst>
          </p:cNvPr>
          <p:cNvSpPr txBox="1"/>
          <p:nvPr/>
        </p:nvSpPr>
        <p:spPr>
          <a:xfrm>
            <a:off x="6622002" y="462013"/>
            <a:ext cx="3696192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dirty="0">
                <a:latin typeface="Palatino Linotype" panose="02040502050505030304" pitchFamily="18" charset="0"/>
              </a:rPr>
              <a:t>Table S13A. Tukey’s Multiple Comparisons</a:t>
            </a:r>
            <a:endParaRPr lang="en-US" sz="11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55744900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B4AD7AD2-18BC-5FED-1B2B-45A85978023C}"/>
              </a:ext>
            </a:extLst>
          </p:cNvPr>
          <p:cNvSpPr txBox="1"/>
          <p:nvPr/>
        </p:nvSpPr>
        <p:spPr>
          <a:xfrm>
            <a:off x="899695" y="515546"/>
            <a:ext cx="8576110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dirty="0">
                <a:latin typeface="Palatino Linotype" panose="02040502050505030304" pitchFamily="18" charset="0"/>
              </a:rPr>
              <a:t>Table S14. One-way ANOVA table for Apiaceae Initial Extracts IC50s in MDA-MB-231</a:t>
            </a:r>
            <a:endParaRPr lang="en-US" sz="1100" dirty="0">
              <a:latin typeface="Palatino Linotype" panose="02040502050505030304" pitchFamily="18" charset="0"/>
            </a:endParaRPr>
          </a:p>
        </p:txBody>
      </p:sp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0D66DFE7-D2FE-A32E-547D-2574B6F27A9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67276638"/>
              </p:ext>
            </p:extLst>
          </p:nvPr>
        </p:nvGraphicFramePr>
        <p:xfrm>
          <a:off x="966090" y="777156"/>
          <a:ext cx="4842934" cy="1187450"/>
        </p:xfrm>
        <a:graphic>
          <a:graphicData uri="http://schemas.openxmlformats.org/drawingml/2006/table">
            <a:tbl>
              <a:tblPr firstRow="1" firstCol="1" bandRow="1"/>
              <a:tblGrid>
                <a:gridCol w="1380316">
                  <a:extLst>
                    <a:ext uri="{9D8B030D-6E8A-4147-A177-3AD203B41FA5}">
                      <a16:colId xmlns:a16="http://schemas.microsoft.com/office/drawing/2014/main" val="4019093576"/>
                    </a:ext>
                  </a:extLst>
                </a:gridCol>
                <a:gridCol w="613585">
                  <a:extLst>
                    <a:ext uri="{9D8B030D-6E8A-4147-A177-3AD203B41FA5}">
                      <a16:colId xmlns:a16="http://schemas.microsoft.com/office/drawing/2014/main" val="3549038995"/>
                    </a:ext>
                  </a:extLst>
                </a:gridCol>
                <a:gridCol w="656167">
                  <a:extLst>
                    <a:ext uri="{9D8B030D-6E8A-4147-A177-3AD203B41FA5}">
                      <a16:colId xmlns:a16="http://schemas.microsoft.com/office/drawing/2014/main" val="1225594128"/>
                    </a:ext>
                  </a:extLst>
                </a:gridCol>
                <a:gridCol w="516466">
                  <a:extLst>
                    <a:ext uri="{9D8B030D-6E8A-4147-A177-3AD203B41FA5}">
                      <a16:colId xmlns:a16="http://schemas.microsoft.com/office/drawing/2014/main" val="4177472088"/>
                    </a:ext>
                  </a:extLst>
                </a:gridCol>
                <a:gridCol w="965200">
                  <a:extLst>
                    <a:ext uri="{9D8B030D-6E8A-4147-A177-3AD203B41FA5}">
                      <a16:colId xmlns:a16="http://schemas.microsoft.com/office/drawing/2014/main" val="212096707"/>
                    </a:ext>
                  </a:extLst>
                </a:gridCol>
                <a:gridCol w="711200">
                  <a:extLst>
                    <a:ext uri="{9D8B030D-6E8A-4147-A177-3AD203B41FA5}">
                      <a16:colId xmlns:a16="http://schemas.microsoft.com/office/drawing/2014/main" val="696750978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i="0" kern="1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NOVA table</a:t>
                      </a:r>
                      <a:endParaRPr lang="en-US" sz="1100" i="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kern="1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S</a:t>
                      </a:r>
                      <a:endParaRPr lang="en-US" sz="110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kern="1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F</a:t>
                      </a:r>
                      <a:endParaRPr lang="en-US" sz="110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kern="1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S</a:t>
                      </a:r>
                      <a:endParaRPr lang="en-US" sz="110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 (</a:t>
                      </a:r>
                      <a:r>
                        <a:rPr lang="en-US" sz="1100" b="1" dirty="0" err="1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Fn</a:t>
                      </a: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lang="en-US" sz="1100" b="1" dirty="0" err="1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Fd</a:t>
                      </a: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en-US" sz="1100" b="1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10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 value</a:t>
                      </a:r>
                      <a:endParaRPr lang="en-US" sz="1100" b="1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10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5273476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Treatment (between columns)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111508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7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159298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F (7, 16) = 113.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P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6277692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Residual (within columns)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2251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1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1407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0366983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Total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1137598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2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97623169"/>
                  </a:ext>
                </a:extLst>
              </a:tr>
            </a:tbl>
          </a:graphicData>
        </a:graphic>
      </p:graphicFrame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6CEB8414-DC94-545A-4365-6F1B32EC52C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96115133"/>
              </p:ext>
            </p:extLst>
          </p:nvPr>
        </p:nvGraphicFramePr>
        <p:xfrm>
          <a:off x="7390418" y="777156"/>
          <a:ext cx="3186053" cy="5495608"/>
        </p:xfrm>
        <a:graphic>
          <a:graphicData uri="http://schemas.openxmlformats.org/drawingml/2006/table">
            <a:tbl>
              <a:tblPr firstRow="1" firstCol="1" bandRow="1"/>
              <a:tblGrid>
                <a:gridCol w="1665261">
                  <a:extLst>
                    <a:ext uri="{9D8B030D-6E8A-4147-A177-3AD203B41FA5}">
                      <a16:colId xmlns:a16="http://schemas.microsoft.com/office/drawing/2014/main" val="4019093576"/>
                    </a:ext>
                  </a:extLst>
                </a:gridCol>
                <a:gridCol w="1520792">
                  <a:extLst>
                    <a:ext uri="{9D8B030D-6E8A-4147-A177-3AD203B41FA5}">
                      <a16:colId xmlns:a16="http://schemas.microsoft.com/office/drawing/2014/main" val="3549038995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ukey's multiple comparisons test</a:t>
                      </a:r>
                      <a:endParaRPr lang="en-US" sz="11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djusted P Value</a:t>
                      </a: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5273476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Ajwain vs. Anis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&gt;0.9999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6277692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Ajwain vs. Cumin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7960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0366983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Ajwain vs. Coriander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995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9762316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Ajwain vs. Caraway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6503175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Ajwain vs. Celery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005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6592949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Ajwain vs. Dill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4358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6935585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Ajwain vs. Fennel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003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6413291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Anise vs. Cumin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8999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4971951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Anise vs. Coriander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9997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4298516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Anise vs. Caraway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2784083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Anise vs. Celery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008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1273830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Anise vs. Dill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316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1029721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Anise vs. Fennel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0019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8020026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Cumin vs. Coriander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9910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013732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Cumin vs. Caraway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7181888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Cumin vs. Celery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0939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220971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Cumin vs. Dill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036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041015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Cumin vs. Fennel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000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7520096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Coriander vs. Caraway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5310508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Coriander vs. Celery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021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693157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Coriander vs. Dill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152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7278838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Coriander vs. Fennel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0008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7212375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Caraway vs. Celery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950189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Caraway vs. Dill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6820366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Caraway vs. Fennel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465969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Celery vs. Dill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0854222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Celery vs. Fennel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6167684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Dill vs. Fennel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169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88338323"/>
                  </a:ext>
                </a:extLst>
              </a:tr>
            </a:tbl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BE137A9C-1CF4-E519-D2EA-6E3D22695470}"/>
              </a:ext>
            </a:extLst>
          </p:cNvPr>
          <p:cNvSpPr txBox="1"/>
          <p:nvPr/>
        </p:nvSpPr>
        <p:spPr>
          <a:xfrm>
            <a:off x="7299156" y="462012"/>
            <a:ext cx="3696192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dirty="0">
                <a:latin typeface="Palatino Linotype" panose="02040502050505030304" pitchFamily="18" charset="0"/>
              </a:rPr>
              <a:t>Table S14A. Tukey’s Multiple Comparisons</a:t>
            </a:r>
            <a:endParaRPr lang="en-US" sz="11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4655663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49C8217D-9EE8-DB1C-5D0E-A6B5559773FE}"/>
              </a:ext>
            </a:extLst>
          </p:cNvPr>
          <p:cNvSpPr txBox="1"/>
          <p:nvPr/>
        </p:nvSpPr>
        <p:spPr>
          <a:xfrm>
            <a:off x="1770959" y="1905560"/>
            <a:ext cx="3513667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dirty="0">
                <a:latin typeface="Palatino Linotype" panose="02040502050505030304" pitchFamily="18" charset="0"/>
              </a:rPr>
              <a:t>Table S1. One-way ANOVA table for Extract Yields</a:t>
            </a:r>
            <a:endParaRPr lang="en-US" sz="1100" dirty="0">
              <a:latin typeface="Palatino Linotype" panose="02040502050505030304" pitchFamily="18" charset="0"/>
            </a:endParaRPr>
          </a:p>
        </p:txBody>
      </p:sp>
      <p:graphicFrame>
        <p:nvGraphicFramePr>
          <p:cNvPr id="8" name="Table 7">
            <a:extLst>
              <a:ext uri="{FF2B5EF4-FFF2-40B4-BE49-F238E27FC236}">
                <a16:creationId xmlns:a16="http://schemas.microsoft.com/office/drawing/2014/main" id="{BB1538D9-477F-0F8F-1116-8155C37FA6E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26297117"/>
              </p:ext>
            </p:extLst>
          </p:nvPr>
        </p:nvGraphicFramePr>
        <p:xfrm>
          <a:off x="1770958" y="2167170"/>
          <a:ext cx="4842934" cy="1866584"/>
        </p:xfrm>
        <a:graphic>
          <a:graphicData uri="http://schemas.openxmlformats.org/drawingml/2006/table">
            <a:tbl>
              <a:tblPr firstRow="1" firstCol="1" bandRow="1"/>
              <a:tblGrid>
                <a:gridCol w="1380316">
                  <a:extLst>
                    <a:ext uri="{9D8B030D-6E8A-4147-A177-3AD203B41FA5}">
                      <a16:colId xmlns:a16="http://schemas.microsoft.com/office/drawing/2014/main" val="4019093576"/>
                    </a:ext>
                  </a:extLst>
                </a:gridCol>
                <a:gridCol w="613585">
                  <a:extLst>
                    <a:ext uri="{9D8B030D-6E8A-4147-A177-3AD203B41FA5}">
                      <a16:colId xmlns:a16="http://schemas.microsoft.com/office/drawing/2014/main" val="3549038995"/>
                    </a:ext>
                  </a:extLst>
                </a:gridCol>
                <a:gridCol w="656167">
                  <a:extLst>
                    <a:ext uri="{9D8B030D-6E8A-4147-A177-3AD203B41FA5}">
                      <a16:colId xmlns:a16="http://schemas.microsoft.com/office/drawing/2014/main" val="1225594128"/>
                    </a:ext>
                  </a:extLst>
                </a:gridCol>
                <a:gridCol w="516466">
                  <a:extLst>
                    <a:ext uri="{9D8B030D-6E8A-4147-A177-3AD203B41FA5}">
                      <a16:colId xmlns:a16="http://schemas.microsoft.com/office/drawing/2014/main" val="4177472088"/>
                    </a:ext>
                  </a:extLst>
                </a:gridCol>
                <a:gridCol w="965200">
                  <a:extLst>
                    <a:ext uri="{9D8B030D-6E8A-4147-A177-3AD203B41FA5}">
                      <a16:colId xmlns:a16="http://schemas.microsoft.com/office/drawing/2014/main" val="212096707"/>
                    </a:ext>
                  </a:extLst>
                </a:gridCol>
                <a:gridCol w="711200">
                  <a:extLst>
                    <a:ext uri="{9D8B030D-6E8A-4147-A177-3AD203B41FA5}">
                      <a16:colId xmlns:a16="http://schemas.microsoft.com/office/drawing/2014/main" val="696750978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i="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NOVA table</a:t>
                      </a:r>
                      <a:endParaRPr lang="en-US" sz="1100" i="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S</a:t>
                      </a:r>
                      <a:endParaRPr lang="en-US" sz="110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F</a:t>
                      </a:r>
                      <a:endParaRPr lang="en-US" sz="110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S</a:t>
                      </a:r>
                      <a:endParaRPr lang="en-US" sz="110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 (</a:t>
                      </a:r>
                      <a:r>
                        <a:rPr lang="en-US" sz="1100" b="1" dirty="0" err="1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Fn</a:t>
                      </a: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lang="en-US" sz="1100" b="1" dirty="0" err="1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Fd</a:t>
                      </a: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en-US" sz="1100" b="1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10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 value</a:t>
                      </a:r>
                      <a:endParaRPr lang="en-US" sz="1100" b="1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10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5273476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reatment </a:t>
                      </a:r>
                    </a:p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between columns)</a:t>
                      </a:r>
                      <a:endParaRPr lang="en-US" sz="1100" b="1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4290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7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612.9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F (7, 16) = 18.9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P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6277692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esidual </a:t>
                      </a:r>
                    </a:p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within columns)</a:t>
                      </a:r>
                      <a:endParaRPr lang="en-US" sz="1100" b="1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517.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1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32.3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0366983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otal</a:t>
                      </a:r>
                      <a:endParaRPr lang="en-US" sz="1100" b="1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4808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2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97623169"/>
                  </a:ext>
                </a:extLst>
              </a:tr>
            </a:tbl>
          </a:graphicData>
        </a:graphic>
      </p:graphicFrame>
      <p:graphicFrame>
        <p:nvGraphicFramePr>
          <p:cNvPr id="11" name="Table 10">
            <a:extLst>
              <a:ext uri="{FF2B5EF4-FFF2-40B4-BE49-F238E27FC236}">
                <a16:creationId xmlns:a16="http://schemas.microsoft.com/office/drawing/2014/main" id="{46D10D4F-C46D-0814-5EE8-B69933A63B6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32691578"/>
              </p:ext>
            </p:extLst>
          </p:nvPr>
        </p:nvGraphicFramePr>
        <p:xfrm>
          <a:off x="7101662" y="2167170"/>
          <a:ext cx="3186053" cy="3059748"/>
        </p:xfrm>
        <a:graphic>
          <a:graphicData uri="http://schemas.openxmlformats.org/drawingml/2006/table">
            <a:tbl>
              <a:tblPr firstRow="1" firstCol="1" bandRow="1"/>
              <a:tblGrid>
                <a:gridCol w="1665261">
                  <a:extLst>
                    <a:ext uri="{9D8B030D-6E8A-4147-A177-3AD203B41FA5}">
                      <a16:colId xmlns:a16="http://schemas.microsoft.com/office/drawing/2014/main" val="4019093576"/>
                    </a:ext>
                  </a:extLst>
                </a:gridCol>
                <a:gridCol w="1520792">
                  <a:extLst>
                    <a:ext uri="{9D8B030D-6E8A-4147-A177-3AD203B41FA5}">
                      <a16:colId xmlns:a16="http://schemas.microsoft.com/office/drawing/2014/main" val="3549038995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ukey's multiple comparisons test</a:t>
                      </a:r>
                      <a:endParaRPr lang="en-US" sz="11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djusted P Value</a:t>
                      </a: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5273476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Cumin vs. Caraway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6277692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Cumin vs. Dill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0366983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Cumin vs. Fennel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0.008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9762316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Cumin vs. Ajwain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0.000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6503175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Cumin vs. Coriander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6592949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Caraway vs. Fennel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0.026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6935585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Caraway vs. Celery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0.000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6413291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Caraway vs. Anis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0.003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4971951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Dill vs. Fennel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0.040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4298516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Dill vs. Celery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0.0009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2784083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Dill vs. Anis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0.005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1273830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Fennel vs. Coriander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0.015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1029721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Coriander vs. Celery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0.000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8020026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Coriander vs. Anis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0.0020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31693127"/>
                  </a:ext>
                </a:extLst>
              </a:tr>
            </a:tbl>
          </a:graphicData>
        </a:graphic>
      </p:graphicFrame>
      <p:sp>
        <p:nvSpPr>
          <p:cNvPr id="14" name="TextBox 13">
            <a:extLst>
              <a:ext uri="{FF2B5EF4-FFF2-40B4-BE49-F238E27FC236}">
                <a16:creationId xmlns:a16="http://schemas.microsoft.com/office/drawing/2014/main" id="{457EEAD9-30F2-A1ED-CD20-E93AA0A36BA9}"/>
              </a:ext>
            </a:extLst>
          </p:cNvPr>
          <p:cNvSpPr txBox="1"/>
          <p:nvPr/>
        </p:nvSpPr>
        <p:spPr>
          <a:xfrm>
            <a:off x="7010400" y="1852026"/>
            <a:ext cx="3696192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dirty="0">
                <a:latin typeface="Palatino Linotype" panose="02040502050505030304" pitchFamily="18" charset="0"/>
              </a:rPr>
              <a:t>Table S1A. Tukey’s Multiple Comparisons</a:t>
            </a:r>
            <a:endParaRPr lang="en-US" sz="11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12583678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B4AD7AD2-18BC-5FED-1B2B-45A85978023C}"/>
              </a:ext>
            </a:extLst>
          </p:cNvPr>
          <p:cNvSpPr txBox="1"/>
          <p:nvPr/>
        </p:nvSpPr>
        <p:spPr>
          <a:xfrm>
            <a:off x="1005573" y="948684"/>
            <a:ext cx="8576110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dirty="0">
                <a:latin typeface="Palatino Linotype" panose="02040502050505030304" pitchFamily="18" charset="0"/>
              </a:rPr>
              <a:t>Table S15. One-way ANOVA table for Apiaceae Initial Extracts IC50s in T-47D</a:t>
            </a:r>
            <a:endParaRPr lang="en-US" sz="1100" dirty="0">
              <a:latin typeface="Palatino Linotype" panose="02040502050505030304" pitchFamily="18" charset="0"/>
            </a:endParaRPr>
          </a:p>
        </p:txBody>
      </p:sp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0D66DFE7-D2FE-A32E-547D-2574B6F27A9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30340874"/>
              </p:ext>
            </p:extLst>
          </p:nvPr>
        </p:nvGraphicFramePr>
        <p:xfrm>
          <a:off x="1071968" y="1210294"/>
          <a:ext cx="4842934" cy="1187450"/>
        </p:xfrm>
        <a:graphic>
          <a:graphicData uri="http://schemas.openxmlformats.org/drawingml/2006/table">
            <a:tbl>
              <a:tblPr firstRow="1" firstCol="1" bandRow="1"/>
              <a:tblGrid>
                <a:gridCol w="1513103">
                  <a:extLst>
                    <a:ext uri="{9D8B030D-6E8A-4147-A177-3AD203B41FA5}">
                      <a16:colId xmlns:a16="http://schemas.microsoft.com/office/drawing/2014/main" val="4019093576"/>
                    </a:ext>
                  </a:extLst>
                </a:gridCol>
                <a:gridCol w="735645">
                  <a:extLst>
                    <a:ext uri="{9D8B030D-6E8A-4147-A177-3AD203B41FA5}">
                      <a16:colId xmlns:a16="http://schemas.microsoft.com/office/drawing/2014/main" val="3549038995"/>
                    </a:ext>
                  </a:extLst>
                </a:gridCol>
                <a:gridCol w="401320">
                  <a:extLst>
                    <a:ext uri="{9D8B030D-6E8A-4147-A177-3AD203B41FA5}">
                      <a16:colId xmlns:a16="http://schemas.microsoft.com/office/drawing/2014/main" val="1225594128"/>
                    </a:ext>
                  </a:extLst>
                </a:gridCol>
                <a:gridCol w="516466">
                  <a:extLst>
                    <a:ext uri="{9D8B030D-6E8A-4147-A177-3AD203B41FA5}">
                      <a16:colId xmlns:a16="http://schemas.microsoft.com/office/drawing/2014/main" val="4177472088"/>
                    </a:ext>
                  </a:extLst>
                </a:gridCol>
                <a:gridCol w="965200">
                  <a:extLst>
                    <a:ext uri="{9D8B030D-6E8A-4147-A177-3AD203B41FA5}">
                      <a16:colId xmlns:a16="http://schemas.microsoft.com/office/drawing/2014/main" val="212096707"/>
                    </a:ext>
                  </a:extLst>
                </a:gridCol>
                <a:gridCol w="711200">
                  <a:extLst>
                    <a:ext uri="{9D8B030D-6E8A-4147-A177-3AD203B41FA5}">
                      <a16:colId xmlns:a16="http://schemas.microsoft.com/office/drawing/2014/main" val="696750978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i="0" kern="1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NOVA table</a:t>
                      </a:r>
                      <a:endParaRPr lang="en-US" sz="1100" i="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kern="1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S</a:t>
                      </a:r>
                      <a:endParaRPr lang="en-US" sz="110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kern="1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F</a:t>
                      </a:r>
                      <a:endParaRPr lang="en-US" sz="110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kern="1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S</a:t>
                      </a:r>
                      <a:endParaRPr lang="en-US" sz="110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 (</a:t>
                      </a:r>
                      <a:r>
                        <a:rPr lang="en-US" sz="1100" b="1" dirty="0" err="1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Fn</a:t>
                      </a: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lang="en-US" sz="1100" b="1" dirty="0" err="1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Fd</a:t>
                      </a: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en-US" sz="1100" b="1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10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 value</a:t>
                      </a:r>
                      <a:endParaRPr lang="en-US" sz="1100" b="1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10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5273476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Treatment </a:t>
                      </a:r>
                    </a:p>
                    <a:p>
                      <a:pPr algn="l" fontAlgn="b"/>
                      <a:r>
                        <a:rPr lang="en-US" sz="11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(between columns)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124660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7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17808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F (7, 16) = 101.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P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6277692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Residual </a:t>
                      </a:r>
                    </a:p>
                    <a:p>
                      <a:pPr algn="l" fontAlgn="b"/>
                      <a:r>
                        <a:rPr lang="en-US" sz="11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(within columns)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2819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1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176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0366983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Total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127479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2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97623169"/>
                  </a:ext>
                </a:extLst>
              </a:tr>
            </a:tbl>
          </a:graphicData>
        </a:graphic>
      </p:graphicFrame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6CEB8414-DC94-545A-4365-6F1B32EC52C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63798284"/>
              </p:ext>
            </p:extLst>
          </p:nvPr>
        </p:nvGraphicFramePr>
        <p:xfrm>
          <a:off x="7362910" y="1156760"/>
          <a:ext cx="3186053" cy="5495608"/>
        </p:xfrm>
        <a:graphic>
          <a:graphicData uri="http://schemas.openxmlformats.org/drawingml/2006/table">
            <a:tbl>
              <a:tblPr firstRow="1" firstCol="1" bandRow="1"/>
              <a:tblGrid>
                <a:gridCol w="1665261">
                  <a:extLst>
                    <a:ext uri="{9D8B030D-6E8A-4147-A177-3AD203B41FA5}">
                      <a16:colId xmlns:a16="http://schemas.microsoft.com/office/drawing/2014/main" val="4019093576"/>
                    </a:ext>
                  </a:extLst>
                </a:gridCol>
                <a:gridCol w="1520792">
                  <a:extLst>
                    <a:ext uri="{9D8B030D-6E8A-4147-A177-3AD203B41FA5}">
                      <a16:colId xmlns:a16="http://schemas.microsoft.com/office/drawing/2014/main" val="3549038995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ukey's multiple comparisons test</a:t>
                      </a:r>
                      <a:endParaRPr lang="en-US" sz="11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djusted P Value</a:t>
                      </a: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5273476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Ajwain vs. Anis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0.381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6277692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Ajwain vs. Cumin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0.8488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0366983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Ajwain vs. Coriander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&gt;0.9999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9762316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Ajwain vs. Caraway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0.010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6503175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Ajwain vs. Celery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0.0440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6592949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Ajwain vs. Dill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0.386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6935585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Ajwain vs. Fennel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6413291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Anise vs. Cumin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0.987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4971951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Anise vs. Coriander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0.396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4298516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Anise vs. Caraway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0.000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2784083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Anise vs. Celery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0.888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1273830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Anise vs. Dill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0.007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1029721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Anise vs. Fennel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8020026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Cumin vs. Coriander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0.861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013732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Cumin vs. Caraway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0.0007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7181888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Cumin vs. Celery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0.432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220971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Cumin vs. Dill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0.037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041015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Cumin vs. Fennel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7520096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Coriander vs. Caraway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0.0100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5310508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Coriander vs. Celery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0.046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693157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Coriander vs. Dill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0.371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8556285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Coriander vs. Fennel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6137406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Caraway vs. Celery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6327521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Caraway vs. Dill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0.486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0876429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Caraway vs. Fennel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615261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Celery vs. Dill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0.000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8352518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Celery vs. Fennel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5712763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Dill vs. Fennel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22462261"/>
                  </a:ext>
                </a:extLst>
              </a:tr>
            </a:tbl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BE137A9C-1CF4-E519-D2EA-6E3D22695470}"/>
              </a:ext>
            </a:extLst>
          </p:cNvPr>
          <p:cNvSpPr txBox="1"/>
          <p:nvPr/>
        </p:nvSpPr>
        <p:spPr>
          <a:xfrm>
            <a:off x="7405034" y="895150"/>
            <a:ext cx="3696192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dirty="0">
                <a:latin typeface="Palatino Linotype" panose="02040502050505030304" pitchFamily="18" charset="0"/>
              </a:rPr>
              <a:t>Table S15A. Tukey’s Multiple Comparisons</a:t>
            </a:r>
            <a:endParaRPr lang="en-US" sz="11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73186315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7CE3D4DA-7B32-E814-AD3D-F64DAF844D27}"/>
              </a:ext>
            </a:extLst>
          </p:cNvPr>
          <p:cNvSpPr txBox="1"/>
          <p:nvPr/>
        </p:nvSpPr>
        <p:spPr>
          <a:xfrm>
            <a:off x="1447176" y="113504"/>
            <a:ext cx="5196216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dirty="0">
                <a:latin typeface="Palatino Linotype" panose="02040502050505030304" pitchFamily="18" charset="0"/>
              </a:rPr>
              <a:t>Table S16. Two-way ANOVA table for AH-Extract IC50 Calculations in T-47D</a:t>
            </a:r>
            <a:endParaRPr lang="en-US" sz="1100" dirty="0">
              <a:latin typeface="Palatino Linotype" panose="02040502050505030304" pitchFamily="18" charset="0"/>
            </a:endParaRPr>
          </a:p>
        </p:txBody>
      </p:sp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BD7A8E18-51E8-B74C-56FC-B8A5F584286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27260597"/>
              </p:ext>
            </p:extLst>
          </p:nvPr>
        </p:nvGraphicFramePr>
        <p:xfrm>
          <a:off x="1447176" y="456148"/>
          <a:ext cx="4842934" cy="1193800"/>
        </p:xfrm>
        <a:graphic>
          <a:graphicData uri="http://schemas.openxmlformats.org/drawingml/2006/table">
            <a:tbl>
              <a:tblPr firstRow="1" firstCol="1" bandRow="1"/>
              <a:tblGrid>
                <a:gridCol w="1380316">
                  <a:extLst>
                    <a:ext uri="{9D8B030D-6E8A-4147-A177-3AD203B41FA5}">
                      <a16:colId xmlns:a16="http://schemas.microsoft.com/office/drawing/2014/main" val="4019093576"/>
                    </a:ext>
                  </a:extLst>
                </a:gridCol>
                <a:gridCol w="691701">
                  <a:extLst>
                    <a:ext uri="{9D8B030D-6E8A-4147-A177-3AD203B41FA5}">
                      <a16:colId xmlns:a16="http://schemas.microsoft.com/office/drawing/2014/main" val="3549038995"/>
                    </a:ext>
                  </a:extLst>
                </a:gridCol>
                <a:gridCol w="203200">
                  <a:extLst>
                    <a:ext uri="{9D8B030D-6E8A-4147-A177-3AD203B41FA5}">
                      <a16:colId xmlns:a16="http://schemas.microsoft.com/office/drawing/2014/main" val="1225594128"/>
                    </a:ext>
                  </a:extLst>
                </a:gridCol>
                <a:gridCol w="891317">
                  <a:extLst>
                    <a:ext uri="{9D8B030D-6E8A-4147-A177-3AD203B41FA5}">
                      <a16:colId xmlns:a16="http://schemas.microsoft.com/office/drawing/2014/main" val="4177472088"/>
                    </a:ext>
                  </a:extLst>
                </a:gridCol>
                <a:gridCol w="1051445">
                  <a:extLst>
                    <a:ext uri="{9D8B030D-6E8A-4147-A177-3AD203B41FA5}">
                      <a16:colId xmlns:a16="http://schemas.microsoft.com/office/drawing/2014/main" val="212096707"/>
                    </a:ext>
                  </a:extLst>
                </a:gridCol>
                <a:gridCol w="624955">
                  <a:extLst>
                    <a:ext uri="{9D8B030D-6E8A-4147-A177-3AD203B41FA5}">
                      <a16:colId xmlns:a16="http://schemas.microsoft.com/office/drawing/2014/main" val="696750978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i="0" kern="1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NOVA table</a:t>
                      </a:r>
                      <a:endParaRPr lang="en-US" sz="1100" i="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kern="1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S</a:t>
                      </a:r>
                      <a:endParaRPr lang="en-US" sz="110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kern="1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F</a:t>
                      </a:r>
                      <a:endParaRPr lang="en-US" sz="110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kern="1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S</a:t>
                      </a:r>
                      <a:endParaRPr lang="en-US" sz="110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 (</a:t>
                      </a:r>
                      <a:r>
                        <a:rPr lang="en-US" sz="1100" b="1" dirty="0" err="1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Fn</a:t>
                      </a: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lang="en-US" sz="1100" b="1" dirty="0" err="1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Fd</a:t>
                      </a: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en-US" sz="1100" b="1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10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 value</a:t>
                      </a:r>
                      <a:endParaRPr lang="en-US" sz="1100" b="1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10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5273476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Interaction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647238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1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4623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F (14, 47) = 12.47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P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6277692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Spice Factor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117143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7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167348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F (7, 47) = 45.1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P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0366983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Extract Treatment Factor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248529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12426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F (2, 47) = 33.5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P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1973013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Residual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174290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47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3708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97623169"/>
                  </a:ext>
                </a:extLst>
              </a:tr>
            </a:tbl>
          </a:graphicData>
        </a:graphic>
      </p:graphicFrame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2DC778C3-036B-E3F5-9BD3-1D5EDF739A1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48627377"/>
              </p:ext>
            </p:extLst>
          </p:nvPr>
        </p:nvGraphicFramePr>
        <p:xfrm>
          <a:off x="7305396" y="375114"/>
          <a:ext cx="4293046" cy="5856288"/>
        </p:xfrm>
        <a:graphic>
          <a:graphicData uri="http://schemas.openxmlformats.org/drawingml/2006/table">
            <a:tbl>
              <a:tblPr firstRow="1" firstCol="1" bandRow="1"/>
              <a:tblGrid>
                <a:gridCol w="2911133">
                  <a:extLst>
                    <a:ext uri="{9D8B030D-6E8A-4147-A177-3AD203B41FA5}">
                      <a16:colId xmlns:a16="http://schemas.microsoft.com/office/drawing/2014/main" val="4019093576"/>
                    </a:ext>
                  </a:extLst>
                </a:gridCol>
                <a:gridCol w="1381913">
                  <a:extLst>
                    <a:ext uri="{9D8B030D-6E8A-4147-A177-3AD203B41FA5}">
                      <a16:colId xmlns:a16="http://schemas.microsoft.com/office/drawing/2014/main" val="3549038995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Tukey's multiple comparisons test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djusted P Value</a:t>
                      </a: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5273476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Ajwain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1320416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Raw Extract vs. Processed Extract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0.957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1570130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Raw Extract vs. Acid Hydrolyzed Extract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0.602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3443504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Processed Extract vs. Acid Hydrolyzed Extract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0.7740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570089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Anis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173353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Raw Extract vs. Processed Extract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0.961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525807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Raw Extract vs. Acid Hydrolyzed Extract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0.951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3834268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Processed Extract vs. Acid Hydrolyzed Extract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0.8368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5384798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Cumin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394577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Raw Extract vs. Processed Extract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0.080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70342576"/>
                  </a:ext>
                </a:extLst>
              </a:tr>
              <a:tr h="7397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Raw Extract vs. Acid Hydrolyzed Extract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0.3837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5241790"/>
                  </a:ext>
                </a:extLst>
              </a:tr>
              <a:tr h="7397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Processed Extract vs. Acid Hydrolyzed Extract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0.002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63908278"/>
                  </a:ext>
                </a:extLst>
              </a:tr>
              <a:tr h="7397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Coriander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58490837"/>
                  </a:ext>
                </a:extLst>
              </a:tr>
              <a:tr h="7397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Raw Extract vs. Processed Extract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0.018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19524468"/>
                  </a:ext>
                </a:extLst>
              </a:tr>
              <a:tr h="7397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Raw Extract vs. Acid Hydrolyzed Extract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0.925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40688637"/>
                  </a:ext>
                </a:extLst>
              </a:tr>
              <a:tr h="7397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Processed Extract vs. Acid Hydrolyzed Extract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0.006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90542512"/>
                  </a:ext>
                </a:extLst>
              </a:tr>
              <a:tr h="7397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Caraway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28205863"/>
                  </a:ext>
                </a:extLst>
              </a:tr>
              <a:tr h="7397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Raw Extract vs. Processed Extract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0.984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1311764"/>
                  </a:ext>
                </a:extLst>
              </a:tr>
              <a:tr h="7397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Raw Extract vs. Acid Hydrolyzed Extract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0.002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69910230"/>
                  </a:ext>
                </a:extLst>
              </a:tr>
              <a:tr h="7397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Processed Extract vs. Acid Hydrolyzed Extract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0.001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90807746"/>
                  </a:ext>
                </a:extLst>
              </a:tr>
              <a:tr h="7397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Celery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85529225"/>
                  </a:ext>
                </a:extLst>
              </a:tr>
              <a:tr h="7397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Raw Extract vs. Processed Extract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0.9988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39297103"/>
                  </a:ext>
                </a:extLst>
              </a:tr>
              <a:tr h="7397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Raw Extract vs. Acid Hydrolyzed Extract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0.8890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79430974"/>
                  </a:ext>
                </a:extLst>
              </a:tr>
              <a:tr h="7397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Processed Extract vs. Acid Hydrolyzed Extract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0.867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7303598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Dill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5394189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Raw Extract vs. Processed Extract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0.260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9533484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Raw Extract vs. Acid Hydrolyzed Extract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0.2720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5112710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Processed Extract vs. Acid Hydrolyzed Extract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0.999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3880505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Fennel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4697014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Raw Extract vs. Processed Extract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0.0020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7753514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Raw Extract vs. Acid Hydrolyzed Extract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9762316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Processed Extract vs. Acid Hydrolyzed Extract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65929490"/>
                  </a:ext>
                </a:extLst>
              </a:tr>
            </a:tbl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BEBCEEFE-F3B2-DC93-9B9D-E6125A5EF931}"/>
              </a:ext>
            </a:extLst>
          </p:cNvPr>
          <p:cNvSpPr txBox="1"/>
          <p:nvPr/>
        </p:nvSpPr>
        <p:spPr>
          <a:xfrm>
            <a:off x="7305396" y="113504"/>
            <a:ext cx="3696192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dirty="0">
                <a:latin typeface="Palatino Linotype" panose="02040502050505030304" pitchFamily="18" charset="0"/>
              </a:rPr>
              <a:t>Table S16A. </a:t>
            </a:r>
            <a:r>
              <a:rPr lang="en-US" sz="1100" b="1" i="0" u="none" strike="noStrike" dirty="0">
                <a:effectLst/>
                <a:latin typeface="Palatino Linotype" panose="02040502050505030304" pitchFamily="18" charset="0"/>
              </a:rPr>
              <a:t>Tukey's</a:t>
            </a:r>
            <a:r>
              <a:rPr lang="en-US" sz="1100" b="1" dirty="0">
                <a:latin typeface="Palatino Linotype" panose="02040502050505030304" pitchFamily="18" charset="0"/>
              </a:rPr>
              <a:t> Multiple Comparisons</a:t>
            </a:r>
            <a:endParaRPr lang="en-US" sz="11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83355326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44E9857F-65BC-6E83-EF0F-87964251E84D}"/>
              </a:ext>
            </a:extLst>
          </p:cNvPr>
          <p:cNvSpPr txBox="1"/>
          <p:nvPr/>
        </p:nvSpPr>
        <p:spPr>
          <a:xfrm>
            <a:off x="908161" y="1396638"/>
            <a:ext cx="8212756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dirty="0">
                <a:latin typeface="Palatino Linotype" panose="02040502050505030304" pitchFamily="18" charset="0"/>
              </a:rPr>
              <a:t>Table S17. Two-way ANOVA table for AH Extract Exosome Formulation IC50 Calculations</a:t>
            </a:r>
            <a:endParaRPr lang="en-US" sz="1100" dirty="0">
              <a:latin typeface="Palatino Linotype" panose="02040502050505030304" pitchFamily="18" charset="0"/>
            </a:endParaRPr>
          </a:p>
        </p:txBody>
      </p:sp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5569E829-DEC8-DE24-4ED4-B81C9472FB4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42983317"/>
              </p:ext>
            </p:extLst>
          </p:nvPr>
        </p:nvGraphicFramePr>
        <p:xfrm>
          <a:off x="908161" y="1711782"/>
          <a:ext cx="4842934" cy="1026160"/>
        </p:xfrm>
        <a:graphic>
          <a:graphicData uri="http://schemas.openxmlformats.org/drawingml/2006/table">
            <a:tbl>
              <a:tblPr firstRow="1" firstCol="1" bandRow="1"/>
              <a:tblGrid>
                <a:gridCol w="1380316">
                  <a:extLst>
                    <a:ext uri="{9D8B030D-6E8A-4147-A177-3AD203B41FA5}">
                      <a16:colId xmlns:a16="http://schemas.microsoft.com/office/drawing/2014/main" val="4019093576"/>
                    </a:ext>
                  </a:extLst>
                </a:gridCol>
                <a:gridCol w="691701">
                  <a:extLst>
                    <a:ext uri="{9D8B030D-6E8A-4147-A177-3AD203B41FA5}">
                      <a16:colId xmlns:a16="http://schemas.microsoft.com/office/drawing/2014/main" val="3549038995"/>
                    </a:ext>
                  </a:extLst>
                </a:gridCol>
                <a:gridCol w="203200">
                  <a:extLst>
                    <a:ext uri="{9D8B030D-6E8A-4147-A177-3AD203B41FA5}">
                      <a16:colId xmlns:a16="http://schemas.microsoft.com/office/drawing/2014/main" val="1225594128"/>
                    </a:ext>
                  </a:extLst>
                </a:gridCol>
                <a:gridCol w="891317">
                  <a:extLst>
                    <a:ext uri="{9D8B030D-6E8A-4147-A177-3AD203B41FA5}">
                      <a16:colId xmlns:a16="http://schemas.microsoft.com/office/drawing/2014/main" val="4177472088"/>
                    </a:ext>
                  </a:extLst>
                </a:gridCol>
                <a:gridCol w="965200">
                  <a:extLst>
                    <a:ext uri="{9D8B030D-6E8A-4147-A177-3AD203B41FA5}">
                      <a16:colId xmlns:a16="http://schemas.microsoft.com/office/drawing/2014/main" val="212096707"/>
                    </a:ext>
                  </a:extLst>
                </a:gridCol>
                <a:gridCol w="711200">
                  <a:extLst>
                    <a:ext uri="{9D8B030D-6E8A-4147-A177-3AD203B41FA5}">
                      <a16:colId xmlns:a16="http://schemas.microsoft.com/office/drawing/2014/main" val="696750978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i="0" kern="1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NOVA table</a:t>
                      </a:r>
                      <a:endParaRPr lang="en-US" sz="1100" i="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kern="1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S</a:t>
                      </a:r>
                      <a:endParaRPr lang="en-US" sz="110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kern="1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F</a:t>
                      </a:r>
                      <a:endParaRPr lang="en-US" sz="110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kern="1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S</a:t>
                      </a:r>
                      <a:endParaRPr lang="en-US" sz="110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 (</a:t>
                      </a:r>
                      <a:r>
                        <a:rPr lang="en-US" sz="1100" b="1" dirty="0" err="1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Fn</a:t>
                      </a: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lang="en-US" sz="1100" b="1" dirty="0" err="1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Fd</a:t>
                      </a: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en-US" sz="1100" b="1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10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 value</a:t>
                      </a:r>
                      <a:endParaRPr lang="en-US" sz="1100" b="1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10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5273476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Interaction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42510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9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472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F (9, 32) = 65.80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P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6277692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Processing Factor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34937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1164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F (3, 32) = 162.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P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0366983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Spice Factor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3871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1290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F (3, 32) = 179.8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P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1973013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Residual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2297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3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71.79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97623169"/>
                  </a:ext>
                </a:extLst>
              </a:tr>
            </a:tbl>
          </a:graphicData>
        </a:graphic>
      </p:graphicFrame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D20797F2-29FA-FD8B-9D76-A869E9C03F2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91182886"/>
              </p:ext>
            </p:extLst>
          </p:nvPr>
        </p:nvGraphicFramePr>
        <p:xfrm>
          <a:off x="7290780" y="1711782"/>
          <a:ext cx="3884351" cy="3214688"/>
        </p:xfrm>
        <a:graphic>
          <a:graphicData uri="http://schemas.openxmlformats.org/drawingml/2006/table">
            <a:tbl>
              <a:tblPr firstRow="1" firstCol="1" bandRow="1"/>
              <a:tblGrid>
                <a:gridCol w="3179501">
                  <a:extLst>
                    <a:ext uri="{9D8B030D-6E8A-4147-A177-3AD203B41FA5}">
                      <a16:colId xmlns:a16="http://schemas.microsoft.com/office/drawing/2014/main" val="4019093576"/>
                    </a:ext>
                  </a:extLst>
                </a:gridCol>
                <a:gridCol w="704850">
                  <a:extLst>
                    <a:ext uri="{9D8B030D-6E8A-4147-A177-3AD203B41FA5}">
                      <a16:colId xmlns:a16="http://schemas.microsoft.com/office/drawing/2014/main" val="3549038995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Dunnett's multiple comparisons test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djusted P Value</a:t>
                      </a: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5273476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Ajwain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1320416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Processed Extract vs. Processed Exosome Formulation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9208421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Processed Extract vs. AH Exosome Formulation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4273072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1570130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Anis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3443504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Processed Extract vs. Acid Hydrolyzed Extract 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570089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Processed Extract vs. Processed Exosome Formulation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8876945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525807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Cumin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3834268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Processed Extract vs. Acid Hydrolyzed Extract 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5384798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Processed Extract vs. Processed Exosome Formulation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9630207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Processed Extract vs. AH Exosome Formulation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3945777"/>
                  </a:ext>
                </a:extLst>
              </a:tr>
            </a:tbl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AF7ABE03-33D9-AA05-6FD8-72F95D5D192E}"/>
              </a:ext>
            </a:extLst>
          </p:cNvPr>
          <p:cNvSpPr txBox="1"/>
          <p:nvPr/>
        </p:nvSpPr>
        <p:spPr>
          <a:xfrm>
            <a:off x="7199518" y="1396638"/>
            <a:ext cx="3696192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dirty="0">
                <a:latin typeface="Palatino Linotype" panose="02040502050505030304" pitchFamily="18" charset="0"/>
              </a:rPr>
              <a:t>Table S17A. </a:t>
            </a:r>
            <a:r>
              <a:rPr lang="en-US" sz="1100" b="1" i="0" u="none" strike="noStrike" dirty="0">
                <a:effectLst/>
                <a:latin typeface="Palatino Linotype" panose="02040502050505030304" pitchFamily="18" charset="0"/>
              </a:rPr>
              <a:t>Dunnett's</a:t>
            </a:r>
            <a:r>
              <a:rPr lang="en-US" sz="1100" b="1" dirty="0">
                <a:latin typeface="Palatino Linotype" panose="02040502050505030304" pitchFamily="18" charset="0"/>
              </a:rPr>
              <a:t> Multiple Comparisons</a:t>
            </a:r>
            <a:endParaRPr lang="en-US" sz="11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12511228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AA2475F2-A369-31B8-A2B4-B5976142C3CF}"/>
              </a:ext>
            </a:extLst>
          </p:cNvPr>
          <p:cNvSpPr txBox="1"/>
          <p:nvPr/>
        </p:nvSpPr>
        <p:spPr>
          <a:xfrm>
            <a:off x="838377" y="126093"/>
            <a:ext cx="4949615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dirty="0">
                <a:latin typeface="Palatino Linotype" panose="02040502050505030304" pitchFamily="18" charset="0"/>
              </a:rPr>
              <a:t>Table S18. : HPLC Total Peak Area Data: </a:t>
            </a:r>
            <a:r>
              <a:rPr lang="en-US" sz="1100" b="1" i="1" dirty="0">
                <a:latin typeface="Palatino Linotype" panose="02040502050505030304" pitchFamily="18" charset="0"/>
              </a:rPr>
              <a:t>Apiaceae</a:t>
            </a:r>
            <a:r>
              <a:rPr lang="en-US" sz="1100" b="1" dirty="0">
                <a:latin typeface="Palatino Linotype" panose="02040502050505030304" pitchFamily="18" charset="0"/>
              </a:rPr>
              <a:t> Spice Extract (mAU’s)</a:t>
            </a:r>
            <a:endParaRPr lang="en-US" sz="1100" dirty="0">
              <a:latin typeface="Palatino Linotype" panose="02040502050505030304" pitchFamily="18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95F253F7-4F9A-2764-4ED0-91EDD8D53023}"/>
              </a:ext>
            </a:extLst>
          </p:cNvPr>
          <p:cNvSpPr txBox="1"/>
          <p:nvPr/>
        </p:nvSpPr>
        <p:spPr>
          <a:xfrm>
            <a:off x="6843564" y="101532"/>
            <a:ext cx="3932270" cy="43088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dirty="0">
                <a:latin typeface="Palatino Linotype" panose="02040502050505030304" pitchFamily="18" charset="0"/>
              </a:rPr>
              <a:t>Table S19. : HPLC Total Peak Area Data: </a:t>
            </a:r>
            <a:r>
              <a:rPr lang="en-US" sz="1100" b="1" i="1" dirty="0">
                <a:latin typeface="Palatino Linotype" panose="02040502050505030304" pitchFamily="18" charset="0"/>
              </a:rPr>
              <a:t>Apiaceae</a:t>
            </a:r>
            <a:r>
              <a:rPr lang="en-US" sz="1100" b="1" dirty="0">
                <a:latin typeface="Palatino Linotype" panose="02040502050505030304" pitchFamily="18" charset="0"/>
              </a:rPr>
              <a:t> Spice</a:t>
            </a:r>
          </a:p>
          <a:p>
            <a:r>
              <a:rPr lang="en-US" sz="1100" b="1" dirty="0">
                <a:latin typeface="Palatino Linotype" panose="02040502050505030304" pitchFamily="18" charset="0"/>
              </a:rPr>
              <a:t> Exosome Formulations (mAU’s)</a:t>
            </a:r>
            <a:endParaRPr lang="en-US" sz="1100" dirty="0">
              <a:latin typeface="Palatino Linotype" panose="02040502050505030304" pitchFamily="18" charset="0"/>
            </a:endParaRPr>
          </a:p>
        </p:txBody>
      </p:sp>
      <p:graphicFrame>
        <p:nvGraphicFramePr>
          <p:cNvPr id="10" name="Table 9">
            <a:extLst>
              <a:ext uri="{FF2B5EF4-FFF2-40B4-BE49-F238E27FC236}">
                <a16:creationId xmlns:a16="http://schemas.microsoft.com/office/drawing/2014/main" id="{A52BEF52-495D-E7E6-630E-13EF5A44125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06465917"/>
              </p:ext>
            </p:extLst>
          </p:nvPr>
        </p:nvGraphicFramePr>
        <p:xfrm>
          <a:off x="914400" y="387703"/>
          <a:ext cx="4353444" cy="1907540"/>
        </p:xfrm>
        <a:graphic>
          <a:graphicData uri="http://schemas.openxmlformats.org/drawingml/2006/table">
            <a:tbl>
              <a:tblPr firstRow="1" firstCol="1" bandRow="1"/>
              <a:tblGrid>
                <a:gridCol w="702644">
                  <a:extLst>
                    <a:ext uri="{9D8B030D-6E8A-4147-A177-3AD203B41FA5}">
                      <a16:colId xmlns:a16="http://schemas.microsoft.com/office/drawing/2014/main" val="2373431523"/>
                    </a:ext>
                  </a:extLst>
                </a:gridCol>
                <a:gridCol w="519764">
                  <a:extLst>
                    <a:ext uri="{9D8B030D-6E8A-4147-A177-3AD203B41FA5}">
                      <a16:colId xmlns:a16="http://schemas.microsoft.com/office/drawing/2014/main" val="2483365243"/>
                    </a:ext>
                  </a:extLst>
                </a:gridCol>
                <a:gridCol w="478155">
                  <a:extLst>
                    <a:ext uri="{9D8B030D-6E8A-4147-A177-3AD203B41FA5}">
                      <a16:colId xmlns:a16="http://schemas.microsoft.com/office/drawing/2014/main" val="391852967"/>
                    </a:ext>
                  </a:extLst>
                </a:gridCol>
                <a:gridCol w="680226">
                  <a:extLst>
                    <a:ext uri="{9D8B030D-6E8A-4147-A177-3AD203B41FA5}">
                      <a16:colId xmlns:a16="http://schemas.microsoft.com/office/drawing/2014/main" val="4266730921"/>
                    </a:ext>
                  </a:extLst>
                </a:gridCol>
                <a:gridCol w="680226">
                  <a:extLst>
                    <a:ext uri="{9D8B030D-6E8A-4147-A177-3AD203B41FA5}">
                      <a16:colId xmlns:a16="http://schemas.microsoft.com/office/drawing/2014/main" val="2125494091"/>
                    </a:ext>
                  </a:extLst>
                </a:gridCol>
                <a:gridCol w="568367">
                  <a:extLst>
                    <a:ext uri="{9D8B030D-6E8A-4147-A177-3AD203B41FA5}">
                      <a16:colId xmlns:a16="http://schemas.microsoft.com/office/drawing/2014/main" val="1562495568"/>
                    </a:ext>
                  </a:extLst>
                </a:gridCol>
                <a:gridCol w="724062">
                  <a:extLst>
                    <a:ext uri="{9D8B030D-6E8A-4147-A177-3AD203B41FA5}">
                      <a16:colId xmlns:a16="http://schemas.microsoft.com/office/drawing/2014/main" val="2028328808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1" u="none" strike="noStrike" dirty="0">
                          <a:effectLst/>
                          <a:latin typeface="Palatino Linotype" panose="02040502050505030304" pitchFamily="18" charset="0"/>
                        </a:rPr>
                        <a:t>Apiaceae</a:t>
                      </a:r>
                      <a:r>
                        <a:rPr lang="en-US" sz="11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 Spic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  <a:latin typeface="Palatino Linotype" panose="02040502050505030304" pitchFamily="18" charset="0"/>
                        </a:rPr>
                        <a:t>Processed Extract</a:t>
                      </a:r>
                      <a:endParaRPr lang="en-US" sz="1100" b="1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  <a:latin typeface="Palatino Linotype" panose="02040502050505030304" pitchFamily="18" charset="0"/>
                        </a:rPr>
                        <a:t>AH-Extract</a:t>
                      </a:r>
                      <a:endParaRPr lang="en-US" sz="1100" b="1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6884919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Rep 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Rep 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Rep 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Rep 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Rep 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Rep 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61354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Anise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19618.5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22809.1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22968.8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19952.3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23943.1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18614.9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3302986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Ajwain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28689.8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28437.5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26106.8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32081.3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32019.1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20267.7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4715125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Fennel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17354.4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17711.1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17569.6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15975.3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18219.4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16673.4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8901649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Caraway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20125.7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19711.3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19779.4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16983.1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16416.1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16353.2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064474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Coriander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8948.7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8553.6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9217.2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11576.1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11823.9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11894.9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2154901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Dill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19125.6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23984.6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13242.7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16439.8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19475.6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18934.2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2735120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Cumin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34398.1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33511.4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31474.6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31096.6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31776.8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31666.4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2648051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Celery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51417.5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61614.7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59956.4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48715.9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51395.8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42197.3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33680005"/>
                  </a:ext>
                </a:extLst>
              </a:tr>
            </a:tbl>
          </a:graphicData>
        </a:graphic>
      </p:graphicFrame>
      <p:graphicFrame>
        <p:nvGraphicFramePr>
          <p:cNvPr id="13" name="Table 12">
            <a:extLst>
              <a:ext uri="{FF2B5EF4-FFF2-40B4-BE49-F238E27FC236}">
                <a16:creationId xmlns:a16="http://schemas.microsoft.com/office/drawing/2014/main" id="{0971F0CC-7954-47A2-06FF-282E00390CC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63240067"/>
              </p:ext>
            </p:extLst>
          </p:nvPr>
        </p:nvGraphicFramePr>
        <p:xfrm>
          <a:off x="6843563" y="574472"/>
          <a:ext cx="3932270" cy="1907540"/>
        </p:xfrm>
        <a:graphic>
          <a:graphicData uri="http://schemas.openxmlformats.org/drawingml/2006/table">
            <a:tbl>
              <a:tblPr firstRow="1" firstCol="1" bandRow="1"/>
              <a:tblGrid>
                <a:gridCol w="702644">
                  <a:extLst>
                    <a:ext uri="{9D8B030D-6E8A-4147-A177-3AD203B41FA5}">
                      <a16:colId xmlns:a16="http://schemas.microsoft.com/office/drawing/2014/main" val="2373431523"/>
                    </a:ext>
                  </a:extLst>
                </a:gridCol>
                <a:gridCol w="519764">
                  <a:extLst>
                    <a:ext uri="{9D8B030D-6E8A-4147-A177-3AD203B41FA5}">
                      <a16:colId xmlns:a16="http://schemas.microsoft.com/office/drawing/2014/main" val="2483365243"/>
                    </a:ext>
                  </a:extLst>
                </a:gridCol>
                <a:gridCol w="571500">
                  <a:extLst>
                    <a:ext uri="{9D8B030D-6E8A-4147-A177-3AD203B41FA5}">
                      <a16:colId xmlns:a16="http://schemas.microsoft.com/office/drawing/2014/main" val="391852967"/>
                    </a:ext>
                  </a:extLst>
                </a:gridCol>
                <a:gridCol w="501650">
                  <a:extLst>
                    <a:ext uri="{9D8B030D-6E8A-4147-A177-3AD203B41FA5}">
                      <a16:colId xmlns:a16="http://schemas.microsoft.com/office/drawing/2014/main" val="4266730921"/>
                    </a:ext>
                  </a:extLst>
                </a:gridCol>
                <a:gridCol w="680226">
                  <a:extLst>
                    <a:ext uri="{9D8B030D-6E8A-4147-A177-3AD203B41FA5}">
                      <a16:colId xmlns:a16="http://schemas.microsoft.com/office/drawing/2014/main" val="2125494091"/>
                    </a:ext>
                  </a:extLst>
                </a:gridCol>
                <a:gridCol w="454836">
                  <a:extLst>
                    <a:ext uri="{9D8B030D-6E8A-4147-A177-3AD203B41FA5}">
                      <a16:colId xmlns:a16="http://schemas.microsoft.com/office/drawing/2014/main" val="1562495568"/>
                    </a:ext>
                  </a:extLst>
                </a:gridCol>
                <a:gridCol w="501650">
                  <a:extLst>
                    <a:ext uri="{9D8B030D-6E8A-4147-A177-3AD203B41FA5}">
                      <a16:colId xmlns:a16="http://schemas.microsoft.com/office/drawing/2014/main" val="2028328808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1" u="none" strike="noStrike" dirty="0">
                          <a:effectLst/>
                          <a:latin typeface="Palatino Linotype" panose="02040502050505030304" pitchFamily="18" charset="0"/>
                        </a:rPr>
                        <a:t>Apiaceae</a:t>
                      </a:r>
                      <a:r>
                        <a:rPr lang="en-US" sz="11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 Spic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  <a:latin typeface="Palatino Linotype" panose="02040502050505030304" pitchFamily="18" charset="0"/>
                        </a:rPr>
                        <a:t>Processed Extract Formulations</a:t>
                      </a:r>
                      <a:endParaRPr lang="en-US" sz="1100" b="1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  <a:latin typeface="Palatino Linotype" panose="02040502050505030304" pitchFamily="18" charset="0"/>
                        </a:rPr>
                        <a:t>AH-Extract Formulations</a:t>
                      </a:r>
                      <a:endParaRPr lang="en-US" sz="1100" b="1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6884919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endParaRPr lang="en-US" sz="1100" b="1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Rep 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Rep 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Rep 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Rep 1 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Rep 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Rep 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61354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Anise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2387.43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890.31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5510.45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4810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3302986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Ajwain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1376.87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1189.99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13600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7720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4715125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Cumin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4273.21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5285.3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4503.67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11300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12300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13100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89016493"/>
                  </a:ext>
                </a:extLst>
              </a:tr>
              <a:tr h="536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Coriander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1463.25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1846.7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1617.17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2033.06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3640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1873.9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064474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Caraway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1641.57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1458.74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1514.4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3661.5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4110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3938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2154901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Celery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9610.59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6645.2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12700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22500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19700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24500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2735120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Dill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2516.87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2726.68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6260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8540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2648051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Fennel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2059.02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869.51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1150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2740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33680005"/>
                  </a:ext>
                </a:extLst>
              </a:tr>
            </a:tbl>
          </a:graphicData>
        </a:graphic>
      </p:graphicFrame>
      <p:sp>
        <p:nvSpPr>
          <p:cNvPr id="14" name="TextBox 13">
            <a:extLst>
              <a:ext uri="{FF2B5EF4-FFF2-40B4-BE49-F238E27FC236}">
                <a16:creationId xmlns:a16="http://schemas.microsoft.com/office/drawing/2014/main" id="{02EC4F23-62AE-47FA-F942-52361C2AED56}"/>
              </a:ext>
            </a:extLst>
          </p:cNvPr>
          <p:cNvSpPr txBox="1"/>
          <p:nvPr/>
        </p:nvSpPr>
        <p:spPr>
          <a:xfrm>
            <a:off x="6751328" y="2621752"/>
            <a:ext cx="4182972" cy="43088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dirty="0">
                <a:latin typeface="Palatino Linotype" panose="02040502050505030304" pitchFamily="18" charset="0"/>
              </a:rPr>
              <a:t>Table S21.: MTT Data T47-D Proliferation Inhibitory Concentration 50% (IC50) µg/mL: AH-</a:t>
            </a:r>
            <a:r>
              <a:rPr lang="en-US" sz="1100" b="1" i="1" dirty="0">
                <a:latin typeface="Palatino Linotype" panose="02040502050505030304" pitchFamily="18" charset="0"/>
              </a:rPr>
              <a:t>Apiaceae</a:t>
            </a:r>
            <a:r>
              <a:rPr lang="en-US" sz="1100" b="1" dirty="0">
                <a:latin typeface="Palatino Linotype" panose="02040502050505030304" pitchFamily="18" charset="0"/>
              </a:rPr>
              <a:t> Spice Extracts</a:t>
            </a:r>
            <a:endParaRPr lang="en-US" sz="1100" dirty="0">
              <a:latin typeface="Palatino Linotype" panose="02040502050505030304" pitchFamily="18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FACC9C88-998B-B639-6E92-C6E5886A3B2C}"/>
              </a:ext>
            </a:extLst>
          </p:cNvPr>
          <p:cNvSpPr txBox="1"/>
          <p:nvPr/>
        </p:nvSpPr>
        <p:spPr>
          <a:xfrm>
            <a:off x="3064042" y="5096295"/>
            <a:ext cx="6581267" cy="43088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dirty="0">
                <a:latin typeface="Palatino Linotype" panose="02040502050505030304" pitchFamily="18" charset="0"/>
              </a:rPr>
              <a:t>Table S22.: MTT Data T47-D Proliferation Inhibitory Concentration 50% (IC50) µg/mL: </a:t>
            </a:r>
          </a:p>
          <a:p>
            <a:r>
              <a:rPr lang="en-US" sz="1100" b="1" dirty="0">
                <a:latin typeface="Palatino Linotype" panose="02040502050505030304" pitchFamily="18" charset="0"/>
              </a:rPr>
              <a:t>AH-Extract Exosome Formulations </a:t>
            </a:r>
            <a:endParaRPr lang="en-US" sz="1100" dirty="0">
              <a:latin typeface="Palatino Linotype" panose="02040502050505030304" pitchFamily="18" charset="0"/>
            </a:endParaRPr>
          </a:p>
        </p:txBody>
      </p:sp>
      <p:graphicFrame>
        <p:nvGraphicFramePr>
          <p:cNvPr id="16" name="Table 15">
            <a:extLst>
              <a:ext uri="{FF2B5EF4-FFF2-40B4-BE49-F238E27FC236}">
                <a16:creationId xmlns:a16="http://schemas.microsoft.com/office/drawing/2014/main" id="{11FC2F16-18DB-DEDB-13A6-34648BBBB1C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99524586"/>
              </p:ext>
            </p:extLst>
          </p:nvPr>
        </p:nvGraphicFramePr>
        <p:xfrm>
          <a:off x="6843563" y="3094692"/>
          <a:ext cx="3522846" cy="1907540"/>
        </p:xfrm>
        <a:graphic>
          <a:graphicData uri="http://schemas.openxmlformats.org/drawingml/2006/table">
            <a:tbl>
              <a:tblPr firstRow="1" firstCol="1" bandRow="1"/>
              <a:tblGrid>
                <a:gridCol w="693019">
                  <a:extLst>
                    <a:ext uri="{9D8B030D-6E8A-4147-A177-3AD203B41FA5}">
                      <a16:colId xmlns:a16="http://schemas.microsoft.com/office/drawing/2014/main" val="2373431523"/>
                    </a:ext>
                  </a:extLst>
                </a:gridCol>
                <a:gridCol w="558265">
                  <a:extLst>
                    <a:ext uri="{9D8B030D-6E8A-4147-A177-3AD203B41FA5}">
                      <a16:colId xmlns:a16="http://schemas.microsoft.com/office/drawing/2014/main" val="2125494091"/>
                    </a:ext>
                  </a:extLst>
                </a:gridCol>
                <a:gridCol w="442762">
                  <a:extLst>
                    <a:ext uri="{9D8B030D-6E8A-4147-A177-3AD203B41FA5}">
                      <a16:colId xmlns:a16="http://schemas.microsoft.com/office/drawing/2014/main" val="1562495568"/>
                    </a:ext>
                  </a:extLst>
                </a:gridCol>
                <a:gridCol w="433137">
                  <a:extLst>
                    <a:ext uri="{9D8B030D-6E8A-4147-A177-3AD203B41FA5}">
                      <a16:colId xmlns:a16="http://schemas.microsoft.com/office/drawing/2014/main" val="2028328808"/>
                    </a:ext>
                  </a:extLst>
                </a:gridCol>
                <a:gridCol w="519764">
                  <a:extLst>
                    <a:ext uri="{9D8B030D-6E8A-4147-A177-3AD203B41FA5}">
                      <a16:colId xmlns:a16="http://schemas.microsoft.com/office/drawing/2014/main" val="2168701468"/>
                    </a:ext>
                  </a:extLst>
                </a:gridCol>
                <a:gridCol w="460207">
                  <a:extLst>
                    <a:ext uri="{9D8B030D-6E8A-4147-A177-3AD203B41FA5}">
                      <a16:colId xmlns:a16="http://schemas.microsoft.com/office/drawing/2014/main" val="1297218065"/>
                    </a:ext>
                  </a:extLst>
                </a:gridCol>
                <a:gridCol w="415692">
                  <a:extLst>
                    <a:ext uri="{9D8B030D-6E8A-4147-A177-3AD203B41FA5}">
                      <a16:colId xmlns:a16="http://schemas.microsoft.com/office/drawing/2014/main" val="1744866613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1" u="none" strike="noStrike" dirty="0">
                          <a:effectLst/>
                          <a:latin typeface="Palatino Linotype" panose="02040502050505030304" pitchFamily="18" charset="0"/>
                        </a:rPr>
                        <a:t>Apiaceae</a:t>
                      </a:r>
                      <a:r>
                        <a:rPr lang="en-US" sz="11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 Spic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  <a:latin typeface="Palatino Linotype" panose="02040502050505030304" pitchFamily="18" charset="0"/>
                        </a:rPr>
                        <a:t>Processed Extracts</a:t>
                      </a:r>
                      <a:endParaRPr lang="en-US" sz="1100" b="1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  <a:latin typeface="Palatino Linotype" panose="02040502050505030304" pitchFamily="18" charset="0"/>
                        </a:rPr>
                        <a:t>AH-Extracts</a:t>
                      </a:r>
                      <a:endParaRPr lang="en-US" sz="1100" b="1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6884919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endParaRPr lang="en-US" sz="1100" b="1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Rep 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Rep 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Rep 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Rep 1 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Rep 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Rep 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61354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Anise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220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267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190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52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48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49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3302986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Ajwain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80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74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67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123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129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54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4715125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Cumin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37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38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46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65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67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65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89016493"/>
                  </a:ext>
                </a:extLst>
              </a:tr>
              <a:tr h="536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Coriander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117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159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207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135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154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198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064474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Caraway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285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302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324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142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120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170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2154901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Celery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160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141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148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107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112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128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2735120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Dill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380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313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262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148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141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111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2648051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Fennel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36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848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err="1">
                          <a:effectLst/>
                          <a:latin typeface="Palatino Linotype" panose="02040502050505030304" pitchFamily="18" charset="0"/>
                        </a:rPr>
                        <a:t>nd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130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80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180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33680005"/>
                  </a:ext>
                </a:extLst>
              </a:tr>
            </a:tbl>
          </a:graphicData>
        </a:graphic>
      </p:graphicFrame>
      <p:graphicFrame>
        <p:nvGraphicFramePr>
          <p:cNvPr id="17" name="Table 16">
            <a:extLst>
              <a:ext uri="{FF2B5EF4-FFF2-40B4-BE49-F238E27FC236}">
                <a16:creationId xmlns:a16="http://schemas.microsoft.com/office/drawing/2014/main" id="{055B6BF1-4380-DEF5-FF13-E4340E186CE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0897507"/>
              </p:ext>
            </p:extLst>
          </p:nvPr>
        </p:nvGraphicFramePr>
        <p:xfrm>
          <a:off x="3156278" y="5525115"/>
          <a:ext cx="6489031" cy="1049900"/>
        </p:xfrm>
        <a:graphic>
          <a:graphicData uri="http://schemas.openxmlformats.org/drawingml/2006/table">
            <a:tbl>
              <a:tblPr firstRow="1" firstCol="1" bandRow="1"/>
              <a:tblGrid>
                <a:gridCol w="676240">
                  <a:extLst>
                    <a:ext uri="{9D8B030D-6E8A-4147-A177-3AD203B41FA5}">
                      <a16:colId xmlns:a16="http://schemas.microsoft.com/office/drawing/2014/main" val="2373431523"/>
                    </a:ext>
                  </a:extLst>
                </a:gridCol>
                <a:gridCol w="469611">
                  <a:extLst>
                    <a:ext uri="{9D8B030D-6E8A-4147-A177-3AD203B41FA5}">
                      <a16:colId xmlns:a16="http://schemas.microsoft.com/office/drawing/2014/main" val="2483365243"/>
                    </a:ext>
                  </a:extLst>
                </a:gridCol>
                <a:gridCol w="511298">
                  <a:extLst>
                    <a:ext uri="{9D8B030D-6E8A-4147-A177-3AD203B41FA5}">
                      <a16:colId xmlns:a16="http://schemas.microsoft.com/office/drawing/2014/main" val="391852967"/>
                    </a:ext>
                  </a:extLst>
                </a:gridCol>
                <a:gridCol w="394636">
                  <a:extLst>
                    <a:ext uri="{9D8B030D-6E8A-4147-A177-3AD203B41FA5}">
                      <a16:colId xmlns:a16="http://schemas.microsoft.com/office/drawing/2014/main" val="4266730921"/>
                    </a:ext>
                  </a:extLst>
                </a:gridCol>
                <a:gridCol w="481263">
                  <a:extLst>
                    <a:ext uri="{9D8B030D-6E8A-4147-A177-3AD203B41FA5}">
                      <a16:colId xmlns:a16="http://schemas.microsoft.com/office/drawing/2014/main" val="2125494091"/>
                    </a:ext>
                  </a:extLst>
                </a:gridCol>
                <a:gridCol w="625642">
                  <a:extLst>
                    <a:ext uri="{9D8B030D-6E8A-4147-A177-3AD203B41FA5}">
                      <a16:colId xmlns:a16="http://schemas.microsoft.com/office/drawing/2014/main" val="1562495568"/>
                    </a:ext>
                  </a:extLst>
                </a:gridCol>
                <a:gridCol w="385010">
                  <a:extLst>
                    <a:ext uri="{9D8B030D-6E8A-4147-A177-3AD203B41FA5}">
                      <a16:colId xmlns:a16="http://schemas.microsoft.com/office/drawing/2014/main" val="2028328808"/>
                    </a:ext>
                  </a:extLst>
                </a:gridCol>
                <a:gridCol w="500514">
                  <a:extLst>
                    <a:ext uri="{9D8B030D-6E8A-4147-A177-3AD203B41FA5}">
                      <a16:colId xmlns:a16="http://schemas.microsoft.com/office/drawing/2014/main" val="2168701468"/>
                    </a:ext>
                  </a:extLst>
                </a:gridCol>
                <a:gridCol w="433137">
                  <a:extLst>
                    <a:ext uri="{9D8B030D-6E8A-4147-A177-3AD203B41FA5}">
                      <a16:colId xmlns:a16="http://schemas.microsoft.com/office/drawing/2014/main" val="1297218065"/>
                    </a:ext>
                  </a:extLst>
                </a:gridCol>
                <a:gridCol w="511089">
                  <a:extLst>
                    <a:ext uri="{9D8B030D-6E8A-4147-A177-3AD203B41FA5}">
                      <a16:colId xmlns:a16="http://schemas.microsoft.com/office/drawing/2014/main" val="1744866613"/>
                    </a:ext>
                  </a:extLst>
                </a:gridCol>
                <a:gridCol w="461062">
                  <a:extLst>
                    <a:ext uri="{9D8B030D-6E8A-4147-A177-3AD203B41FA5}">
                      <a16:colId xmlns:a16="http://schemas.microsoft.com/office/drawing/2014/main" val="1610072248"/>
                    </a:ext>
                  </a:extLst>
                </a:gridCol>
                <a:gridCol w="462013">
                  <a:extLst>
                    <a:ext uri="{9D8B030D-6E8A-4147-A177-3AD203B41FA5}">
                      <a16:colId xmlns:a16="http://schemas.microsoft.com/office/drawing/2014/main" val="3469488304"/>
                    </a:ext>
                  </a:extLst>
                </a:gridCol>
                <a:gridCol w="577516">
                  <a:extLst>
                    <a:ext uri="{9D8B030D-6E8A-4147-A177-3AD203B41FA5}">
                      <a16:colId xmlns:a16="http://schemas.microsoft.com/office/drawing/2014/main" val="1381689013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1" u="none" strike="noStrike" dirty="0">
                          <a:effectLst/>
                          <a:latin typeface="Palatino Linotype" panose="02040502050505030304" pitchFamily="18" charset="0"/>
                        </a:rPr>
                        <a:t>Apiaceae</a:t>
                      </a:r>
                      <a:r>
                        <a:rPr lang="en-US" sz="11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 Spic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  <a:latin typeface="Palatino Linotype" panose="02040502050505030304" pitchFamily="18" charset="0"/>
                        </a:rPr>
                        <a:t>Processed Extracts</a:t>
                      </a:r>
                      <a:endParaRPr lang="en-US" sz="1100" b="1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  <a:latin typeface="Palatino Linotype" panose="02040502050505030304" pitchFamily="18" charset="0"/>
                        </a:rPr>
                        <a:t>AH-Extracts</a:t>
                      </a:r>
                      <a:endParaRPr lang="en-US" sz="1100" b="1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  <a:latin typeface="Palatino Linotype" panose="02040502050505030304" pitchFamily="18" charset="0"/>
                        </a:rPr>
                        <a:t>Processed Extract Formulations</a:t>
                      </a:r>
                      <a:endParaRPr lang="en-US" sz="1100" b="1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  <a:latin typeface="Palatino Linotype" panose="02040502050505030304" pitchFamily="18" charset="0"/>
                        </a:rPr>
                        <a:t>AH-Extract Formulations</a:t>
                      </a:r>
                      <a:endParaRPr lang="en-US" sz="1100" b="1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6884919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494" marR="4494" marT="449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Rep 1</a:t>
                      </a:r>
                    </a:p>
                  </a:txBody>
                  <a:tcPr marL="4494" marR="4494" marT="449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Rep 2</a:t>
                      </a:r>
                    </a:p>
                  </a:txBody>
                  <a:tcPr marL="4494" marR="4494" marT="449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Rep 3</a:t>
                      </a:r>
                    </a:p>
                  </a:txBody>
                  <a:tcPr marL="4494" marR="4494" marT="449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Rep 1</a:t>
                      </a:r>
                    </a:p>
                  </a:txBody>
                  <a:tcPr marL="4494" marR="4494" marT="449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Rep 2</a:t>
                      </a:r>
                    </a:p>
                  </a:txBody>
                  <a:tcPr marL="4494" marR="4494" marT="449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Rep 3</a:t>
                      </a:r>
                    </a:p>
                  </a:txBody>
                  <a:tcPr marL="4494" marR="4494" marT="449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Rep 1</a:t>
                      </a:r>
                    </a:p>
                  </a:txBody>
                  <a:tcPr marL="4494" marR="4494" marT="449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Rep 2</a:t>
                      </a:r>
                    </a:p>
                  </a:txBody>
                  <a:tcPr marL="4494" marR="4494" marT="449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Rep 3</a:t>
                      </a:r>
                    </a:p>
                  </a:txBody>
                  <a:tcPr marL="4494" marR="4494" marT="449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Rep 1</a:t>
                      </a:r>
                    </a:p>
                  </a:txBody>
                  <a:tcPr marL="4494" marR="4494" marT="449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Rep 2</a:t>
                      </a:r>
                    </a:p>
                  </a:txBody>
                  <a:tcPr marL="4494" marR="4494" marT="449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Rep 3</a:t>
                      </a:r>
                    </a:p>
                  </a:txBody>
                  <a:tcPr marL="4494" marR="4494" marT="449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61354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effectLst/>
                          <a:latin typeface="Palatino Linotype" panose="02040502050505030304" pitchFamily="18" charset="0"/>
                        </a:rPr>
                        <a:t>Celery</a:t>
                      </a:r>
                      <a:endParaRPr lang="en-US" sz="9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494" marR="4494" marT="449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effectLst/>
                          <a:latin typeface="Palatino Linotype" panose="02040502050505030304" pitchFamily="18" charset="0"/>
                        </a:rPr>
                        <a:t>26</a:t>
                      </a:r>
                      <a:endParaRPr lang="en-US" sz="9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494" marR="4494" marT="449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effectLst/>
                          <a:latin typeface="Palatino Linotype" panose="02040502050505030304" pitchFamily="18" charset="0"/>
                        </a:rPr>
                        <a:t>21.5</a:t>
                      </a:r>
                      <a:endParaRPr lang="en-US" sz="9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494" marR="4494" marT="449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effectLst/>
                          <a:latin typeface="Palatino Linotype" panose="02040502050505030304" pitchFamily="18" charset="0"/>
                        </a:rPr>
                        <a:t>22</a:t>
                      </a:r>
                      <a:endParaRPr lang="en-US" sz="9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494" marR="4494" marT="449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effectLst/>
                          <a:latin typeface="Palatino Linotype" panose="02040502050505030304" pitchFamily="18" charset="0"/>
                        </a:rPr>
                        <a:t>11.5</a:t>
                      </a:r>
                      <a:endParaRPr lang="en-US" sz="9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494" marR="4494" marT="449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effectLst/>
                          <a:latin typeface="Palatino Linotype" panose="02040502050505030304" pitchFamily="18" charset="0"/>
                        </a:rPr>
                        <a:t>9.5</a:t>
                      </a:r>
                      <a:endParaRPr lang="en-US" sz="9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494" marR="4494" marT="449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effectLst/>
                          <a:latin typeface="Palatino Linotype" panose="02040502050505030304" pitchFamily="18" charset="0"/>
                        </a:rPr>
                        <a:t>9.5</a:t>
                      </a:r>
                      <a:endParaRPr lang="en-US" sz="9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494" marR="4494" marT="449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effectLst/>
                          <a:latin typeface="Palatino Linotype" panose="02040502050505030304" pitchFamily="18" charset="0"/>
                        </a:rPr>
                        <a:t>12</a:t>
                      </a:r>
                      <a:endParaRPr lang="en-US" sz="9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494" marR="4494" marT="449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effectLst/>
                          <a:latin typeface="Palatino Linotype" panose="02040502050505030304" pitchFamily="18" charset="0"/>
                        </a:rPr>
                        <a:t>16</a:t>
                      </a:r>
                      <a:endParaRPr lang="en-US" sz="9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494" marR="4494" marT="449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effectLst/>
                          <a:latin typeface="Palatino Linotype" panose="02040502050505030304" pitchFamily="18" charset="0"/>
                        </a:rPr>
                        <a:t>13.5</a:t>
                      </a:r>
                      <a:endParaRPr lang="en-US" sz="9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494" marR="4494" marT="449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effectLst/>
                          <a:latin typeface="Palatino Linotype" panose="02040502050505030304" pitchFamily="18" charset="0"/>
                        </a:rPr>
                        <a:t>5.5</a:t>
                      </a:r>
                      <a:endParaRPr lang="en-US" sz="9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494" marR="4494" marT="449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effectLst/>
                          <a:latin typeface="Palatino Linotype" panose="02040502050505030304" pitchFamily="18" charset="0"/>
                        </a:rPr>
                        <a:t>7</a:t>
                      </a:r>
                      <a:endParaRPr lang="en-US" sz="9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494" marR="4494" marT="449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effectLst/>
                          <a:latin typeface="Palatino Linotype" panose="02040502050505030304" pitchFamily="18" charset="0"/>
                        </a:rPr>
                        <a:t>6</a:t>
                      </a:r>
                      <a:endParaRPr lang="en-US" sz="9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494" marR="4494" marT="449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3302986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effectLst/>
                          <a:latin typeface="Palatino Linotype" panose="02040502050505030304" pitchFamily="18" charset="0"/>
                        </a:rPr>
                        <a:t>Anise</a:t>
                      </a:r>
                      <a:endParaRPr lang="en-US" sz="9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494" marR="4494" marT="44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effectLst/>
                          <a:latin typeface="Palatino Linotype" panose="02040502050505030304" pitchFamily="18" charset="0"/>
                        </a:rPr>
                        <a:t>68</a:t>
                      </a:r>
                      <a:endParaRPr lang="en-US" sz="9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494" marR="4494" marT="44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effectLst/>
                          <a:latin typeface="Palatino Linotype" panose="02040502050505030304" pitchFamily="18" charset="0"/>
                        </a:rPr>
                        <a:t>79.5</a:t>
                      </a:r>
                      <a:endParaRPr lang="en-US" sz="9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494" marR="4494" marT="44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effectLst/>
                          <a:latin typeface="Palatino Linotype" panose="02040502050505030304" pitchFamily="18" charset="0"/>
                        </a:rPr>
                        <a:t>73</a:t>
                      </a:r>
                      <a:endParaRPr lang="en-US" sz="9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494" marR="4494" marT="44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effectLst/>
                          <a:latin typeface="Palatino Linotype" panose="02040502050505030304" pitchFamily="18" charset="0"/>
                        </a:rPr>
                        <a:t>144</a:t>
                      </a:r>
                      <a:endParaRPr lang="en-US" sz="9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494" marR="4494" marT="44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effectLst/>
                          <a:latin typeface="Palatino Linotype" panose="02040502050505030304" pitchFamily="18" charset="0"/>
                        </a:rPr>
                        <a:t>104</a:t>
                      </a:r>
                      <a:endParaRPr lang="en-US" sz="9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494" marR="4494" marT="44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effectLst/>
                          <a:latin typeface="Palatino Linotype" panose="02040502050505030304" pitchFamily="18" charset="0"/>
                        </a:rPr>
                        <a:t>126</a:t>
                      </a:r>
                      <a:endParaRPr lang="en-US" sz="9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494" marR="4494" marT="44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effectLst/>
                          <a:latin typeface="Palatino Linotype" panose="02040502050505030304" pitchFamily="18" charset="0"/>
                        </a:rPr>
                        <a:t>47.5</a:t>
                      </a:r>
                      <a:endParaRPr lang="en-US" sz="9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494" marR="4494" marT="44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effectLst/>
                          <a:latin typeface="Palatino Linotype" panose="02040502050505030304" pitchFamily="18" charset="0"/>
                        </a:rPr>
                        <a:t>33</a:t>
                      </a:r>
                      <a:endParaRPr lang="en-US" sz="9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494" marR="4494" marT="44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effectLst/>
                          <a:latin typeface="Palatino Linotype" panose="02040502050505030304" pitchFamily="18" charset="0"/>
                        </a:rPr>
                        <a:t>27</a:t>
                      </a:r>
                      <a:endParaRPr lang="en-US" sz="9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494" marR="4494" marT="44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effectLst/>
                          <a:latin typeface="Palatino Linotype" panose="02040502050505030304" pitchFamily="18" charset="0"/>
                        </a:rPr>
                        <a:t>63.5</a:t>
                      </a:r>
                      <a:endParaRPr lang="en-US" sz="9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494" marR="4494" marT="44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effectLst/>
                          <a:latin typeface="Palatino Linotype" panose="02040502050505030304" pitchFamily="18" charset="0"/>
                        </a:rPr>
                        <a:t>52.5</a:t>
                      </a:r>
                      <a:endParaRPr lang="en-US" sz="9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494" marR="4494" marT="44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effectLst/>
                          <a:latin typeface="Palatino Linotype" panose="02040502050505030304" pitchFamily="18" charset="0"/>
                        </a:rPr>
                        <a:t>56</a:t>
                      </a:r>
                      <a:endParaRPr lang="en-US" sz="9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494" marR="4494" marT="44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4715125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effectLst/>
                          <a:latin typeface="Palatino Linotype" panose="02040502050505030304" pitchFamily="18" charset="0"/>
                        </a:rPr>
                        <a:t>Cumin</a:t>
                      </a:r>
                      <a:endParaRPr lang="en-US" sz="9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494" marR="4494" marT="44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effectLst/>
                          <a:latin typeface="Palatino Linotype" panose="02040502050505030304" pitchFamily="18" charset="0"/>
                        </a:rPr>
                        <a:t>184</a:t>
                      </a:r>
                      <a:endParaRPr lang="en-US" sz="9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494" marR="4494" marT="44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effectLst/>
                          <a:latin typeface="Palatino Linotype" panose="02040502050505030304" pitchFamily="18" charset="0"/>
                        </a:rPr>
                        <a:t>186</a:t>
                      </a:r>
                      <a:endParaRPr lang="en-US" sz="9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494" marR="4494" marT="44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effectLst/>
                          <a:latin typeface="Palatino Linotype" panose="02040502050505030304" pitchFamily="18" charset="0"/>
                        </a:rPr>
                        <a:t>190</a:t>
                      </a:r>
                      <a:endParaRPr lang="en-US" sz="9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494" marR="4494" marT="44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effectLst/>
                          <a:latin typeface="Palatino Linotype" panose="02040502050505030304" pitchFamily="18" charset="0"/>
                        </a:rPr>
                        <a:t>31.5</a:t>
                      </a:r>
                      <a:endParaRPr lang="en-US" sz="9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494" marR="4494" marT="44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effectLst/>
                          <a:latin typeface="Palatino Linotype" panose="02040502050505030304" pitchFamily="18" charset="0"/>
                        </a:rPr>
                        <a:t>52</a:t>
                      </a:r>
                      <a:endParaRPr lang="en-US" sz="9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494" marR="4494" marT="44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effectLst/>
                          <a:latin typeface="Palatino Linotype" panose="02040502050505030304" pitchFamily="18" charset="0"/>
                        </a:rPr>
                        <a:t>49</a:t>
                      </a:r>
                      <a:endParaRPr lang="en-US" sz="9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494" marR="4494" marT="44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effectLst/>
                          <a:latin typeface="Palatino Linotype" panose="02040502050505030304" pitchFamily="18" charset="0"/>
                        </a:rPr>
                        <a:t>31</a:t>
                      </a:r>
                      <a:endParaRPr lang="en-US" sz="9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494" marR="4494" marT="44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effectLst/>
                          <a:latin typeface="Palatino Linotype" panose="02040502050505030304" pitchFamily="18" charset="0"/>
                        </a:rPr>
                        <a:t>24</a:t>
                      </a:r>
                      <a:endParaRPr lang="en-US" sz="9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494" marR="4494" marT="44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effectLst/>
                          <a:latin typeface="Palatino Linotype" panose="02040502050505030304" pitchFamily="18" charset="0"/>
                        </a:rPr>
                        <a:t>38</a:t>
                      </a:r>
                      <a:endParaRPr lang="en-US" sz="9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494" marR="4494" marT="44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effectLst/>
                          <a:latin typeface="Palatino Linotype" panose="02040502050505030304" pitchFamily="18" charset="0"/>
                        </a:rPr>
                        <a:t>38</a:t>
                      </a:r>
                      <a:endParaRPr lang="en-US" sz="9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494" marR="4494" marT="44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effectLst/>
                          <a:latin typeface="Palatino Linotype" panose="02040502050505030304" pitchFamily="18" charset="0"/>
                        </a:rPr>
                        <a:t>45</a:t>
                      </a:r>
                      <a:endParaRPr lang="en-US" sz="9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494" marR="4494" marT="44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effectLst/>
                          <a:latin typeface="Palatino Linotype" panose="02040502050505030304" pitchFamily="18" charset="0"/>
                        </a:rPr>
                        <a:t>46</a:t>
                      </a:r>
                      <a:endParaRPr lang="en-US" sz="9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494" marR="4494" marT="44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89016493"/>
                  </a:ext>
                </a:extLst>
              </a:tr>
              <a:tr h="536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effectLst/>
                          <a:latin typeface="Palatino Linotype" panose="02040502050505030304" pitchFamily="18" charset="0"/>
                        </a:rPr>
                        <a:t>Ajwain</a:t>
                      </a:r>
                      <a:endParaRPr lang="en-US" sz="9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494" marR="4494" marT="44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effectLst/>
                          <a:latin typeface="Palatino Linotype" panose="02040502050505030304" pitchFamily="18" charset="0"/>
                        </a:rPr>
                        <a:t>108</a:t>
                      </a:r>
                      <a:endParaRPr lang="en-US" sz="9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494" marR="4494" marT="44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effectLst/>
                          <a:latin typeface="Palatino Linotype" panose="02040502050505030304" pitchFamily="18" charset="0"/>
                        </a:rPr>
                        <a:t>118</a:t>
                      </a:r>
                      <a:endParaRPr lang="en-US" sz="9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494" marR="4494" marT="44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effectLst/>
                          <a:latin typeface="Palatino Linotype" panose="02040502050505030304" pitchFamily="18" charset="0"/>
                        </a:rPr>
                        <a:t>115</a:t>
                      </a:r>
                      <a:endParaRPr lang="en-US" sz="9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494" marR="4494" marT="44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effectLst/>
                          <a:latin typeface="Palatino Linotype" panose="02040502050505030304" pitchFamily="18" charset="0"/>
                        </a:rPr>
                        <a:t>91</a:t>
                      </a:r>
                      <a:endParaRPr lang="en-US" sz="9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494" marR="4494" marT="44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effectLst/>
                          <a:latin typeface="Palatino Linotype" panose="02040502050505030304" pitchFamily="18" charset="0"/>
                        </a:rPr>
                        <a:t>125</a:t>
                      </a:r>
                      <a:endParaRPr lang="en-US" sz="9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494" marR="4494" marT="44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effectLst/>
                          <a:latin typeface="Palatino Linotype" panose="02040502050505030304" pitchFamily="18" charset="0"/>
                        </a:rPr>
                        <a:t>113</a:t>
                      </a:r>
                      <a:endParaRPr lang="en-US" sz="9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494" marR="4494" marT="44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effectLst/>
                          <a:latin typeface="Palatino Linotype" panose="02040502050505030304" pitchFamily="18" charset="0"/>
                        </a:rPr>
                        <a:t>16</a:t>
                      </a:r>
                      <a:endParaRPr lang="en-US" sz="9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494" marR="4494" marT="44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effectLst/>
                          <a:latin typeface="Palatino Linotype" panose="02040502050505030304" pitchFamily="18" charset="0"/>
                        </a:rPr>
                        <a:t>14</a:t>
                      </a:r>
                      <a:endParaRPr lang="en-US" sz="9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494" marR="4494" marT="44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effectLst/>
                          <a:latin typeface="Palatino Linotype" panose="02040502050505030304" pitchFamily="18" charset="0"/>
                        </a:rPr>
                        <a:t>16</a:t>
                      </a:r>
                      <a:endParaRPr lang="en-US" sz="9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494" marR="4494" marT="44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effectLst/>
                          <a:latin typeface="Palatino Linotype" panose="02040502050505030304" pitchFamily="18" charset="0"/>
                        </a:rPr>
                        <a:t>69</a:t>
                      </a:r>
                      <a:endParaRPr lang="en-US" sz="9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494" marR="4494" marT="44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effectLst/>
                          <a:latin typeface="Palatino Linotype" panose="02040502050505030304" pitchFamily="18" charset="0"/>
                        </a:rPr>
                        <a:t>67</a:t>
                      </a:r>
                      <a:endParaRPr lang="en-US" sz="9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494" marR="4494" marT="44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effectLst/>
                          <a:latin typeface="Palatino Linotype" panose="02040502050505030304" pitchFamily="18" charset="0"/>
                        </a:rPr>
                        <a:t>78</a:t>
                      </a:r>
                      <a:endParaRPr lang="en-US" sz="9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494" marR="4494" marT="44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06447401"/>
                  </a:ext>
                </a:extLst>
              </a:tr>
            </a:tbl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B7FA674E-9077-1E27-7F0E-805ADAE14DB3}"/>
              </a:ext>
            </a:extLst>
          </p:cNvPr>
          <p:cNvSpPr txBox="1"/>
          <p:nvPr/>
        </p:nvSpPr>
        <p:spPr>
          <a:xfrm>
            <a:off x="838377" y="2529046"/>
            <a:ext cx="4949615" cy="43088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dirty="0">
                <a:latin typeface="Palatino Linotype" panose="02040502050505030304" pitchFamily="18" charset="0"/>
              </a:rPr>
              <a:t>Table S20.: MTT Data Proliferation Inhibitory Concentration 50% (IC50) µg/mL: Initial </a:t>
            </a:r>
            <a:r>
              <a:rPr lang="en-US" sz="1100" b="1" i="1" dirty="0">
                <a:latin typeface="Palatino Linotype" panose="02040502050505030304" pitchFamily="18" charset="0"/>
              </a:rPr>
              <a:t>Apiaceae</a:t>
            </a:r>
            <a:r>
              <a:rPr lang="en-US" sz="1100" b="1" dirty="0">
                <a:latin typeface="Palatino Linotype" panose="02040502050505030304" pitchFamily="18" charset="0"/>
              </a:rPr>
              <a:t> Spice Extracts</a:t>
            </a:r>
            <a:endParaRPr lang="en-US" sz="1100" dirty="0">
              <a:latin typeface="Palatino Linotype" panose="02040502050505030304" pitchFamily="18" charset="0"/>
            </a:endParaRPr>
          </a:p>
        </p:txBody>
      </p:sp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99933C60-CBFF-87AA-ABE3-2F44F3D6C0D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27474593"/>
              </p:ext>
            </p:extLst>
          </p:nvPr>
        </p:nvGraphicFramePr>
        <p:xfrm>
          <a:off x="930613" y="3001986"/>
          <a:ext cx="4831882" cy="1907540"/>
        </p:xfrm>
        <a:graphic>
          <a:graphicData uri="http://schemas.openxmlformats.org/drawingml/2006/table">
            <a:tbl>
              <a:tblPr firstRow="1" firstCol="1" bandRow="1"/>
              <a:tblGrid>
                <a:gridCol w="693019">
                  <a:extLst>
                    <a:ext uri="{9D8B030D-6E8A-4147-A177-3AD203B41FA5}">
                      <a16:colId xmlns:a16="http://schemas.microsoft.com/office/drawing/2014/main" val="2373431523"/>
                    </a:ext>
                  </a:extLst>
                </a:gridCol>
                <a:gridCol w="481263">
                  <a:extLst>
                    <a:ext uri="{9D8B030D-6E8A-4147-A177-3AD203B41FA5}">
                      <a16:colId xmlns:a16="http://schemas.microsoft.com/office/drawing/2014/main" val="2483365243"/>
                    </a:ext>
                  </a:extLst>
                </a:gridCol>
                <a:gridCol w="452388">
                  <a:extLst>
                    <a:ext uri="{9D8B030D-6E8A-4147-A177-3AD203B41FA5}">
                      <a16:colId xmlns:a16="http://schemas.microsoft.com/office/drawing/2014/main" val="391852967"/>
                    </a:ext>
                  </a:extLst>
                </a:gridCol>
                <a:gridCol w="375385">
                  <a:extLst>
                    <a:ext uri="{9D8B030D-6E8A-4147-A177-3AD203B41FA5}">
                      <a16:colId xmlns:a16="http://schemas.microsoft.com/office/drawing/2014/main" val="4266730921"/>
                    </a:ext>
                  </a:extLst>
                </a:gridCol>
                <a:gridCol w="558265">
                  <a:extLst>
                    <a:ext uri="{9D8B030D-6E8A-4147-A177-3AD203B41FA5}">
                      <a16:colId xmlns:a16="http://schemas.microsoft.com/office/drawing/2014/main" val="2125494091"/>
                    </a:ext>
                  </a:extLst>
                </a:gridCol>
                <a:gridCol w="442762">
                  <a:extLst>
                    <a:ext uri="{9D8B030D-6E8A-4147-A177-3AD203B41FA5}">
                      <a16:colId xmlns:a16="http://schemas.microsoft.com/office/drawing/2014/main" val="1562495568"/>
                    </a:ext>
                  </a:extLst>
                </a:gridCol>
                <a:gridCol w="433137">
                  <a:extLst>
                    <a:ext uri="{9D8B030D-6E8A-4147-A177-3AD203B41FA5}">
                      <a16:colId xmlns:a16="http://schemas.microsoft.com/office/drawing/2014/main" val="2028328808"/>
                    </a:ext>
                  </a:extLst>
                </a:gridCol>
                <a:gridCol w="519764">
                  <a:extLst>
                    <a:ext uri="{9D8B030D-6E8A-4147-A177-3AD203B41FA5}">
                      <a16:colId xmlns:a16="http://schemas.microsoft.com/office/drawing/2014/main" val="2168701468"/>
                    </a:ext>
                  </a:extLst>
                </a:gridCol>
                <a:gridCol w="460207">
                  <a:extLst>
                    <a:ext uri="{9D8B030D-6E8A-4147-A177-3AD203B41FA5}">
                      <a16:colId xmlns:a16="http://schemas.microsoft.com/office/drawing/2014/main" val="1297218065"/>
                    </a:ext>
                  </a:extLst>
                </a:gridCol>
                <a:gridCol w="415692">
                  <a:extLst>
                    <a:ext uri="{9D8B030D-6E8A-4147-A177-3AD203B41FA5}">
                      <a16:colId xmlns:a16="http://schemas.microsoft.com/office/drawing/2014/main" val="1744866613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1" u="none" strike="noStrike" dirty="0">
                          <a:effectLst/>
                          <a:latin typeface="Palatino Linotype" panose="02040502050505030304" pitchFamily="18" charset="0"/>
                        </a:rPr>
                        <a:t>Apiaceae</a:t>
                      </a:r>
                      <a:r>
                        <a:rPr lang="en-US" sz="11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 Spic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BT-47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  <a:latin typeface="Palatino Linotype" panose="02040502050505030304" pitchFamily="18" charset="0"/>
                        </a:rPr>
                        <a:t>MDA-MB-231</a:t>
                      </a:r>
                      <a:endParaRPr lang="en-US" sz="1100" b="1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T-47D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6884919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endParaRPr lang="en-US" sz="1100" b="1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Rep 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Rep 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Rep 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Rep 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Rep 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Rep 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Rep 1 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Rep 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Rep 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61354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Anise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12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118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107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177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158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15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17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15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16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3302986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Ajwain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107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9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9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14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16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16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90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80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9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4715125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Cumin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8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89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9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119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12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11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12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11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110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89016493"/>
                  </a:ext>
                </a:extLst>
              </a:tr>
              <a:tr h="536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Coriander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171.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180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19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14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15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128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15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159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17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064474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Caraway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250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25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21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730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750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830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290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310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330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2154901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Celery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23.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24.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22.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21.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2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2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4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4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4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2735120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Dill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200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210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19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21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207.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262.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197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25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267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2648051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Fennel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280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287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350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380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effectLst/>
                          <a:latin typeface="Palatino Linotype" panose="02040502050505030304" pitchFamily="18" charset="0"/>
                        </a:rPr>
                        <a:t>34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219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720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770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930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3368000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870120763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E1304B69-E1EC-0CF2-A265-B5DFDDAEDE2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60963766"/>
              </p:ext>
            </p:extLst>
          </p:nvPr>
        </p:nvGraphicFramePr>
        <p:xfrm>
          <a:off x="552815" y="567233"/>
          <a:ext cx="3712024" cy="1901190"/>
        </p:xfrm>
        <a:graphic>
          <a:graphicData uri="http://schemas.openxmlformats.org/drawingml/2006/table">
            <a:tbl>
              <a:tblPr firstRow="1" firstCol="1" bandRow="1"/>
              <a:tblGrid>
                <a:gridCol w="1039528">
                  <a:extLst>
                    <a:ext uri="{9D8B030D-6E8A-4147-A177-3AD203B41FA5}">
                      <a16:colId xmlns:a16="http://schemas.microsoft.com/office/drawing/2014/main" val="1390128220"/>
                    </a:ext>
                  </a:extLst>
                </a:gridCol>
                <a:gridCol w="1099389">
                  <a:extLst>
                    <a:ext uri="{9D8B030D-6E8A-4147-A177-3AD203B41FA5}">
                      <a16:colId xmlns:a16="http://schemas.microsoft.com/office/drawing/2014/main" val="982554927"/>
                    </a:ext>
                  </a:extLst>
                </a:gridCol>
                <a:gridCol w="762000">
                  <a:extLst>
                    <a:ext uri="{9D8B030D-6E8A-4147-A177-3AD203B41FA5}">
                      <a16:colId xmlns:a16="http://schemas.microsoft.com/office/drawing/2014/main" val="2940507884"/>
                    </a:ext>
                  </a:extLst>
                </a:gridCol>
                <a:gridCol w="811107">
                  <a:extLst>
                    <a:ext uri="{9D8B030D-6E8A-4147-A177-3AD203B41FA5}">
                      <a16:colId xmlns:a16="http://schemas.microsoft.com/office/drawing/2014/main" val="1992709120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1" u="none" strike="noStrike" dirty="0">
                          <a:effectLst/>
                          <a:latin typeface="Palatino Linotype" panose="02040502050505030304" pitchFamily="18" charset="0"/>
                        </a:rPr>
                        <a:t>Apiaceae</a:t>
                      </a:r>
                      <a:r>
                        <a:rPr lang="en-US" sz="11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 Spice Exosome Formulation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  <a:latin typeface="Palatino Linotype" panose="02040502050505030304" pitchFamily="18" charset="0"/>
                        </a:rPr>
                        <a:t>Processed Extract Loaded Exosomes</a:t>
                      </a:r>
                      <a:endParaRPr lang="en-US" sz="1100" b="1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  <a:latin typeface="Palatino Linotype" panose="02040502050505030304" pitchFamily="18" charset="0"/>
                        </a:rPr>
                        <a:t>AH Extract Loaded Exosomes</a:t>
                      </a:r>
                      <a:endParaRPr lang="en-US" sz="1100" b="1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  <a:latin typeface="Palatino Linotype" panose="02040502050505030304" pitchFamily="18" charset="0"/>
                        </a:rPr>
                        <a:t>Bovine Exosomes</a:t>
                      </a:r>
                      <a:endParaRPr lang="en-US" sz="1100" b="1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2977192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Ajwain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119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118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79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5906357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Anis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118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115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9894096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Caraway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120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112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5649057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Celery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125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122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3416259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Coriander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132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123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8007049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Cumin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122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107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3837033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Dill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125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120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5771316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Fennel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115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effectLst/>
                          <a:latin typeface="Palatino Linotype" panose="02040502050505030304" pitchFamily="18" charset="0"/>
                        </a:rPr>
                        <a:t>115</a:t>
                      </a:r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50640333"/>
                  </a:ext>
                </a:extLst>
              </a:tr>
            </a:tbl>
          </a:graphicData>
        </a:graphic>
      </p:graphicFrame>
      <p:graphicFrame>
        <p:nvGraphicFramePr>
          <p:cNvPr id="8" name="Table 7">
            <a:extLst>
              <a:ext uri="{FF2B5EF4-FFF2-40B4-BE49-F238E27FC236}">
                <a16:creationId xmlns:a16="http://schemas.microsoft.com/office/drawing/2014/main" id="{4F145E7B-186D-DAD3-D5A6-D868A1DE5D3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92198487"/>
              </p:ext>
            </p:extLst>
          </p:nvPr>
        </p:nvGraphicFramePr>
        <p:xfrm>
          <a:off x="404261" y="3328079"/>
          <a:ext cx="4348717" cy="1901190"/>
        </p:xfrm>
        <a:graphic>
          <a:graphicData uri="http://schemas.openxmlformats.org/drawingml/2006/table">
            <a:tbl>
              <a:tblPr firstRow="1" firstCol="1" bandRow="1"/>
              <a:tblGrid>
                <a:gridCol w="1039528">
                  <a:extLst>
                    <a:ext uri="{9D8B030D-6E8A-4147-A177-3AD203B41FA5}">
                      <a16:colId xmlns:a16="http://schemas.microsoft.com/office/drawing/2014/main" val="1390128220"/>
                    </a:ext>
                  </a:extLst>
                </a:gridCol>
                <a:gridCol w="1099389">
                  <a:extLst>
                    <a:ext uri="{9D8B030D-6E8A-4147-A177-3AD203B41FA5}">
                      <a16:colId xmlns:a16="http://schemas.microsoft.com/office/drawing/2014/main" val="982554927"/>
                    </a:ext>
                  </a:extLst>
                </a:gridCol>
                <a:gridCol w="762000">
                  <a:extLst>
                    <a:ext uri="{9D8B030D-6E8A-4147-A177-3AD203B41FA5}">
                      <a16:colId xmlns:a16="http://schemas.microsoft.com/office/drawing/2014/main" val="2940507884"/>
                    </a:ext>
                  </a:extLst>
                </a:gridCol>
                <a:gridCol w="636693">
                  <a:extLst>
                    <a:ext uri="{9D8B030D-6E8A-4147-A177-3AD203B41FA5}">
                      <a16:colId xmlns:a16="http://schemas.microsoft.com/office/drawing/2014/main" val="3787304384"/>
                    </a:ext>
                  </a:extLst>
                </a:gridCol>
                <a:gridCol w="811107">
                  <a:extLst>
                    <a:ext uri="{9D8B030D-6E8A-4147-A177-3AD203B41FA5}">
                      <a16:colId xmlns:a16="http://schemas.microsoft.com/office/drawing/2014/main" val="1992709120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1" u="none" strike="noStrike" dirty="0">
                          <a:effectLst/>
                          <a:latin typeface="Palatino Linotype" panose="02040502050505030304" pitchFamily="18" charset="0"/>
                        </a:rPr>
                        <a:t>Apiaceae</a:t>
                      </a:r>
                      <a:r>
                        <a:rPr lang="en-US" sz="11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 Spice Exosome Formulation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  <a:latin typeface="Palatino Linotype" panose="02040502050505030304" pitchFamily="18" charset="0"/>
                        </a:rPr>
                        <a:t>Processed Extract Loaded Exosomes</a:t>
                      </a:r>
                      <a:endParaRPr lang="en-US" sz="1100" b="1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  <a:latin typeface="Palatino Linotype" panose="02040502050505030304" pitchFamily="18" charset="0"/>
                        </a:rPr>
                        <a:t>AH Extract Loaded Exosomes</a:t>
                      </a:r>
                      <a:endParaRPr lang="en-US" sz="1100" b="1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1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  <a:latin typeface="Palatino Linotype" panose="02040502050505030304" pitchFamily="18" charset="0"/>
                        </a:rPr>
                        <a:t>Bovine Exosomes</a:t>
                      </a:r>
                      <a:endParaRPr lang="en-US" sz="1100" b="1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2977192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Ajwain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7.6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8.39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Rep 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6.87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5906357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Anis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6.9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6.9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Rep 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7.39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9894096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Caraway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7.08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7.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Rep 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7.2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5649057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Celery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6.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7.1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3416259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Coriander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7.0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8.19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8007049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Cumin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7.08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7.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3837033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Dill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8.3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7.4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5771316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Fennel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7.7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7.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50640333"/>
                  </a:ext>
                </a:extLst>
              </a:tr>
            </a:tbl>
          </a:graphicData>
        </a:graphic>
      </p:graphicFrame>
      <p:graphicFrame>
        <p:nvGraphicFramePr>
          <p:cNvPr id="9" name="Table 8">
            <a:extLst>
              <a:ext uri="{FF2B5EF4-FFF2-40B4-BE49-F238E27FC236}">
                <a16:creationId xmlns:a16="http://schemas.microsoft.com/office/drawing/2014/main" id="{7217D4DE-CE76-A1A4-3837-1CC3637C690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71473155"/>
              </p:ext>
            </p:extLst>
          </p:nvPr>
        </p:nvGraphicFramePr>
        <p:xfrm>
          <a:off x="6094230" y="567233"/>
          <a:ext cx="4348717" cy="1901190"/>
        </p:xfrm>
        <a:graphic>
          <a:graphicData uri="http://schemas.openxmlformats.org/drawingml/2006/table">
            <a:tbl>
              <a:tblPr firstRow="1" firstCol="1" bandRow="1"/>
              <a:tblGrid>
                <a:gridCol w="1039528">
                  <a:extLst>
                    <a:ext uri="{9D8B030D-6E8A-4147-A177-3AD203B41FA5}">
                      <a16:colId xmlns:a16="http://schemas.microsoft.com/office/drawing/2014/main" val="1390128220"/>
                    </a:ext>
                  </a:extLst>
                </a:gridCol>
                <a:gridCol w="1099389">
                  <a:extLst>
                    <a:ext uri="{9D8B030D-6E8A-4147-A177-3AD203B41FA5}">
                      <a16:colId xmlns:a16="http://schemas.microsoft.com/office/drawing/2014/main" val="982554927"/>
                    </a:ext>
                  </a:extLst>
                </a:gridCol>
                <a:gridCol w="762000">
                  <a:extLst>
                    <a:ext uri="{9D8B030D-6E8A-4147-A177-3AD203B41FA5}">
                      <a16:colId xmlns:a16="http://schemas.microsoft.com/office/drawing/2014/main" val="2940507884"/>
                    </a:ext>
                  </a:extLst>
                </a:gridCol>
                <a:gridCol w="636693">
                  <a:extLst>
                    <a:ext uri="{9D8B030D-6E8A-4147-A177-3AD203B41FA5}">
                      <a16:colId xmlns:a16="http://schemas.microsoft.com/office/drawing/2014/main" val="3787304384"/>
                    </a:ext>
                  </a:extLst>
                </a:gridCol>
                <a:gridCol w="811107">
                  <a:extLst>
                    <a:ext uri="{9D8B030D-6E8A-4147-A177-3AD203B41FA5}">
                      <a16:colId xmlns:a16="http://schemas.microsoft.com/office/drawing/2014/main" val="1992709120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1" u="none" strike="noStrike" dirty="0">
                          <a:effectLst/>
                          <a:latin typeface="Palatino Linotype" panose="02040502050505030304" pitchFamily="18" charset="0"/>
                        </a:rPr>
                        <a:t>Apiaceae</a:t>
                      </a:r>
                      <a:r>
                        <a:rPr lang="en-US" sz="11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 Spice Exosome Formulation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  <a:latin typeface="Palatino Linotype" panose="02040502050505030304" pitchFamily="18" charset="0"/>
                        </a:rPr>
                        <a:t>Processed Extract Loaded Exosomes</a:t>
                      </a:r>
                      <a:endParaRPr lang="en-US" sz="1100" b="1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  <a:latin typeface="Palatino Linotype" panose="02040502050505030304" pitchFamily="18" charset="0"/>
                        </a:rPr>
                        <a:t>AH Extract Loaded Exosomes</a:t>
                      </a:r>
                      <a:endParaRPr lang="en-US" sz="1100" b="1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1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  <a:latin typeface="Palatino Linotype" panose="02040502050505030304" pitchFamily="18" charset="0"/>
                        </a:rPr>
                        <a:t>Bovine Exosomes</a:t>
                      </a:r>
                      <a:endParaRPr lang="en-US" sz="1100" b="1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2977192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Ajwain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0.35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0.35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Rep 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0.28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5906357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Anis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0.29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0.29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Rep 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0.29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9894096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Caraway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0.30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0.31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Rep 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0.28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5649057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Celery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0.26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0.2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3416259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Coriander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0.28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0.289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8007049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Cumin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0.30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0.26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3837033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Dill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0.279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0.249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5771316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Fennel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0.33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0.32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50640333"/>
                  </a:ext>
                </a:extLst>
              </a:tr>
            </a:tbl>
          </a:graphicData>
        </a:graphic>
      </p:graphicFrame>
      <p:graphicFrame>
        <p:nvGraphicFramePr>
          <p:cNvPr id="10" name="Table 9">
            <a:extLst>
              <a:ext uri="{FF2B5EF4-FFF2-40B4-BE49-F238E27FC236}">
                <a16:creationId xmlns:a16="http://schemas.microsoft.com/office/drawing/2014/main" id="{1188B34E-0B56-594E-94FC-CC9CD9DE17F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44230782"/>
              </p:ext>
            </p:extLst>
          </p:nvPr>
        </p:nvGraphicFramePr>
        <p:xfrm>
          <a:off x="6094230" y="3298707"/>
          <a:ext cx="4348717" cy="1901190"/>
        </p:xfrm>
        <a:graphic>
          <a:graphicData uri="http://schemas.openxmlformats.org/drawingml/2006/table">
            <a:tbl>
              <a:tblPr firstRow="1" firstCol="1" bandRow="1"/>
              <a:tblGrid>
                <a:gridCol w="1039528">
                  <a:extLst>
                    <a:ext uri="{9D8B030D-6E8A-4147-A177-3AD203B41FA5}">
                      <a16:colId xmlns:a16="http://schemas.microsoft.com/office/drawing/2014/main" val="1390128220"/>
                    </a:ext>
                  </a:extLst>
                </a:gridCol>
                <a:gridCol w="1099389">
                  <a:extLst>
                    <a:ext uri="{9D8B030D-6E8A-4147-A177-3AD203B41FA5}">
                      <a16:colId xmlns:a16="http://schemas.microsoft.com/office/drawing/2014/main" val="982554927"/>
                    </a:ext>
                  </a:extLst>
                </a:gridCol>
                <a:gridCol w="762000">
                  <a:extLst>
                    <a:ext uri="{9D8B030D-6E8A-4147-A177-3AD203B41FA5}">
                      <a16:colId xmlns:a16="http://schemas.microsoft.com/office/drawing/2014/main" val="2940507884"/>
                    </a:ext>
                  </a:extLst>
                </a:gridCol>
                <a:gridCol w="636693">
                  <a:extLst>
                    <a:ext uri="{9D8B030D-6E8A-4147-A177-3AD203B41FA5}">
                      <a16:colId xmlns:a16="http://schemas.microsoft.com/office/drawing/2014/main" val="3787304384"/>
                    </a:ext>
                  </a:extLst>
                </a:gridCol>
                <a:gridCol w="811107">
                  <a:extLst>
                    <a:ext uri="{9D8B030D-6E8A-4147-A177-3AD203B41FA5}">
                      <a16:colId xmlns:a16="http://schemas.microsoft.com/office/drawing/2014/main" val="1992709120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1" u="none" strike="noStrike" dirty="0">
                          <a:effectLst/>
                          <a:latin typeface="Palatino Linotype" panose="02040502050505030304" pitchFamily="18" charset="0"/>
                        </a:rPr>
                        <a:t>Apiaceae</a:t>
                      </a:r>
                      <a:r>
                        <a:rPr lang="en-US" sz="11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 Spice Exosome Formulation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  <a:latin typeface="Palatino Linotype" panose="02040502050505030304" pitchFamily="18" charset="0"/>
                        </a:rPr>
                        <a:t>Processed Extract Loaded Exosomes</a:t>
                      </a:r>
                      <a:endParaRPr lang="en-US" sz="1100" b="1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  <a:latin typeface="Palatino Linotype" panose="02040502050505030304" pitchFamily="18" charset="0"/>
                        </a:rPr>
                        <a:t>AH Extract Loaded Exosomes</a:t>
                      </a:r>
                      <a:endParaRPr lang="en-US" sz="1100" b="1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1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  <a:latin typeface="Palatino Linotype" panose="02040502050505030304" pitchFamily="18" charset="0"/>
                        </a:rPr>
                        <a:t>Bovine Exosomes</a:t>
                      </a:r>
                      <a:endParaRPr lang="en-US" sz="1100" b="1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2977192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Ajwain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4.7e+01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6.4e+01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Rep 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1.1e+01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5906357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Anis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7.4e+01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7e+01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Rep 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1.1e+01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9894096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Caraway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7.4e+01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8.2e+01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Rep 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1.0e+01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5649057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Celery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1.3e+01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7.6e+01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3416259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Coriander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1.4e+01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8.5e+01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8007049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Cumin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7e+01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7.9e+01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3837033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Dill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6.7e+01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6.7e+01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5771316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Fennel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6.8e+01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7e+01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50640333"/>
                  </a:ext>
                </a:extLst>
              </a:tr>
            </a:tbl>
          </a:graphicData>
        </a:graphic>
      </p:graphicFrame>
      <p:sp>
        <p:nvSpPr>
          <p:cNvPr id="11" name="TextBox 10">
            <a:extLst>
              <a:ext uri="{FF2B5EF4-FFF2-40B4-BE49-F238E27FC236}">
                <a16:creationId xmlns:a16="http://schemas.microsoft.com/office/drawing/2014/main" id="{1436F716-59A0-8ED5-1608-488CBCDCAC91}"/>
              </a:ext>
            </a:extLst>
          </p:cNvPr>
          <p:cNvSpPr txBox="1"/>
          <p:nvPr/>
        </p:nvSpPr>
        <p:spPr>
          <a:xfrm>
            <a:off x="404261" y="305623"/>
            <a:ext cx="5307318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dirty="0">
                <a:latin typeface="Palatino Linotype" panose="02040502050505030304" pitchFamily="18" charset="0"/>
              </a:rPr>
              <a:t>Table S23.: AH-Extract Exosome Formulation Size Data: Average Diameter (nm)  </a:t>
            </a:r>
            <a:endParaRPr lang="en-US" sz="1100" dirty="0">
              <a:latin typeface="Palatino Linotype" panose="02040502050505030304" pitchFamily="18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EDC2B3BA-8B24-8558-02D0-F8A1A5360E7A}"/>
              </a:ext>
            </a:extLst>
          </p:cNvPr>
          <p:cNvSpPr txBox="1"/>
          <p:nvPr/>
        </p:nvSpPr>
        <p:spPr>
          <a:xfrm>
            <a:off x="6094230" y="305623"/>
            <a:ext cx="5824464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dirty="0">
                <a:latin typeface="Palatino Linotype" panose="02040502050505030304" pitchFamily="18" charset="0"/>
              </a:rPr>
              <a:t>Table S24.: AH-Extract Exosome Formulation Polydispersity Index (PDI) Data  </a:t>
            </a:r>
            <a:endParaRPr lang="en-US" sz="1100" dirty="0">
              <a:latin typeface="Palatino Linotype" panose="02040502050505030304" pitchFamily="18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D5FAE1DE-E56D-D3A8-8AE0-E9A50A4C8756}"/>
              </a:ext>
            </a:extLst>
          </p:cNvPr>
          <p:cNvSpPr txBox="1"/>
          <p:nvPr/>
        </p:nvSpPr>
        <p:spPr>
          <a:xfrm>
            <a:off x="404261" y="3037097"/>
            <a:ext cx="4792846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dirty="0">
                <a:latin typeface="Palatino Linotype" panose="02040502050505030304" pitchFamily="18" charset="0"/>
              </a:rPr>
              <a:t>Table S25.: AH-Extract Exosome Formulation Zeta Potential Data: (-mV)  </a:t>
            </a:r>
            <a:endParaRPr lang="en-US" sz="1100" dirty="0">
              <a:latin typeface="Palatino Linotype" panose="02040502050505030304" pitchFamily="18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1A4D1435-AB1C-7DC4-9B97-DFFF6FBE195D}"/>
              </a:ext>
            </a:extLst>
          </p:cNvPr>
          <p:cNvSpPr txBox="1"/>
          <p:nvPr/>
        </p:nvSpPr>
        <p:spPr>
          <a:xfrm>
            <a:off x="6094230" y="3037097"/>
            <a:ext cx="6062476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dirty="0">
                <a:latin typeface="Palatino Linotype" panose="02040502050505030304" pitchFamily="18" charset="0"/>
              </a:rPr>
              <a:t>Table S26.: AH-Extract Exosome Formulation ZetaView Data: Nanoparticles per mg Protein  </a:t>
            </a:r>
            <a:endParaRPr lang="en-US" sz="11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8465795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phic 3">
            <a:extLst>
              <a:ext uri="{FF2B5EF4-FFF2-40B4-BE49-F238E27FC236}">
                <a16:creationId xmlns:a16="http://schemas.microsoft.com/office/drawing/2014/main" id="{314B7156-9689-3209-11E1-78B713542E4B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 bwMode="auto">
          <a:xfrm>
            <a:off x="2774022" y="670647"/>
            <a:ext cx="6097684" cy="4266243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891D74BC-0004-466B-0625-2F95261F69E1}"/>
              </a:ext>
            </a:extLst>
          </p:cNvPr>
          <p:cNvSpPr txBox="1"/>
          <p:nvPr/>
        </p:nvSpPr>
        <p:spPr>
          <a:xfrm>
            <a:off x="2774102" y="4936890"/>
            <a:ext cx="6097604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Figure S1. </a:t>
            </a:r>
            <a:r>
              <a:rPr lang="en-US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Linalool standard curve for terpenoid assay. Values represent the average of 3 replicates and error bars represent standard deviation.</a:t>
            </a:r>
          </a:p>
        </p:txBody>
      </p:sp>
    </p:spTree>
    <p:extLst>
      <p:ext uri="{BB962C8B-B14F-4D97-AF65-F5344CB8AC3E}">
        <p14:creationId xmlns:p14="http://schemas.microsoft.com/office/powerpoint/2010/main" val="367910075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F2309F12-5A55-EA2A-052E-86B43726AE78}"/>
              </a:ext>
            </a:extLst>
          </p:cNvPr>
          <p:cNvSpPr txBox="1"/>
          <p:nvPr/>
        </p:nvSpPr>
        <p:spPr>
          <a:xfrm>
            <a:off x="1601359" y="149786"/>
            <a:ext cx="3696190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dirty="0">
                <a:latin typeface="Palatino Linotype" panose="02040502050505030304" pitchFamily="18" charset="0"/>
              </a:rPr>
              <a:t>Table S2. One-way ANOVA table for Terpenoid Assay</a:t>
            </a:r>
            <a:endParaRPr lang="en-US" sz="1100" dirty="0">
              <a:latin typeface="Palatino Linotype" panose="02040502050505030304" pitchFamily="18" charset="0"/>
            </a:endParaRPr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F92D067B-F274-EBC4-2EE1-D66A5D7EDA7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099456"/>
              </p:ext>
            </p:extLst>
          </p:nvPr>
        </p:nvGraphicFramePr>
        <p:xfrm>
          <a:off x="1601358" y="411396"/>
          <a:ext cx="4842934" cy="1866584"/>
        </p:xfrm>
        <a:graphic>
          <a:graphicData uri="http://schemas.openxmlformats.org/drawingml/2006/table">
            <a:tbl>
              <a:tblPr firstRow="1" firstCol="1" bandRow="1"/>
              <a:tblGrid>
                <a:gridCol w="1380316">
                  <a:extLst>
                    <a:ext uri="{9D8B030D-6E8A-4147-A177-3AD203B41FA5}">
                      <a16:colId xmlns:a16="http://schemas.microsoft.com/office/drawing/2014/main" val="4019093576"/>
                    </a:ext>
                  </a:extLst>
                </a:gridCol>
                <a:gridCol w="613585">
                  <a:extLst>
                    <a:ext uri="{9D8B030D-6E8A-4147-A177-3AD203B41FA5}">
                      <a16:colId xmlns:a16="http://schemas.microsoft.com/office/drawing/2014/main" val="3549038995"/>
                    </a:ext>
                  </a:extLst>
                </a:gridCol>
                <a:gridCol w="656167">
                  <a:extLst>
                    <a:ext uri="{9D8B030D-6E8A-4147-A177-3AD203B41FA5}">
                      <a16:colId xmlns:a16="http://schemas.microsoft.com/office/drawing/2014/main" val="1225594128"/>
                    </a:ext>
                  </a:extLst>
                </a:gridCol>
                <a:gridCol w="516466">
                  <a:extLst>
                    <a:ext uri="{9D8B030D-6E8A-4147-A177-3AD203B41FA5}">
                      <a16:colId xmlns:a16="http://schemas.microsoft.com/office/drawing/2014/main" val="4177472088"/>
                    </a:ext>
                  </a:extLst>
                </a:gridCol>
                <a:gridCol w="965200">
                  <a:extLst>
                    <a:ext uri="{9D8B030D-6E8A-4147-A177-3AD203B41FA5}">
                      <a16:colId xmlns:a16="http://schemas.microsoft.com/office/drawing/2014/main" val="212096707"/>
                    </a:ext>
                  </a:extLst>
                </a:gridCol>
                <a:gridCol w="711200">
                  <a:extLst>
                    <a:ext uri="{9D8B030D-6E8A-4147-A177-3AD203B41FA5}">
                      <a16:colId xmlns:a16="http://schemas.microsoft.com/office/drawing/2014/main" val="696750978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i="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NOVA table</a:t>
                      </a:r>
                      <a:endParaRPr lang="en-US" sz="1100" i="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S</a:t>
                      </a:r>
                      <a:endParaRPr lang="en-US" sz="110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F</a:t>
                      </a:r>
                      <a:endParaRPr lang="en-US" sz="110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S</a:t>
                      </a:r>
                      <a:endParaRPr lang="en-US" sz="110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 (</a:t>
                      </a:r>
                      <a:r>
                        <a:rPr lang="en-US" sz="1100" b="1" dirty="0" err="1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Fn</a:t>
                      </a: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lang="en-US" sz="1100" b="1" dirty="0" err="1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Fd</a:t>
                      </a: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en-US" sz="1100" b="1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10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 value</a:t>
                      </a:r>
                      <a:endParaRPr lang="en-US" sz="1100" b="1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10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5273476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reatment </a:t>
                      </a:r>
                    </a:p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between columns)</a:t>
                      </a:r>
                      <a:endParaRPr lang="en-US" sz="1100" b="1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1686</a:t>
                      </a:r>
                      <a:endParaRPr lang="en-US" sz="11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800" marR="7680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  <a:endParaRPr lang="en-US" sz="11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800" marR="7680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669</a:t>
                      </a:r>
                      <a:endParaRPr lang="en-US" sz="11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800" marR="7680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 (7, 16) = 163.4</a:t>
                      </a:r>
                      <a:endParaRPr lang="en-US" sz="11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800" marR="7680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&lt;0.0001</a:t>
                      </a:r>
                      <a:endParaRPr lang="en-US" sz="11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800" marR="7680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6277692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esidual </a:t>
                      </a:r>
                    </a:p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within columns)</a:t>
                      </a:r>
                      <a:endParaRPr lang="en-US" sz="1100" b="1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63.5</a:t>
                      </a:r>
                      <a:endParaRPr lang="en-US" sz="11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800" marR="7680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6</a:t>
                      </a:r>
                      <a:endParaRPr lang="en-US" sz="11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800" marR="7680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0.22</a:t>
                      </a:r>
                      <a:endParaRPr lang="en-US" sz="11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800" marR="7680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en-US" sz="1100" dirty="0">
                        <a:effectLst/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800" marR="7680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en-US" sz="1100" dirty="0">
                        <a:effectLst/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800" marR="7680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0366983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otal</a:t>
                      </a:r>
                      <a:endParaRPr lang="en-US" sz="1100" b="1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1850</a:t>
                      </a:r>
                      <a:endParaRPr lang="en-US" sz="11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800" marR="7680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3</a:t>
                      </a:r>
                      <a:endParaRPr lang="en-US" sz="11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800" marR="7680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en-US" sz="1100" dirty="0">
                        <a:effectLst/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800" marR="7680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en-US" sz="1100" dirty="0">
                        <a:effectLst/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800" marR="7680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en-US" sz="1100" dirty="0">
                        <a:effectLst/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800" marR="7680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97623169"/>
                  </a:ext>
                </a:extLst>
              </a:tr>
            </a:tbl>
          </a:graphicData>
        </a:graphic>
      </p:graphicFrame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D30837DB-14B8-BA6F-7B8A-28CC21F4619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4757303"/>
              </p:ext>
            </p:extLst>
          </p:nvPr>
        </p:nvGraphicFramePr>
        <p:xfrm>
          <a:off x="6925020" y="411396"/>
          <a:ext cx="3186053" cy="6291656"/>
        </p:xfrm>
        <a:graphic>
          <a:graphicData uri="http://schemas.openxmlformats.org/drawingml/2006/table">
            <a:tbl>
              <a:tblPr firstRow="1" firstCol="1" bandRow="1"/>
              <a:tblGrid>
                <a:gridCol w="1665261">
                  <a:extLst>
                    <a:ext uri="{9D8B030D-6E8A-4147-A177-3AD203B41FA5}">
                      <a16:colId xmlns:a16="http://schemas.microsoft.com/office/drawing/2014/main" val="4019093576"/>
                    </a:ext>
                  </a:extLst>
                </a:gridCol>
                <a:gridCol w="1520792">
                  <a:extLst>
                    <a:ext uri="{9D8B030D-6E8A-4147-A177-3AD203B41FA5}">
                      <a16:colId xmlns:a16="http://schemas.microsoft.com/office/drawing/2014/main" val="3549038995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ukey's multiple comparisons test</a:t>
                      </a:r>
                      <a:endParaRPr lang="en-US" sz="11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djusted P Value</a:t>
                      </a: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5273476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umin vs. Caraway</a:t>
                      </a:r>
                    </a:p>
                  </a:txBody>
                  <a:tcPr marL="41902" marR="4190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0.0001</a:t>
                      </a:r>
                    </a:p>
                  </a:txBody>
                  <a:tcPr marL="41902" marR="4190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6277692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umin vs. Celery</a:t>
                      </a:r>
                    </a:p>
                  </a:txBody>
                  <a:tcPr marL="41902" marR="4190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0.0001</a:t>
                      </a:r>
                    </a:p>
                  </a:txBody>
                  <a:tcPr marL="41902" marR="4190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0366983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umin vs. Coriander</a:t>
                      </a:r>
                    </a:p>
                  </a:txBody>
                  <a:tcPr marL="41902" marR="4190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0.0001</a:t>
                      </a:r>
                    </a:p>
                  </a:txBody>
                  <a:tcPr marL="41902" marR="4190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9762316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umin vs. Dill</a:t>
                      </a:r>
                    </a:p>
                  </a:txBody>
                  <a:tcPr marL="41902" marR="4190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0.0001</a:t>
                      </a:r>
                    </a:p>
                  </a:txBody>
                  <a:tcPr marL="41902" marR="4190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6503175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umin vs. Fennel</a:t>
                      </a:r>
                    </a:p>
                  </a:txBody>
                  <a:tcPr marL="41902" marR="4190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0.0001</a:t>
                      </a:r>
                    </a:p>
                  </a:txBody>
                  <a:tcPr marL="41902" marR="4190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6592949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umin vs. Ajwain</a:t>
                      </a:r>
                    </a:p>
                  </a:txBody>
                  <a:tcPr marL="41902" marR="4190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0.0001</a:t>
                      </a:r>
                    </a:p>
                  </a:txBody>
                  <a:tcPr marL="41902" marR="4190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6935585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umin vs. Anise</a:t>
                      </a:r>
                    </a:p>
                  </a:txBody>
                  <a:tcPr marL="41902" marR="4190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0.0001</a:t>
                      </a:r>
                    </a:p>
                  </a:txBody>
                  <a:tcPr marL="41902" marR="4190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6413291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araway vs. Celery</a:t>
                      </a:r>
                    </a:p>
                  </a:txBody>
                  <a:tcPr marL="41902" marR="4190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0.0001</a:t>
                      </a:r>
                    </a:p>
                  </a:txBody>
                  <a:tcPr marL="41902" marR="4190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4971951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araway vs. Coriander</a:t>
                      </a:r>
                    </a:p>
                  </a:txBody>
                  <a:tcPr marL="41902" marR="4190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0.0001</a:t>
                      </a:r>
                    </a:p>
                  </a:txBody>
                  <a:tcPr marL="41902" marR="4190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4298516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araway vs. Fennel</a:t>
                      </a:r>
                    </a:p>
                  </a:txBody>
                  <a:tcPr marL="41902" marR="4190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0002</a:t>
                      </a:r>
                    </a:p>
                  </a:txBody>
                  <a:tcPr marL="41902" marR="4190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2784083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araway vs. Ajwain</a:t>
                      </a:r>
                    </a:p>
                  </a:txBody>
                  <a:tcPr marL="41902" marR="4190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0.0001</a:t>
                      </a:r>
                    </a:p>
                  </a:txBody>
                  <a:tcPr marL="41902" marR="4190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1273830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araway vs. Anise</a:t>
                      </a:r>
                    </a:p>
                  </a:txBody>
                  <a:tcPr marL="41902" marR="4190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0007</a:t>
                      </a:r>
                    </a:p>
                  </a:txBody>
                  <a:tcPr marL="41902" marR="4190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1029721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elery vs. Dill</a:t>
                      </a:r>
                    </a:p>
                  </a:txBody>
                  <a:tcPr marL="41902" marR="4190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0.0001</a:t>
                      </a:r>
                    </a:p>
                  </a:txBody>
                  <a:tcPr marL="41902" marR="4190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8020026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elery vs. Fennel</a:t>
                      </a:r>
                    </a:p>
                  </a:txBody>
                  <a:tcPr marL="41902" marR="4190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0038</a:t>
                      </a:r>
                    </a:p>
                  </a:txBody>
                  <a:tcPr marL="41902" marR="4190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013732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elery vs. Ajwain</a:t>
                      </a:r>
                    </a:p>
                  </a:txBody>
                  <a:tcPr marL="41902" marR="4190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0031</a:t>
                      </a:r>
                    </a:p>
                  </a:txBody>
                  <a:tcPr marL="41902" marR="4190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7181888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elery vs. Anise</a:t>
                      </a:r>
                    </a:p>
                  </a:txBody>
                  <a:tcPr marL="41902" marR="4190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0011</a:t>
                      </a:r>
                    </a:p>
                  </a:txBody>
                  <a:tcPr marL="41902" marR="4190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220971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oriander vs. Dill</a:t>
                      </a:r>
                    </a:p>
                  </a:txBody>
                  <a:tcPr marL="41902" marR="4190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0.0001</a:t>
                      </a:r>
                    </a:p>
                  </a:txBody>
                  <a:tcPr marL="41902" marR="4190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041015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oriander vs. Ajwain</a:t>
                      </a:r>
                    </a:p>
                  </a:txBody>
                  <a:tcPr marL="41902" marR="4190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0001</a:t>
                      </a:r>
                    </a:p>
                  </a:txBody>
                  <a:tcPr marL="41902" marR="4190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7520096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oriander vs. Anise</a:t>
                      </a:r>
                    </a:p>
                  </a:txBody>
                  <a:tcPr marL="41902" marR="4190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0264</a:t>
                      </a:r>
                    </a:p>
                  </a:txBody>
                  <a:tcPr marL="41902" marR="4190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5310508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ill vs. Fennel</a:t>
                      </a:r>
                    </a:p>
                  </a:txBody>
                  <a:tcPr marL="41902" marR="4190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0.0001</a:t>
                      </a:r>
                    </a:p>
                  </a:txBody>
                  <a:tcPr marL="41902" marR="4190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693157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ill vs. Ajwain</a:t>
                      </a:r>
                    </a:p>
                  </a:txBody>
                  <a:tcPr marL="41902" marR="4190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0.0001</a:t>
                      </a:r>
                    </a:p>
                  </a:txBody>
                  <a:tcPr marL="41902" marR="4190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7278838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ill vs. Anise</a:t>
                      </a:r>
                    </a:p>
                  </a:txBody>
                  <a:tcPr marL="41902" marR="4190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0.0001</a:t>
                      </a:r>
                    </a:p>
                  </a:txBody>
                  <a:tcPr marL="41902" marR="4190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7212375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ennel vs. Ajwain</a:t>
                      </a:r>
                    </a:p>
                  </a:txBody>
                  <a:tcPr marL="41902" marR="4190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0.0001</a:t>
                      </a:r>
                    </a:p>
                  </a:txBody>
                  <a:tcPr marL="41902" marR="4190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3169312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jwain vs. Anise</a:t>
                      </a:r>
                    </a:p>
                  </a:txBody>
                  <a:tcPr marL="41902" marR="4190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0.0001</a:t>
                      </a:r>
                    </a:p>
                  </a:txBody>
                  <a:tcPr marL="41902" marR="4190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81042355"/>
                  </a:ext>
                </a:extLst>
              </a:tr>
            </a:tbl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1759B9E1-F1C3-2E1D-EE03-A34749C88BE6}"/>
              </a:ext>
            </a:extLst>
          </p:cNvPr>
          <p:cNvSpPr txBox="1"/>
          <p:nvPr/>
        </p:nvSpPr>
        <p:spPr>
          <a:xfrm>
            <a:off x="6833758" y="96252"/>
            <a:ext cx="3696192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dirty="0">
                <a:latin typeface="Palatino Linotype" panose="02040502050505030304" pitchFamily="18" charset="0"/>
              </a:rPr>
              <a:t>Table S2A. Tukey’s Multiple Comparisons</a:t>
            </a:r>
            <a:endParaRPr lang="en-US" sz="11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8937678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20D363E4-F70F-5D8B-4BF5-472D9D8AC41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34281" y="706347"/>
            <a:ext cx="6523437" cy="4089115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206080D3-8ABC-8073-D501-3724F4E13591}"/>
              </a:ext>
            </a:extLst>
          </p:cNvPr>
          <p:cNvSpPr txBox="1"/>
          <p:nvPr/>
        </p:nvSpPr>
        <p:spPr>
          <a:xfrm>
            <a:off x="2834281" y="4795462"/>
            <a:ext cx="6523436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Figure S2.</a:t>
            </a:r>
            <a:r>
              <a:rPr lang="en-US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Gallic acid standard curve for the phenolics assay. Values represent an average of 3 replicates and error bars represent standard deviation.</a:t>
            </a:r>
          </a:p>
        </p:txBody>
      </p:sp>
    </p:spTree>
    <p:extLst>
      <p:ext uri="{BB962C8B-B14F-4D97-AF65-F5344CB8AC3E}">
        <p14:creationId xmlns:p14="http://schemas.microsoft.com/office/powerpoint/2010/main" val="124552196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2515B68F-FE96-637E-5FC1-DEB0F1B26509}"/>
              </a:ext>
            </a:extLst>
          </p:cNvPr>
          <p:cNvSpPr txBox="1"/>
          <p:nvPr/>
        </p:nvSpPr>
        <p:spPr>
          <a:xfrm>
            <a:off x="696583" y="74512"/>
            <a:ext cx="4736834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dirty="0">
                <a:latin typeface="Palatino Linotype" panose="02040502050505030304" pitchFamily="18" charset="0"/>
              </a:rPr>
              <a:t>Table S3. One-way ANOVA table for Phenolics Assay</a:t>
            </a:r>
            <a:endParaRPr lang="en-US" sz="1100" dirty="0">
              <a:latin typeface="Palatino Linotype" panose="02040502050505030304" pitchFamily="18" charset="0"/>
            </a:endParaRPr>
          </a:p>
        </p:txBody>
      </p:sp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51CCBA87-51B6-4817-725B-75E9FC33107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91609158"/>
              </p:ext>
            </p:extLst>
          </p:nvPr>
        </p:nvGraphicFramePr>
        <p:xfrm>
          <a:off x="696583" y="315144"/>
          <a:ext cx="4842934" cy="1866584"/>
        </p:xfrm>
        <a:graphic>
          <a:graphicData uri="http://schemas.openxmlformats.org/drawingml/2006/table">
            <a:tbl>
              <a:tblPr firstRow="1" firstCol="1" bandRow="1"/>
              <a:tblGrid>
                <a:gridCol w="1380316">
                  <a:extLst>
                    <a:ext uri="{9D8B030D-6E8A-4147-A177-3AD203B41FA5}">
                      <a16:colId xmlns:a16="http://schemas.microsoft.com/office/drawing/2014/main" val="4019093576"/>
                    </a:ext>
                  </a:extLst>
                </a:gridCol>
                <a:gridCol w="613585">
                  <a:extLst>
                    <a:ext uri="{9D8B030D-6E8A-4147-A177-3AD203B41FA5}">
                      <a16:colId xmlns:a16="http://schemas.microsoft.com/office/drawing/2014/main" val="3549038995"/>
                    </a:ext>
                  </a:extLst>
                </a:gridCol>
                <a:gridCol w="656167">
                  <a:extLst>
                    <a:ext uri="{9D8B030D-6E8A-4147-A177-3AD203B41FA5}">
                      <a16:colId xmlns:a16="http://schemas.microsoft.com/office/drawing/2014/main" val="1225594128"/>
                    </a:ext>
                  </a:extLst>
                </a:gridCol>
                <a:gridCol w="516466">
                  <a:extLst>
                    <a:ext uri="{9D8B030D-6E8A-4147-A177-3AD203B41FA5}">
                      <a16:colId xmlns:a16="http://schemas.microsoft.com/office/drawing/2014/main" val="4177472088"/>
                    </a:ext>
                  </a:extLst>
                </a:gridCol>
                <a:gridCol w="965200">
                  <a:extLst>
                    <a:ext uri="{9D8B030D-6E8A-4147-A177-3AD203B41FA5}">
                      <a16:colId xmlns:a16="http://schemas.microsoft.com/office/drawing/2014/main" val="212096707"/>
                    </a:ext>
                  </a:extLst>
                </a:gridCol>
                <a:gridCol w="711200">
                  <a:extLst>
                    <a:ext uri="{9D8B030D-6E8A-4147-A177-3AD203B41FA5}">
                      <a16:colId xmlns:a16="http://schemas.microsoft.com/office/drawing/2014/main" val="696750978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i="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NOVA table</a:t>
                      </a:r>
                      <a:endParaRPr lang="en-US" sz="1100" i="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S</a:t>
                      </a:r>
                      <a:endParaRPr lang="en-US" sz="110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F</a:t>
                      </a:r>
                      <a:endParaRPr lang="en-US" sz="110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S</a:t>
                      </a:r>
                      <a:endParaRPr lang="en-US" sz="110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 (</a:t>
                      </a:r>
                      <a:r>
                        <a:rPr lang="en-US" sz="1100" b="1" dirty="0" err="1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Fn</a:t>
                      </a: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lang="en-US" sz="1100" b="1" dirty="0" err="1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Fd</a:t>
                      </a: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en-US" sz="1100" b="1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10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 value</a:t>
                      </a:r>
                      <a:endParaRPr lang="en-US" sz="1100" b="1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10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5273476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reatment </a:t>
                      </a:r>
                    </a:p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between columns)</a:t>
                      </a:r>
                      <a:endParaRPr lang="en-US" sz="1100" b="1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856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65.1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 (7, 16) = 165.0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&lt;0.0001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6277692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esidual </a:t>
                      </a:r>
                    </a:p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within columns)</a:t>
                      </a:r>
                      <a:endParaRPr lang="en-US" sz="1100" b="1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5.71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6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.607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en-US" sz="1100" dirty="0">
                        <a:effectLst/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en-US" sz="1100" dirty="0">
                        <a:effectLst/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0366983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otal</a:t>
                      </a:r>
                      <a:endParaRPr lang="en-US" sz="1100" b="1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882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3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en-US" sz="1100" dirty="0">
                        <a:effectLst/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en-US" sz="1100" dirty="0">
                        <a:effectLst/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en-US" sz="1100" dirty="0">
                        <a:effectLst/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97623169"/>
                  </a:ext>
                </a:extLst>
              </a:tr>
            </a:tbl>
          </a:graphicData>
        </a:graphic>
      </p:graphicFrame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0398E366-1D71-6F95-E612-4E1B8A61BB4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86655239"/>
              </p:ext>
            </p:extLst>
          </p:nvPr>
        </p:nvGraphicFramePr>
        <p:xfrm>
          <a:off x="6020245" y="315144"/>
          <a:ext cx="3186053" cy="6341058"/>
        </p:xfrm>
        <a:graphic>
          <a:graphicData uri="http://schemas.openxmlformats.org/drawingml/2006/table">
            <a:tbl>
              <a:tblPr firstRow="1" firstCol="1" bandRow="1"/>
              <a:tblGrid>
                <a:gridCol w="1665261">
                  <a:extLst>
                    <a:ext uri="{9D8B030D-6E8A-4147-A177-3AD203B41FA5}">
                      <a16:colId xmlns:a16="http://schemas.microsoft.com/office/drawing/2014/main" val="4019093576"/>
                    </a:ext>
                  </a:extLst>
                </a:gridCol>
                <a:gridCol w="1520792">
                  <a:extLst>
                    <a:ext uri="{9D8B030D-6E8A-4147-A177-3AD203B41FA5}">
                      <a16:colId xmlns:a16="http://schemas.microsoft.com/office/drawing/2014/main" val="3549038995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ukey's multiple comparisons test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djusted P Value</a:t>
                      </a: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5273476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umin vs. Anise</a:t>
                      </a:r>
                    </a:p>
                  </a:txBody>
                  <a:tcPr marL="28268" marR="28268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0010</a:t>
                      </a:r>
                    </a:p>
                  </a:txBody>
                  <a:tcPr marL="28268" marR="28268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6277692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umin vs. Coriander</a:t>
                      </a:r>
                    </a:p>
                  </a:txBody>
                  <a:tcPr marL="28268" marR="28268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0023</a:t>
                      </a:r>
                    </a:p>
                  </a:txBody>
                  <a:tcPr marL="28268" marR="28268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0366983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umin vs. Celery</a:t>
                      </a:r>
                    </a:p>
                  </a:txBody>
                  <a:tcPr marL="28268" marR="28268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0.0001</a:t>
                      </a:r>
                    </a:p>
                  </a:txBody>
                  <a:tcPr marL="28268" marR="28268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9762316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umin vs. Ajwain</a:t>
                      </a:r>
                    </a:p>
                  </a:txBody>
                  <a:tcPr marL="28268" marR="28268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0.0001</a:t>
                      </a:r>
                    </a:p>
                  </a:txBody>
                  <a:tcPr marL="28268" marR="28268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6503175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umin vs. Dill</a:t>
                      </a:r>
                    </a:p>
                  </a:txBody>
                  <a:tcPr marL="28268" marR="28268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0011</a:t>
                      </a:r>
                    </a:p>
                  </a:txBody>
                  <a:tcPr marL="28268" marR="28268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6592949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umin vs. Caraway</a:t>
                      </a:r>
                    </a:p>
                  </a:txBody>
                  <a:tcPr marL="28268" marR="28268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0003</a:t>
                      </a:r>
                    </a:p>
                  </a:txBody>
                  <a:tcPr marL="28268" marR="28268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6935585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umin vs. Fennel</a:t>
                      </a:r>
                    </a:p>
                  </a:txBody>
                  <a:tcPr marL="28268" marR="28268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0.0001</a:t>
                      </a:r>
                    </a:p>
                  </a:txBody>
                  <a:tcPr marL="28268" marR="28268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6413291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nise vs. Coriander</a:t>
                      </a:r>
                    </a:p>
                  </a:txBody>
                  <a:tcPr marL="28268" marR="28268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0.0001</a:t>
                      </a:r>
                    </a:p>
                  </a:txBody>
                  <a:tcPr marL="28268" marR="28268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4971951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nise vs. Ajwain</a:t>
                      </a:r>
                    </a:p>
                  </a:txBody>
                  <a:tcPr marL="28268" marR="28268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0.0001</a:t>
                      </a:r>
                    </a:p>
                  </a:txBody>
                  <a:tcPr marL="28268" marR="28268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4298516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nise vs. Fennel</a:t>
                      </a:r>
                    </a:p>
                  </a:txBody>
                  <a:tcPr marL="28268" marR="28268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0.0001</a:t>
                      </a:r>
                    </a:p>
                  </a:txBody>
                  <a:tcPr marL="28268" marR="28268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2784083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oriander vs. Celery</a:t>
                      </a:r>
                    </a:p>
                  </a:txBody>
                  <a:tcPr marL="28268" marR="28268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0.0001</a:t>
                      </a:r>
                    </a:p>
                  </a:txBody>
                  <a:tcPr marL="28268" marR="28268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1273830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oriander vs. Ajwain</a:t>
                      </a:r>
                    </a:p>
                  </a:txBody>
                  <a:tcPr marL="28268" marR="28268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0.0001</a:t>
                      </a:r>
                    </a:p>
                  </a:txBody>
                  <a:tcPr marL="28268" marR="28268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1029721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oriander vs. Dill</a:t>
                      </a:r>
                    </a:p>
                  </a:txBody>
                  <a:tcPr marL="28268" marR="28268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0.0001</a:t>
                      </a:r>
                    </a:p>
                  </a:txBody>
                  <a:tcPr marL="28268" marR="28268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8020026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oriander vs. Caraway</a:t>
                      </a:r>
                    </a:p>
                  </a:txBody>
                  <a:tcPr marL="28268" marR="28268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0.0001</a:t>
                      </a:r>
                    </a:p>
                  </a:txBody>
                  <a:tcPr marL="28268" marR="28268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013732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oriander vs. Fennel</a:t>
                      </a:r>
                    </a:p>
                  </a:txBody>
                  <a:tcPr marL="28268" marR="28268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0.0001</a:t>
                      </a:r>
                    </a:p>
                  </a:txBody>
                  <a:tcPr marL="28268" marR="28268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7181888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elery vs. Ajwain</a:t>
                      </a:r>
                    </a:p>
                  </a:txBody>
                  <a:tcPr marL="28268" marR="28268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0.0001</a:t>
                      </a:r>
                    </a:p>
                  </a:txBody>
                  <a:tcPr marL="28268" marR="28268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220971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elery vs. Fennel</a:t>
                      </a:r>
                    </a:p>
                  </a:txBody>
                  <a:tcPr marL="28268" marR="28268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0.0001</a:t>
                      </a:r>
                    </a:p>
                  </a:txBody>
                  <a:tcPr marL="28268" marR="28268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041015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jwain vs. Dill</a:t>
                      </a:r>
                    </a:p>
                  </a:txBody>
                  <a:tcPr marL="28268" marR="28268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0.0001</a:t>
                      </a:r>
                    </a:p>
                  </a:txBody>
                  <a:tcPr marL="28268" marR="28268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7520096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jwain vs. Caraway</a:t>
                      </a:r>
                    </a:p>
                  </a:txBody>
                  <a:tcPr marL="28268" marR="28268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0.0001</a:t>
                      </a:r>
                    </a:p>
                  </a:txBody>
                  <a:tcPr marL="28268" marR="28268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5310508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jwain vs. Fennel</a:t>
                      </a:r>
                    </a:p>
                  </a:txBody>
                  <a:tcPr marL="28268" marR="28268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0.0001</a:t>
                      </a:r>
                    </a:p>
                  </a:txBody>
                  <a:tcPr marL="28268" marR="28268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693157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ill vs. Fennel</a:t>
                      </a:r>
                    </a:p>
                  </a:txBody>
                  <a:tcPr marL="28268" marR="28268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0.0001</a:t>
                      </a:r>
                    </a:p>
                  </a:txBody>
                  <a:tcPr marL="28268" marR="28268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7278838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araway vs. Fennel</a:t>
                      </a:r>
                    </a:p>
                  </a:txBody>
                  <a:tcPr marL="28268" marR="28268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0.0001</a:t>
                      </a:r>
                    </a:p>
                  </a:txBody>
                  <a:tcPr marL="28268" marR="28268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72123750"/>
                  </a:ext>
                </a:extLst>
              </a:tr>
            </a:tbl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7EAB2F1C-8A4B-1EC7-7438-9757B22D8786}"/>
              </a:ext>
            </a:extLst>
          </p:cNvPr>
          <p:cNvSpPr txBox="1"/>
          <p:nvPr/>
        </p:nvSpPr>
        <p:spPr>
          <a:xfrm>
            <a:off x="5928983" y="0"/>
            <a:ext cx="3696192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dirty="0">
                <a:latin typeface="Palatino Linotype" panose="02040502050505030304" pitchFamily="18" charset="0"/>
              </a:rPr>
              <a:t>Table S3A. Tukey’s Multiple Comparisons</a:t>
            </a:r>
            <a:endParaRPr lang="en-US" sz="11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7171242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0B13D9E7-60A4-CEEA-7B08-30B4A6EA47B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56216" y="699470"/>
            <a:ext cx="6161882" cy="4711272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5439A087-7728-6E03-1A3F-4C7F9B7F8BFC}"/>
              </a:ext>
            </a:extLst>
          </p:cNvPr>
          <p:cNvSpPr txBox="1"/>
          <p:nvPr/>
        </p:nvSpPr>
        <p:spPr>
          <a:xfrm>
            <a:off x="2856216" y="5410742"/>
            <a:ext cx="6097604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Figure S3. </a:t>
            </a:r>
            <a:r>
              <a:rPr lang="en-US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Atropine standard curve for alkaloid assay. Values represent the average of 3 replicates and error bars represent standard deviation.</a:t>
            </a:r>
          </a:p>
        </p:txBody>
      </p:sp>
    </p:spTree>
    <p:extLst>
      <p:ext uri="{BB962C8B-B14F-4D97-AF65-F5344CB8AC3E}">
        <p14:creationId xmlns:p14="http://schemas.microsoft.com/office/powerpoint/2010/main" val="173306779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B4AD7AD2-18BC-5FED-1B2B-45A85978023C}"/>
              </a:ext>
            </a:extLst>
          </p:cNvPr>
          <p:cNvSpPr txBox="1"/>
          <p:nvPr/>
        </p:nvSpPr>
        <p:spPr>
          <a:xfrm>
            <a:off x="1592715" y="785054"/>
            <a:ext cx="8576110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dirty="0">
                <a:latin typeface="Palatino Linotype" panose="02040502050505030304" pitchFamily="18" charset="0"/>
              </a:rPr>
              <a:t>Table S4. One-way ANOVA table for Alkaloid Assay</a:t>
            </a:r>
            <a:endParaRPr lang="en-US" sz="1100" dirty="0">
              <a:latin typeface="Palatino Linotype" panose="02040502050505030304" pitchFamily="18" charset="0"/>
            </a:endParaRPr>
          </a:p>
        </p:txBody>
      </p:sp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0D66DFE7-D2FE-A32E-547D-2574B6F27A9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02488670"/>
              </p:ext>
            </p:extLst>
          </p:nvPr>
        </p:nvGraphicFramePr>
        <p:xfrm>
          <a:off x="1659110" y="1046664"/>
          <a:ext cx="4842934" cy="1866584"/>
        </p:xfrm>
        <a:graphic>
          <a:graphicData uri="http://schemas.openxmlformats.org/drawingml/2006/table">
            <a:tbl>
              <a:tblPr firstRow="1" firstCol="1" bandRow="1"/>
              <a:tblGrid>
                <a:gridCol w="1380316">
                  <a:extLst>
                    <a:ext uri="{9D8B030D-6E8A-4147-A177-3AD203B41FA5}">
                      <a16:colId xmlns:a16="http://schemas.microsoft.com/office/drawing/2014/main" val="4019093576"/>
                    </a:ext>
                  </a:extLst>
                </a:gridCol>
                <a:gridCol w="613585">
                  <a:extLst>
                    <a:ext uri="{9D8B030D-6E8A-4147-A177-3AD203B41FA5}">
                      <a16:colId xmlns:a16="http://schemas.microsoft.com/office/drawing/2014/main" val="3549038995"/>
                    </a:ext>
                  </a:extLst>
                </a:gridCol>
                <a:gridCol w="656167">
                  <a:extLst>
                    <a:ext uri="{9D8B030D-6E8A-4147-A177-3AD203B41FA5}">
                      <a16:colId xmlns:a16="http://schemas.microsoft.com/office/drawing/2014/main" val="1225594128"/>
                    </a:ext>
                  </a:extLst>
                </a:gridCol>
                <a:gridCol w="516466">
                  <a:extLst>
                    <a:ext uri="{9D8B030D-6E8A-4147-A177-3AD203B41FA5}">
                      <a16:colId xmlns:a16="http://schemas.microsoft.com/office/drawing/2014/main" val="4177472088"/>
                    </a:ext>
                  </a:extLst>
                </a:gridCol>
                <a:gridCol w="965200">
                  <a:extLst>
                    <a:ext uri="{9D8B030D-6E8A-4147-A177-3AD203B41FA5}">
                      <a16:colId xmlns:a16="http://schemas.microsoft.com/office/drawing/2014/main" val="212096707"/>
                    </a:ext>
                  </a:extLst>
                </a:gridCol>
                <a:gridCol w="711200">
                  <a:extLst>
                    <a:ext uri="{9D8B030D-6E8A-4147-A177-3AD203B41FA5}">
                      <a16:colId xmlns:a16="http://schemas.microsoft.com/office/drawing/2014/main" val="696750978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i="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NOVA table</a:t>
                      </a:r>
                      <a:endParaRPr lang="en-US" sz="1100" i="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S</a:t>
                      </a:r>
                      <a:endParaRPr lang="en-US" sz="110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F</a:t>
                      </a:r>
                      <a:endParaRPr lang="en-US" sz="110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S</a:t>
                      </a:r>
                      <a:endParaRPr lang="en-US" sz="110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 (</a:t>
                      </a:r>
                      <a:r>
                        <a:rPr lang="en-US" sz="1100" b="1" dirty="0" err="1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Fn</a:t>
                      </a: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lang="en-US" sz="1100" b="1" dirty="0" err="1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Fd</a:t>
                      </a: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en-US" sz="1100" b="1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10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 value</a:t>
                      </a:r>
                      <a:endParaRPr lang="en-US" sz="1100" b="1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10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5273476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reatment </a:t>
                      </a:r>
                    </a:p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between columns)</a:t>
                      </a:r>
                      <a:endParaRPr lang="en-US" sz="1100" b="1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9468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7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1352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F (7, 16) = 644.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P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6277692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esidual </a:t>
                      </a:r>
                    </a:p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within columns)</a:t>
                      </a:r>
                      <a:endParaRPr lang="en-US" sz="1100" b="1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336.0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1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21.00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0366983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otal</a:t>
                      </a:r>
                      <a:endParaRPr lang="en-US" sz="1100" b="1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95017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2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97623169"/>
                  </a:ext>
                </a:extLst>
              </a:tr>
            </a:tbl>
          </a:graphicData>
        </a:graphic>
      </p:graphicFrame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6CEB8414-DC94-545A-4365-6F1B32EC52C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01590074"/>
              </p:ext>
            </p:extLst>
          </p:nvPr>
        </p:nvGraphicFramePr>
        <p:xfrm>
          <a:off x="6982772" y="1046664"/>
          <a:ext cx="3186053" cy="4625658"/>
        </p:xfrm>
        <a:graphic>
          <a:graphicData uri="http://schemas.openxmlformats.org/drawingml/2006/table">
            <a:tbl>
              <a:tblPr firstRow="1" firstCol="1" bandRow="1"/>
              <a:tblGrid>
                <a:gridCol w="1665261">
                  <a:extLst>
                    <a:ext uri="{9D8B030D-6E8A-4147-A177-3AD203B41FA5}">
                      <a16:colId xmlns:a16="http://schemas.microsoft.com/office/drawing/2014/main" val="4019093576"/>
                    </a:ext>
                  </a:extLst>
                </a:gridCol>
                <a:gridCol w="1520792">
                  <a:extLst>
                    <a:ext uri="{9D8B030D-6E8A-4147-A177-3AD203B41FA5}">
                      <a16:colId xmlns:a16="http://schemas.microsoft.com/office/drawing/2014/main" val="3549038995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ukey's multiple comparisons test</a:t>
                      </a:r>
                      <a:endParaRPr lang="en-US" sz="11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djusted P Value</a:t>
                      </a: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5273476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Cumin vs. Caraway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6277692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Cumin vs. Celery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0366983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Cumin vs. Coriander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9762316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Cumin vs. Ajwain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6503175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Cumin vs. Anis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6592949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Cumin vs. Fennel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6935585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Cumin vs. Dill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6413291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Caraway vs. Celery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4971951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Caraway vs. Coriander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4298516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Caraway vs. Ajwain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2784083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Caraway vs. Anis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1273830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Caraway vs. Fennel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1029721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Caraway vs. Dill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8020026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Celery vs. Coriander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013732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Celery vs. Ajwain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0.000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7181888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Celery vs. Fennel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220971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Celery vs. Dill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0.001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041015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Coriander vs. Ajwain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7520096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Coriander vs. Anis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5310508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Coriander vs. Fennel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693157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Coriander vs. Dill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7278838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Ajwain vs. Anis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0.0147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7212375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Anise vs. Fennel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0.0060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88338323"/>
                  </a:ext>
                </a:extLst>
              </a:tr>
            </a:tbl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BE137A9C-1CF4-E519-D2EA-6E3D22695470}"/>
              </a:ext>
            </a:extLst>
          </p:cNvPr>
          <p:cNvSpPr txBox="1"/>
          <p:nvPr/>
        </p:nvSpPr>
        <p:spPr>
          <a:xfrm>
            <a:off x="6891510" y="731520"/>
            <a:ext cx="3696192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dirty="0">
                <a:latin typeface="Palatino Linotype" panose="02040502050505030304" pitchFamily="18" charset="0"/>
              </a:rPr>
              <a:t>Table S4A. Tukey’s Multiple Comparisons</a:t>
            </a:r>
            <a:endParaRPr lang="en-US" sz="11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5034768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2A6F81DF-6C6A-1348-3EA0-82D1602DA6CE}"/>
              </a:ext>
            </a:extLst>
          </p:cNvPr>
          <p:cNvSpPr txBox="1"/>
          <p:nvPr/>
        </p:nvSpPr>
        <p:spPr>
          <a:xfrm>
            <a:off x="1714565" y="1911210"/>
            <a:ext cx="4736834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dirty="0">
                <a:latin typeface="Palatino Linotype" panose="02040502050505030304" pitchFamily="18" charset="0"/>
              </a:rPr>
              <a:t>Table S5. One-way ANOVA table for Loading % Calculations</a:t>
            </a:r>
            <a:endParaRPr lang="en-US" sz="1100" dirty="0">
              <a:latin typeface="Palatino Linotype" panose="02040502050505030304" pitchFamily="18" charset="0"/>
            </a:endParaRPr>
          </a:p>
        </p:txBody>
      </p: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35A34099-3171-4A65-06C1-E492013AE06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98552425"/>
              </p:ext>
            </p:extLst>
          </p:nvPr>
        </p:nvGraphicFramePr>
        <p:xfrm>
          <a:off x="1793863" y="2172820"/>
          <a:ext cx="4842934" cy="1866584"/>
        </p:xfrm>
        <a:graphic>
          <a:graphicData uri="http://schemas.openxmlformats.org/drawingml/2006/table">
            <a:tbl>
              <a:tblPr firstRow="1" firstCol="1" bandRow="1"/>
              <a:tblGrid>
                <a:gridCol w="1380316">
                  <a:extLst>
                    <a:ext uri="{9D8B030D-6E8A-4147-A177-3AD203B41FA5}">
                      <a16:colId xmlns:a16="http://schemas.microsoft.com/office/drawing/2014/main" val="4019093576"/>
                    </a:ext>
                  </a:extLst>
                </a:gridCol>
                <a:gridCol w="613585">
                  <a:extLst>
                    <a:ext uri="{9D8B030D-6E8A-4147-A177-3AD203B41FA5}">
                      <a16:colId xmlns:a16="http://schemas.microsoft.com/office/drawing/2014/main" val="3549038995"/>
                    </a:ext>
                  </a:extLst>
                </a:gridCol>
                <a:gridCol w="656167">
                  <a:extLst>
                    <a:ext uri="{9D8B030D-6E8A-4147-A177-3AD203B41FA5}">
                      <a16:colId xmlns:a16="http://schemas.microsoft.com/office/drawing/2014/main" val="1225594128"/>
                    </a:ext>
                  </a:extLst>
                </a:gridCol>
                <a:gridCol w="516466">
                  <a:extLst>
                    <a:ext uri="{9D8B030D-6E8A-4147-A177-3AD203B41FA5}">
                      <a16:colId xmlns:a16="http://schemas.microsoft.com/office/drawing/2014/main" val="4177472088"/>
                    </a:ext>
                  </a:extLst>
                </a:gridCol>
                <a:gridCol w="965200">
                  <a:extLst>
                    <a:ext uri="{9D8B030D-6E8A-4147-A177-3AD203B41FA5}">
                      <a16:colId xmlns:a16="http://schemas.microsoft.com/office/drawing/2014/main" val="212096707"/>
                    </a:ext>
                  </a:extLst>
                </a:gridCol>
                <a:gridCol w="711200">
                  <a:extLst>
                    <a:ext uri="{9D8B030D-6E8A-4147-A177-3AD203B41FA5}">
                      <a16:colId xmlns:a16="http://schemas.microsoft.com/office/drawing/2014/main" val="696750978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i="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NOVA table</a:t>
                      </a:r>
                      <a:endParaRPr lang="en-US" sz="1100" i="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S</a:t>
                      </a:r>
                      <a:endParaRPr lang="en-US" sz="110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F</a:t>
                      </a:r>
                      <a:endParaRPr lang="en-US" sz="110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S</a:t>
                      </a:r>
                      <a:endParaRPr lang="en-US" sz="110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 (</a:t>
                      </a:r>
                      <a:r>
                        <a:rPr lang="en-US" sz="1100" b="1" dirty="0" err="1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Fn</a:t>
                      </a: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lang="en-US" sz="1100" b="1" dirty="0" err="1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Fd</a:t>
                      </a: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en-US" sz="1100" b="1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10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 value</a:t>
                      </a:r>
                      <a:endParaRPr lang="en-US" sz="1100" b="1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100" kern="1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5273476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reatment </a:t>
                      </a:r>
                    </a:p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between columns)</a:t>
                      </a:r>
                      <a:endParaRPr lang="en-US" sz="1100" b="1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443.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7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63.3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F (7, 12) = 6.468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P=0.002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6277692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esidual </a:t>
                      </a:r>
                    </a:p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within columns)</a:t>
                      </a:r>
                      <a:endParaRPr lang="en-US" sz="1100" b="1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117.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1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9.79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0366983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otal</a:t>
                      </a:r>
                      <a:endParaRPr lang="en-US" sz="1100" b="1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560.9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19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97623169"/>
                  </a:ext>
                </a:extLst>
              </a:tr>
            </a:tbl>
          </a:graphicData>
        </a:graphic>
      </p:graphicFrame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383228DD-7B69-9487-BC12-E01D5916AB9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89496928"/>
              </p:ext>
            </p:extLst>
          </p:nvPr>
        </p:nvGraphicFramePr>
        <p:xfrm>
          <a:off x="7117525" y="2172820"/>
          <a:ext cx="3186053" cy="1493838"/>
        </p:xfrm>
        <a:graphic>
          <a:graphicData uri="http://schemas.openxmlformats.org/drawingml/2006/table">
            <a:tbl>
              <a:tblPr firstRow="1" firstCol="1" bandRow="1"/>
              <a:tblGrid>
                <a:gridCol w="1665261">
                  <a:extLst>
                    <a:ext uri="{9D8B030D-6E8A-4147-A177-3AD203B41FA5}">
                      <a16:colId xmlns:a16="http://schemas.microsoft.com/office/drawing/2014/main" val="4019093576"/>
                    </a:ext>
                  </a:extLst>
                </a:gridCol>
                <a:gridCol w="1520792">
                  <a:extLst>
                    <a:ext uri="{9D8B030D-6E8A-4147-A177-3AD203B41FA5}">
                      <a16:colId xmlns:a16="http://schemas.microsoft.com/office/drawing/2014/main" val="3549038995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ukey's multiple comparisons test</a:t>
                      </a:r>
                      <a:endParaRPr lang="en-US" sz="11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djusted P Value</a:t>
                      </a: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5273476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Anise vs. Coriander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0.0358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6277692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Ajwain vs. Coriander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0.0068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0366983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Ajwain vs. Celery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0.0180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9762316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Coriander vs. Caraway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0.0197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6503175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Cumin vs. Fennel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0.501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65929490"/>
                  </a:ext>
                </a:extLst>
              </a:tr>
            </a:tbl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E745FFA4-008E-0533-6139-A27DF4A27118}"/>
              </a:ext>
            </a:extLst>
          </p:cNvPr>
          <p:cNvSpPr txBox="1"/>
          <p:nvPr/>
        </p:nvSpPr>
        <p:spPr>
          <a:xfrm>
            <a:off x="7026263" y="1857676"/>
            <a:ext cx="3696192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dirty="0">
                <a:latin typeface="Palatino Linotype" panose="02040502050505030304" pitchFamily="18" charset="0"/>
              </a:rPr>
              <a:t>Table S5A. Tukey’s Multiple Comparisons</a:t>
            </a:r>
            <a:endParaRPr lang="en-US" sz="11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751157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33</TotalTime>
  <Words>3512</Words>
  <Application>Microsoft Office PowerPoint</Application>
  <PresentationFormat>Widescreen</PresentationFormat>
  <Paragraphs>1413</Paragraphs>
  <Slides>2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4</vt:i4>
      </vt:variant>
    </vt:vector>
  </HeadingPairs>
  <TitlesOfParts>
    <vt:vector size="30" baseType="lpstr">
      <vt:lpstr>Arial</vt:lpstr>
      <vt:lpstr>Calibri</vt:lpstr>
      <vt:lpstr>Calibri Light</vt:lpstr>
      <vt:lpstr>Palatino Linotype</vt:lpstr>
      <vt:lpstr>Times New Roman</vt:lpstr>
      <vt:lpstr>Office Theme</vt:lpstr>
      <vt:lpstr>Exosomal Delivery Enhances Anticancer Properties of Acid Hydrolyzed Apiaceae Spice Extracts. 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iaceae Spice Extracts have Anticancer Properties that can be Enhanced with Acid Hydrolysis and Exosomal Delivery</dc:title>
  <dc:creator>Scott, Jared</dc:creator>
  <cp:lastModifiedBy>Scott, Jared</cp:lastModifiedBy>
  <cp:revision>7</cp:revision>
  <dcterms:created xsi:type="dcterms:W3CDTF">2023-12-11T00:06:04Z</dcterms:created>
  <dcterms:modified xsi:type="dcterms:W3CDTF">2024-08-16T03:32:23Z</dcterms:modified>
</cp:coreProperties>
</file>